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44" saveSubsetFonts="1" bookmarkIdSeed="4">
  <p:sldMasterIdLst>
    <p:sldMasterId id="2147483732" r:id="rId1"/>
  </p:sldMasterIdLst>
  <p:notesMasterIdLst>
    <p:notesMasterId r:id="rId25"/>
  </p:notesMasterIdLst>
  <p:sldIdLst>
    <p:sldId id="286" r:id="rId2"/>
    <p:sldId id="301" r:id="rId3"/>
    <p:sldId id="300" r:id="rId4"/>
    <p:sldId id="324" r:id="rId5"/>
    <p:sldId id="310" r:id="rId6"/>
    <p:sldId id="299" r:id="rId7"/>
    <p:sldId id="317" r:id="rId8"/>
    <p:sldId id="326" r:id="rId9"/>
    <p:sldId id="308" r:id="rId10"/>
    <p:sldId id="304" r:id="rId11"/>
    <p:sldId id="323" r:id="rId12"/>
    <p:sldId id="319" r:id="rId13"/>
    <p:sldId id="281" r:id="rId14"/>
    <p:sldId id="327" r:id="rId15"/>
    <p:sldId id="312" r:id="rId16"/>
    <p:sldId id="321" r:id="rId17"/>
    <p:sldId id="320" r:id="rId18"/>
    <p:sldId id="289" r:id="rId19"/>
    <p:sldId id="322" r:id="rId20"/>
    <p:sldId id="313" r:id="rId21"/>
    <p:sldId id="325" r:id="rId22"/>
    <p:sldId id="311" r:id="rId23"/>
    <p:sldId id="318" r:id="rId2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 Huang" initials="JH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CC00"/>
    <a:srgbClr val="FF00FF"/>
    <a:srgbClr val="00FFFF"/>
    <a:srgbClr val="00CCFF"/>
    <a:srgbClr val="66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31616" autoAdjust="0"/>
  </p:normalViewPr>
  <p:slideViewPr>
    <p:cSldViewPr snapToGrid="0">
      <p:cViewPr varScale="1">
        <p:scale>
          <a:sx n="86" d="100"/>
          <a:sy n="86" d="100"/>
        </p:scale>
        <p:origin x="3366" y="102"/>
      </p:cViewPr>
      <p:guideLst>
        <p:guide orient="horz" pos="2880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50" tIns="46576" rIns="93150" bIns="4657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50" tIns="46576" rIns="93150" bIns="46576" rtlCol="0"/>
          <a:lstStyle>
            <a:lvl1pPr algn="r">
              <a:defRPr sz="1200"/>
            </a:lvl1pPr>
          </a:lstStyle>
          <a:p>
            <a:fld id="{E8994AAB-ECF0-42A7-A495-674F4184F926}" type="datetimeFigureOut">
              <a:rPr lang="en-US" smtClean="0"/>
              <a:t>8/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0" tIns="46576" rIns="93150" bIns="4657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50" tIns="46576" rIns="93150" bIns="46576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50" tIns="46576" rIns="93150" bIns="4657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50" tIns="46576" rIns="93150" bIns="46576" rtlCol="0" anchor="b"/>
          <a:lstStyle>
            <a:lvl1pPr algn="r">
              <a:defRPr sz="1200"/>
            </a:lvl1pPr>
          </a:lstStyle>
          <a:p>
            <a:fld id="{ED20C891-D588-4B71-B0B9-570194C6D9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449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1pPr>
    <a:lvl2pPr marL="501516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2pPr>
    <a:lvl3pPr marL="1003035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3pPr>
    <a:lvl4pPr marL="1504552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4pPr>
    <a:lvl5pPr marL="2006069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5pPr>
    <a:lvl6pPr marL="2507587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6pPr>
    <a:lvl7pPr marL="3009104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7pPr>
    <a:lvl8pPr marL="3510622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8pPr>
    <a:lvl9pPr marL="4012138" algn="l" defTabSz="1003035" rtl="0" eaLnBrk="1" latinLnBrk="0" hangingPunct="1">
      <a:defRPr sz="13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20C891-D588-4B71-B0B9-570194C6D9ED}" type="slidenum">
              <a:rPr lang="en-US" smtClean="0"/>
              <a:t>4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46151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20C891-D588-4B71-B0B9-570194C6D9ED}" type="slidenum">
              <a:rPr lang="en-US" smtClean="0"/>
              <a:t>4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38616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0C891-D588-4B71-B0B9-570194C6D9ED}" type="slidenum">
              <a:rPr lang="en-US" smtClean="0"/>
              <a:t>5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17545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8863" y="1162050"/>
            <a:ext cx="235267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20C891-D588-4B71-B0B9-570194C6D9ED}" type="slidenum">
              <a:rPr lang="en-US" smtClean="0"/>
              <a:t>5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29651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20C891-D588-4B71-B0B9-570194C6D9ED}" type="slidenum">
              <a:rPr lang="en-US" smtClean="0"/>
              <a:t>5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59692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15495-D2D9-1E44-B203-E0CA240BA04B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95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85329-8EBE-A64C-BC07-14E0437EA4F2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052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0879E-A7C8-7C46-A0A3-405E90D400D8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67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5F49B-B952-8E4D-ABB3-B569844C3A19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828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7DC23-0253-8A4F-9E28-E79C0422A78F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6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F53565-C806-184A-B395-A81B185577A1}" type="datetime1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03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5AD11C-C363-8E40-A3A3-ED935EA93ED3}" type="datetime1">
              <a:rPr lang="en-US" smtClean="0"/>
              <a:t>8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340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1B06-1C3C-AD41-AFD7-C5EEA42B00F4}" type="datetime1">
              <a:rPr lang="en-US" smtClean="0"/>
              <a:t>8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117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22D5D0-BEF7-484F-99FA-82A1E9B9FE3F}" type="datetime1">
              <a:rPr lang="en-US" smtClean="0"/>
              <a:t>8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254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9A1D-AC8D-B34F-A4F0-FF3EB3DEFEE0}" type="datetime1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001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073E2-46E2-764C-8B21-DB8AB1742FFC}" type="datetime1">
              <a:rPr lang="en-US" smtClean="0"/>
              <a:t>8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470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0C00C-7249-2045-8312-24E6EE1C06A2}" type="datetime1">
              <a:rPr lang="en-US" smtClean="0"/>
              <a:t>8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BB0DD-9FB1-4582-B4C9-29606918C6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490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12" Type="http://schemas.openxmlformats.org/officeDocument/2006/relationships/image" Target="../media/image4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11" Type="http://schemas.openxmlformats.org/officeDocument/2006/relationships/image" Target="../media/image45.emf"/><Relationship Id="rId5" Type="http://schemas.openxmlformats.org/officeDocument/2006/relationships/image" Target="../media/image39.emf"/><Relationship Id="rId10" Type="http://schemas.openxmlformats.org/officeDocument/2006/relationships/image" Target="../media/image44.emf"/><Relationship Id="rId4" Type="http://schemas.openxmlformats.org/officeDocument/2006/relationships/image" Target="../media/image38.emf"/><Relationship Id="rId9" Type="http://schemas.openxmlformats.org/officeDocument/2006/relationships/image" Target="../media/image43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tiff"/><Relationship Id="rId13" Type="http://schemas.openxmlformats.org/officeDocument/2006/relationships/image" Target="../media/image57.tif"/><Relationship Id="rId18" Type="http://schemas.openxmlformats.org/officeDocument/2006/relationships/image" Target="../media/image62.tiff"/><Relationship Id="rId26" Type="http://schemas.openxmlformats.org/officeDocument/2006/relationships/image" Target="../media/image70.tiff"/><Relationship Id="rId3" Type="http://schemas.openxmlformats.org/officeDocument/2006/relationships/image" Target="../media/image47.tif"/><Relationship Id="rId21" Type="http://schemas.openxmlformats.org/officeDocument/2006/relationships/image" Target="../media/image65.tiff"/><Relationship Id="rId34" Type="http://schemas.openxmlformats.org/officeDocument/2006/relationships/image" Target="../media/image78.tif"/><Relationship Id="rId7" Type="http://schemas.openxmlformats.org/officeDocument/2006/relationships/image" Target="../media/image51.tiff"/><Relationship Id="rId12" Type="http://schemas.openxmlformats.org/officeDocument/2006/relationships/image" Target="../media/image56.tiff"/><Relationship Id="rId17" Type="http://schemas.openxmlformats.org/officeDocument/2006/relationships/image" Target="../media/image61.tiff"/><Relationship Id="rId25" Type="http://schemas.openxmlformats.org/officeDocument/2006/relationships/image" Target="../media/image69.jpeg"/><Relationship Id="rId33" Type="http://schemas.openxmlformats.org/officeDocument/2006/relationships/image" Target="../media/image77.tif"/><Relationship Id="rId38" Type="http://schemas.openxmlformats.org/officeDocument/2006/relationships/image" Target="../media/image82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60.tif"/><Relationship Id="rId20" Type="http://schemas.openxmlformats.org/officeDocument/2006/relationships/image" Target="../media/image64.tiff"/><Relationship Id="rId29" Type="http://schemas.openxmlformats.org/officeDocument/2006/relationships/image" Target="../media/image7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emf"/><Relationship Id="rId11" Type="http://schemas.openxmlformats.org/officeDocument/2006/relationships/image" Target="../media/image55.tiff"/><Relationship Id="rId24" Type="http://schemas.openxmlformats.org/officeDocument/2006/relationships/image" Target="../media/image68.tif"/><Relationship Id="rId32" Type="http://schemas.openxmlformats.org/officeDocument/2006/relationships/image" Target="../media/image76.tif"/><Relationship Id="rId37" Type="http://schemas.openxmlformats.org/officeDocument/2006/relationships/image" Target="../media/image81.jpeg"/><Relationship Id="rId5" Type="http://schemas.openxmlformats.org/officeDocument/2006/relationships/image" Target="../media/image49.emf"/><Relationship Id="rId15" Type="http://schemas.openxmlformats.org/officeDocument/2006/relationships/image" Target="../media/image59.tif"/><Relationship Id="rId23" Type="http://schemas.openxmlformats.org/officeDocument/2006/relationships/image" Target="../media/image67.tif"/><Relationship Id="rId28" Type="http://schemas.openxmlformats.org/officeDocument/2006/relationships/image" Target="../media/image72.tiff"/><Relationship Id="rId36" Type="http://schemas.openxmlformats.org/officeDocument/2006/relationships/image" Target="../media/image80.tif"/><Relationship Id="rId10" Type="http://schemas.openxmlformats.org/officeDocument/2006/relationships/image" Target="../media/image54.tiff"/><Relationship Id="rId19" Type="http://schemas.openxmlformats.org/officeDocument/2006/relationships/image" Target="../media/image63.tiff"/><Relationship Id="rId31" Type="http://schemas.openxmlformats.org/officeDocument/2006/relationships/image" Target="../media/image75.tiff"/><Relationship Id="rId4" Type="http://schemas.openxmlformats.org/officeDocument/2006/relationships/image" Target="../media/image48.emf"/><Relationship Id="rId9" Type="http://schemas.openxmlformats.org/officeDocument/2006/relationships/image" Target="../media/image53.tiff"/><Relationship Id="rId14" Type="http://schemas.openxmlformats.org/officeDocument/2006/relationships/image" Target="../media/image58.tif"/><Relationship Id="rId22" Type="http://schemas.openxmlformats.org/officeDocument/2006/relationships/image" Target="../media/image66.tiff"/><Relationship Id="rId27" Type="http://schemas.openxmlformats.org/officeDocument/2006/relationships/image" Target="../media/image71.jpeg"/><Relationship Id="rId30" Type="http://schemas.openxmlformats.org/officeDocument/2006/relationships/image" Target="../media/image74.tiff"/><Relationship Id="rId35" Type="http://schemas.openxmlformats.org/officeDocument/2006/relationships/image" Target="../media/image79.ti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jpeg"/><Relationship Id="rId3" Type="http://schemas.openxmlformats.org/officeDocument/2006/relationships/image" Target="../media/image83.emf"/><Relationship Id="rId7" Type="http://schemas.openxmlformats.org/officeDocument/2006/relationships/image" Target="../media/image8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tif"/><Relationship Id="rId5" Type="http://schemas.openxmlformats.org/officeDocument/2006/relationships/image" Target="../media/image85.tif"/><Relationship Id="rId4" Type="http://schemas.openxmlformats.org/officeDocument/2006/relationships/image" Target="../media/image84.emf"/><Relationship Id="rId9" Type="http://schemas.openxmlformats.org/officeDocument/2006/relationships/image" Target="../media/image82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emf"/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emf"/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3.em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96.tif"/><Relationship Id="rId7" Type="http://schemas.openxmlformats.org/officeDocument/2006/relationships/image" Target="../media/image99.png"/><Relationship Id="rId2" Type="http://schemas.openxmlformats.org/officeDocument/2006/relationships/image" Target="../media/image95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98.png"/><Relationship Id="rId4" Type="http://schemas.openxmlformats.org/officeDocument/2006/relationships/image" Target="../media/image97.ti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em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png"/><Relationship Id="rId2" Type="http://schemas.openxmlformats.org/officeDocument/2006/relationships/image" Target="../media/image101.jpe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20.png"/><Relationship Id="rId4" Type="http://schemas.openxmlformats.org/officeDocument/2006/relationships/image" Target="../media/image105.tif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12" Type="http://schemas.openxmlformats.org/officeDocument/2006/relationships/image" Target="../media/image12.em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tiff"/><Relationship Id="rId5" Type="http://schemas.openxmlformats.org/officeDocument/2006/relationships/image" Target="../media/image5.png"/><Relationship Id="rId10" Type="http://schemas.openxmlformats.org/officeDocument/2006/relationships/image" Target="../media/image10.tiff"/><Relationship Id="rId4" Type="http://schemas.openxmlformats.org/officeDocument/2006/relationships/image" Target="../media/image4.tiff"/><Relationship Id="rId9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"/><Relationship Id="rId13" Type="http://schemas.openxmlformats.org/officeDocument/2006/relationships/image" Target="../media/image23.tif"/><Relationship Id="rId3" Type="http://schemas.openxmlformats.org/officeDocument/2006/relationships/image" Target="../media/image13.tif"/><Relationship Id="rId7" Type="http://schemas.openxmlformats.org/officeDocument/2006/relationships/image" Target="../media/image17.tif"/><Relationship Id="rId12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11" Type="http://schemas.openxmlformats.org/officeDocument/2006/relationships/image" Target="../media/image21.tif"/><Relationship Id="rId5" Type="http://schemas.openxmlformats.org/officeDocument/2006/relationships/image" Target="../media/image15.tif"/><Relationship Id="rId10" Type="http://schemas.openxmlformats.org/officeDocument/2006/relationships/image" Target="../media/image20.tif"/><Relationship Id="rId4" Type="http://schemas.openxmlformats.org/officeDocument/2006/relationships/image" Target="../media/image14.tif"/><Relationship Id="rId9" Type="http://schemas.openxmlformats.org/officeDocument/2006/relationships/image" Target="../media/image19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"/><Relationship Id="rId3" Type="http://schemas.openxmlformats.org/officeDocument/2006/relationships/image" Target="../media/image24.tif"/><Relationship Id="rId7" Type="http://schemas.openxmlformats.org/officeDocument/2006/relationships/image" Target="../media/image28.jpeg"/><Relationship Id="rId12" Type="http://schemas.openxmlformats.org/officeDocument/2006/relationships/image" Target="../media/image3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11" Type="http://schemas.openxmlformats.org/officeDocument/2006/relationships/image" Target="../media/image32.emf"/><Relationship Id="rId5" Type="http://schemas.openxmlformats.org/officeDocument/2006/relationships/image" Target="../media/image26.emf"/><Relationship Id="rId10" Type="http://schemas.openxmlformats.org/officeDocument/2006/relationships/image" Target="../media/image31.jpeg"/><Relationship Id="rId4" Type="http://schemas.openxmlformats.org/officeDocument/2006/relationships/image" Target="../media/image25.tif"/><Relationship Id="rId9" Type="http://schemas.openxmlformats.org/officeDocument/2006/relationships/image" Target="../media/image30.ti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178571" y="4787678"/>
            <a:ext cx="4818938" cy="2941434"/>
            <a:chOff x="1215147" y="887254"/>
            <a:chExt cx="4818938" cy="2941434"/>
          </a:xfrm>
        </p:grpSpPr>
        <p:sp>
          <p:nvSpPr>
            <p:cNvPr id="142" name="TextBox 141"/>
            <p:cNvSpPr txBox="1"/>
            <p:nvPr/>
          </p:nvSpPr>
          <p:spPr>
            <a:xfrm>
              <a:off x="1559897" y="2112734"/>
              <a:ext cx="292388" cy="26545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3786147" y="2358641"/>
              <a:ext cx="3481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BF</a:t>
              </a:r>
              <a:endParaRPr lang="en-US" sz="7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085503" y="2715421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311070" y="887254"/>
              <a:ext cx="20336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nalog white LED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2045852" y="2428280"/>
              <a:ext cx="292388" cy="39209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5 nm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304215" y="1912015"/>
              <a:ext cx="292388" cy="39209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47 nm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1519980" y="2432000"/>
              <a:ext cx="292388" cy="39209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32 nm</a:t>
              </a:r>
            </a:p>
          </p:txBody>
        </p:sp>
        <p:cxnSp>
          <p:nvCxnSpPr>
            <p:cNvPr id="19" name="Straight Connector 18"/>
            <p:cNvCxnSpPr/>
            <p:nvPr/>
          </p:nvCxnSpPr>
          <p:spPr>
            <a:xfrm>
              <a:off x="2268481" y="2380757"/>
              <a:ext cx="0" cy="387853"/>
            </a:xfrm>
            <a:prstGeom prst="line">
              <a:avLst/>
            </a:prstGeom>
            <a:ln w="28575">
              <a:solidFill>
                <a:srgbClr val="3399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1754058" y="1929026"/>
              <a:ext cx="292388" cy="39209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88 nm</a:t>
              </a:r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3668166" y="1917496"/>
              <a:ext cx="0" cy="411008"/>
            </a:xfrm>
            <a:prstGeom prst="line">
              <a:avLst/>
            </a:prstGeom>
            <a:ln w="57150">
              <a:solidFill>
                <a:srgbClr val="00FF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>
              <a:off x="1969479" y="1255330"/>
              <a:ext cx="17166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agnetic stage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1515930" y="2369181"/>
              <a:ext cx="97831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1527509" y="1969749"/>
              <a:ext cx="0" cy="41100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1741695" y="2380758"/>
              <a:ext cx="0" cy="376275"/>
            </a:xfrm>
            <a:prstGeom prst="line">
              <a:avLst/>
            </a:prstGeom>
            <a:ln w="28575">
              <a:solidFill>
                <a:srgbClr val="00FF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V="1">
              <a:off x="1984827" y="1969749"/>
              <a:ext cx="0" cy="411008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1446464" y="2305503"/>
              <a:ext cx="138932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oup 30"/>
            <p:cNvGrpSpPr/>
            <p:nvPr/>
          </p:nvGrpSpPr>
          <p:grpSpPr>
            <a:xfrm>
              <a:off x="2494245" y="2231696"/>
              <a:ext cx="63677" cy="274970"/>
              <a:chOff x="2579298" y="2063871"/>
              <a:chExt cx="94890" cy="409755"/>
            </a:xfrm>
          </p:grpSpPr>
          <p:cxnSp>
            <p:nvCxnSpPr>
              <p:cNvPr id="29" name="Straight Connector 28"/>
              <p:cNvCxnSpPr/>
              <p:nvPr/>
            </p:nvCxnSpPr>
            <p:spPr>
              <a:xfrm>
                <a:off x="2579298" y="2063871"/>
                <a:ext cx="0" cy="40975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ectangle 29"/>
              <p:cNvSpPr/>
              <p:nvPr/>
            </p:nvSpPr>
            <p:spPr>
              <a:xfrm>
                <a:off x="2579298" y="2197804"/>
                <a:ext cx="94890" cy="15914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Freeform 31"/>
            <p:cNvSpPr/>
            <p:nvPr/>
          </p:nvSpPr>
          <p:spPr>
            <a:xfrm>
              <a:off x="2569595" y="2328504"/>
              <a:ext cx="451436" cy="149189"/>
            </a:xfrm>
            <a:custGeom>
              <a:avLst/>
              <a:gdLst>
                <a:gd name="connsiteX0" fmla="*/ 0 w 1231490"/>
                <a:gd name="connsiteY0" fmla="*/ 191729 h 508937"/>
                <a:gd name="connsiteX1" fmla="*/ 147484 w 1231490"/>
                <a:gd name="connsiteY1" fmla="*/ 199103 h 508937"/>
                <a:gd name="connsiteX2" fmla="*/ 169606 w 1231490"/>
                <a:gd name="connsiteY2" fmla="*/ 221226 h 508937"/>
                <a:gd name="connsiteX3" fmla="*/ 191729 w 1231490"/>
                <a:gd name="connsiteY3" fmla="*/ 228600 h 508937"/>
                <a:gd name="connsiteX4" fmla="*/ 243348 w 1231490"/>
                <a:gd name="connsiteY4" fmla="*/ 280219 h 508937"/>
                <a:gd name="connsiteX5" fmla="*/ 250722 w 1231490"/>
                <a:gd name="connsiteY5" fmla="*/ 501445 h 508937"/>
                <a:gd name="connsiteX6" fmla="*/ 272845 w 1231490"/>
                <a:gd name="connsiteY6" fmla="*/ 508819 h 508937"/>
                <a:gd name="connsiteX7" fmla="*/ 560438 w 1231490"/>
                <a:gd name="connsiteY7" fmla="*/ 486697 h 508937"/>
                <a:gd name="connsiteX8" fmla="*/ 582561 w 1231490"/>
                <a:gd name="connsiteY8" fmla="*/ 471948 h 508937"/>
                <a:gd name="connsiteX9" fmla="*/ 589935 w 1231490"/>
                <a:gd name="connsiteY9" fmla="*/ 412955 h 508937"/>
                <a:gd name="connsiteX10" fmla="*/ 597309 w 1231490"/>
                <a:gd name="connsiteY10" fmla="*/ 390832 h 508937"/>
                <a:gd name="connsiteX11" fmla="*/ 589935 w 1231490"/>
                <a:gd name="connsiteY11" fmla="*/ 317090 h 508937"/>
                <a:gd name="connsiteX12" fmla="*/ 553064 w 1231490"/>
                <a:gd name="connsiteY12" fmla="*/ 272845 h 508937"/>
                <a:gd name="connsiteX13" fmla="*/ 530942 w 1231490"/>
                <a:gd name="connsiteY13" fmla="*/ 243348 h 508937"/>
                <a:gd name="connsiteX14" fmla="*/ 508819 w 1231490"/>
                <a:gd name="connsiteY14" fmla="*/ 199103 h 508937"/>
                <a:gd name="connsiteX15" fmla="*/ 494071 w 1231490"/>
                <a:gd name="connsiteY15" fmla="*/ 162232 h 508937"/>
                <a:gd name="connsiteX16" fmla="*/ 508819 w 1231490"/>
                <a:gd name="connsiteY16" fmla="*/ 117987 h 508937"/>
                <a:gd name="connsiteX17" fmla="*/ 567813 w 1231490"/>
                <a:gd name="connsiteY17" fmla="*/ 81116 h 508937"/>
                <a:gd name="connsiteX18" fmla="*/ 589935 w 1231490"/>
                <a:gd name="connsiteY18" fmla="*/ 66368 h 508937"/>
                <a:gd name="connsiteX19" fmla="*/ 663677 w 1231490"/>
                <a:gd name="connsiteY19" fmla="*/ 44245 h 508937"/>
                <a:gd name="connsiteX20" fmla="*/ 685800 w 1231490"/>
                <a:gd name="connsiteY20" fmla="*/ 29497 h 508937"/>
                <a:gd name="connsiteX21" fmla="*/ 848032 w 1231490"/>
                <a:gd name="connsiteY21" fmla="*/ 51619 h 508937"/>
                <a:gd name="connsiteX22" fmla="*/ 870154 w 1231490"/>
                <a:gd name="connsiteY22" fmla="*/ 81116 h 508937"/>
                <a:gd name="connsiteX23" fmla="*/ 884903 w 1231490"/>
                <a:gd name="connsiteY23" fmla="*/ 125361 h 508937"/>
                <a:gd name="connsiteX24" fmla="*/ 892277 w 1231490"/>
                <a:gd name="connsiteY24" fmla="*/ 154858 h 508937"/>
                <a:gd name="connsiteX25" fmla="*/ 921774 w 1231490"/>
                <a:gd name="connsiteY25" fmla="*/ 191729 h 508937"/>
                <a:gd name="connsiteX26" fmla="*/ 936522 w 1231490"/>
                <a:gd name="connsiteY26" fmla="*/ 213852 h 508937"/>
                <a:gd name="connsiteX27" fmla="*/ 1054509 w 1231490"/>
                <a:gd name="connsiteY27" fmla="*/ 206477 h 508937"/>
                <a:gd name="connsiteX28" fmla="*/ 1084006 w 1231490"/>
                <a:gd name="connsiteY28" fmla="*/ 199103 h 508937"/>
                <a:gd name="connsiteX29" fmla="*/ 1135625 w 1231490"/>
                <a:gd name="connsiteY29" fmla="*/ 132735 h 508937"/>
                <a:gd name="connsiteX30" fmla="*/ 1157748 w 1231490"/>
                <a:gd name="connsiteY30" fmla="*/ 117987 h 508937"/>
                <a:gd name="connsiteX31" fmla="*/ 1165122 w 1231490"/>
                <a:gd name="connsiteY31" fmla="*/ 88490 h 508937"/>
                <a:gd name="connsiteX32" fmla="*/ 1201993 w 1231490"/>
                <a:gd name="connsiteY32" fmla="*/ 58994 h 508937"/>
                <a:gd name="connsiteX33" fmla="*/ 1209367 w 1231490"/>
                <a:gd name="connsiteY33" fmla="*/ 36871 h 508937"/>
                <a:gd name="connsiteX34" fmla="*/ 1224116 w 1231490"/>
                <a:gd name="connsiteY34" fmla="*/ 14748 h 508937"/>
                <a:gd name="connsiteX35" fmla="*/ 1231490 w 1231490"/>
                <a:gd name="connsiteY35" fmla="*/ 0 h 5089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1231490" h="508937">
                  <a:moveTo>
                    <a:pt x="0" y="191729"/>
                  </a:moveTo>
                  <a:cubicBezTo>
                    <a:pt x="49161" y="194187"/>
                    <a:pt x="98989" y="190669"/>
                    <a:pt x="147484" y="199103"/>
                  </a:cubicBezTo>
                  <a:cubicBezTo>
                    <a:pt x="157758" y="200890"/>
                    <a:pt x="160929" y="215441"/>
                    <a:pt x="169606" y="221226"/>
                  </a:cubicBezTo>
                  <a:cubicBezTo>
                    <a:pt x="176074" y="225538"/>
                    <a:pt x="184355" y="226142"/>
                    <a:pt x="191729" y="228600"/>
                  </a:cubicBezTo>
                  <a:cubicBezTo>
                    <a:pt x="242441" y="262409"/>
                    <a:pt x="230369" y="241281"/>
                    <a:pt x="243348" y="280219"/>
                  </a:cubicBezTo>
                  <a:cubicBezTo>
                    <a:pt x="245806" y="353961"/>
                    <a:pt x="241280" y="428269"/>
                    <a:pt x="250722" y="501445"/>
                  </a:cubicBezTo>
                  <a:cubicBezTo>
                    <a:pt x="251717" y="509154"/>
                    <a:pt x="265081" y="509189"/>
                    <a:pt x="272845" y="508819"/>
                  </a:cubicBezTo>
                  <a:cubicBezTo>
                    <a:pt x="368884" y="504246"/>
                    <a:pt x="464574" y="494071"/>
                    <a:pt x="560438" y="486697"/>
                  </a:cubicBezTo>
                  <a:cubicBezTo>
                    <a:pt x="567812" y="481781"/>
                    <a:pt x="579269" y="480177"/>
                    <a:pt x="582561" y="471948"/>
                  </a:cubicBezTo>
                  <a:cubicBezTo>
                    <a:pt x="589921" y="453548"/>
                    <a:pt x="586390" y="432453"/>
                    <a:pt x="589935" y="412955"/>
                  </a:cubicBezTo>
                  <a:cubicBezTo>
                    <a:pt x="591325" y="405307"/>
                    <a:pt x="594851" y="398206"/>
                    <a:pt x="597309" y="390832"/>
                  </a:cubicBezTo>
                  <a:cubicBezTo>
                    <a:pt x="594851" y="366251"/>
                    <a:pt x="596721" y="340843"/>
                    <a:pt x="589935" y="317090"/>
                  </a:cubicBezTo>
                  <a:cubicBezTo>
                    <a:pt x="584808" y="299145"/>
                    <a:pt x="564529" y="286603"/>
                    <a:pt x="553064" y="272845"/>
                  </a:cubicBezTo>
                  <a:cubicBezTo>
                    <a:pt x="545196" y="263403"/>
                    <a:pt x="538316" y="253180"/>
                    <a:pt x="530942" y="243348"/>
                  </a:cubicBezTo>
                  <a:cubicBezTo>
                    <a:pt x="512402" y="187736"/>
                    <a:pt x="537413" y="256293"/>
                    <a:pt x="508819" y="199103"/>
                  </a:cubicBezTo>
                  <a:cubicBezTo>
                    <a:pt x="502899" y="187263"/>
                    <a:pt x="498987" y="174522"/>
                    <a:pt x="494071" y="162232"/>
                  </a:cubicBezTo>
                  <a:cubicBezTo>
                    <a:pt x="498987" y="147484"/>
                    <a:pt x="501269" y="131577"/>
                    <a:pt x="508819" y="117987"/>
                  </a:cubicBezTo>
                  <a:cubicBezTo>
                    <a:pt x="523749" y="91112"/>
                    <a:pt x="542269" y="93888"/>
                    <a:pt x="567813" y="81116"/>
                  </a:cubicBezTo>
                  <a:cubicBezTo>
                    <a:pt x="575740" y="77153"/>
                    <a:pt x="581836" y="69967"/>
                    <a:pt x="589935" y="66368"/>
                  </a:cubicBezTo>
                  <a:cubicBezTo>
                    <a:pt x="613022" y="56107"/>
                    <a:pt x="639159" y="50374"/>
                    <a:pt x="663677" y="44245"/>
                  </a:cubicBezTo>
                  <a:cubicBezTo>
                    <a:pt x="671051" y="39329"/>
                    <a:pt x="676946" y="29899"/>
                    <a:pt x="685800" y="29497"/>
                  </a:cubicBezTo>
                  <a:cubicBezTo>
                    <a:pt x="814242" y="23659"/>
                    <a:pt x="790884" y="13522"/>
                    <a:pt x="848032" y="51619"/>
                  </a:cubicBezTo>
                  <a:cubicBezTo>
                    <a:pt x="855406" y="61451"/>
                    <a:pt x="864658" y="70123"/>
                    <a:pt x="870154" y="81116"/>
                  </a:cubicBezTo>
                  <a:cubicBezTo>
                    <a:pt x="877106" y="95021"/>
                    <a:pt x="880436" y="110470"/>
                    <a:pt x="884903" y="125361"/>
                  </a:cubicBezTo>
                  <a:cubicBezTo>
                    <a:pt x="887815" y="135068"/>
                    <a:pt x="887355" y="145998"/>
                    <a:pt x="892277" y="154858"/>
                  </a:cubicBezTo>
                  <a:cubicBezTo>
                    <a:pt x="899921" y="168617"/>
                    <a:pt x="912330" y="179137"/>
                    <a:pt x="921774" y="191729"/>
                  </a:cubicBezTo>
                  <a:cubicBezTo>
                    <a:pt x="927092" y="198819"/>
                    <a:pt x="931606" y="206478"/>
                    <a:pt x="936522" y="213852"/>
                  </a:cubicBezTo>
                  <a:cubicBezTo>
                    <a:pt x="975851" y="211394"/>
                    <a:pt x="1015299" y="210398"/>
                    <a:pt x="1054509" y="206477"/>
                  </a:cubicBezTo>
                  <a:cubicBezTo>
                    <a:pt x="1064594" y="205468"/>
                    <a:pt x="1075206" y="204131"/>
                    <a:pt x="1084006" y="199103"/>
                  </a:cubicBezTo>
                  <a:cubicBezTo>
                    <a:pt x="1144363" y="164615"/>
                    <a:pt x="1056663" y="185374"/>
                    <a:pt x="1135625" y="132735"/>
                  </a:cubicBezTo>
                  <a:lnTo>
                    <a:pt x="1157748" y="117987"/>
                  </a:lnTo>
                  <a:cubicBezTo>
                    <a:pt x="1160206" y="108155"/>
                    <a:pt x="1160589" y="97555"/>
                    <a:pt x="1165122" y="88490"/>
                  </a:cubicBezTo>
                  <a:cubicBezTo>
                    <a:pt x="1170375" y="77984"/>
                    <a:pt x="1194179" y="64203"/>
                    <a:pt x="1201993" y="58994"/>
                  </a:cubicBezTo>
                  <a:cubicBezTo>
                    <a:pt x="1204451" y="51620"/>
                    <a:pt x="1205891" y="43824"/>
                    <a:pt x="1209367" y="36871"/>
                  </a:cubicBezTo>
                  <a:cubicBezTo>
                    <a:pt x="1213331" y="28944"/>
                    <a:pt x="1219556" y="22348"/>
                    <a:pt x="1224116" y="14748"/>
                  </a:cubicBezTo>
                  <a:cubicBezTo>
                    <a:pt x="1226944" y="10035"/>
                    <a:pt x="1229032" y="4916"/>
                    <a:pt x="1231490" y="0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Group 32"/>
            <p:cNvGrpSpPr/>
            <p:nvPr/>
          </p:nvGrpSpPr>
          <p:grpSpPr>
            <a:xfrm flipH="1">
              <a:off x="3032701" y="2180201"/>
              <a:ext cx="71987" cy="274970"/>
              <a:chOff x="2579298" y="2063871"/>
              <a:chExt cx="94890" cy="409755"/>
            </a:xfrm>
            <a:scene3d>
              <a:camera prst="orthographicFront">
                <a:rot lat="0" lon="0" rev="0"/>
              </a:camera>
              <a:lightRig rig="threePt" dir="t"/>
            </a:scene3d>
          </p:grpSpPr>
          <p:cxnSp>
            <p:nvCxnSpPr>
              <p:cNvPr id="34" name="Straight Connector 33"/>
              <p:cNvCxnSpPr/>
              <p:nvPr/>
            </p:nvCxnSpPr>
            <p:spPr>
              <a:xfrm>
                <a:off x="2579298" y="2063871"/>
                <a:ext cx="0" cy="40975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Rectangle 34"/>
              <p:cNvSpPr/>
              <p:nvPr/>
            </p:nvSpPr>
            <p:spPr>
              <a:xfrm>
                <a:off x="2579298" y="2197804"/>
                <a:ext cx="94890" cy="15914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8" name="Straight Connector 37"/>
            <p:cNvCxnSpPr/>
            <p:nvPr/>
          </p:nvCxnSpPr>
          <p:spPr>
            <a:xfrm>
              <a:off x="3109637" y="2323555"/>
              <a:ext cx="558529" cy="0"/>
            </a:xfrm>
            <a:prstGeom prst="line">
              <a:avLst/>
            </a:prstGeom>
            <a:ln w="57150">
              <a:solidFill>
                <a:srgbClr val="00FF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668166" y="1509757"/>
              <a:ext cx="0" cy="411008"/>
            </a:xfrm>
            <a:prstGeom prst="line">
              <a:avLst/>
            </a:prstGeom>
            <a:ln w="57150">
              <a:solidFill>
                <a:srgbClr val="00FF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Snip Same Side Corner Rectangle 48"/>
            <p:cNvSpPr/>
            <p:nvPr/>
          </p:nvSpPr>
          <p:spPr>
            <a:xfrm>
              <a:off x="3605094" y="1435220"/>
              <a:ext cx="192992" cy="247345"/>
            </a:xfrm>
            <a:prstGeom prst="snip2SameRect">
              <a:avLst>
                <a:gd name="adj1" fmla="val 33990"/>
                <a:gd name="adj2" fmla="val 0"/>
              </a:avLst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V="1">
              <a:off x="3696649" y="1682566"/>
              <a:ext cx="0" cy="1202942"/>
            </a:xfrm>
            <a:prstGeom prst="line">
              <a:avLst/>
            </a:prstGeom>
            <a:ln w="571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 flipV="1">
              <a:off x="3736418" y="1685264"/>
              <a:ext cx="3834" cy="1542326"/>
            </a:xfrm>
            <a:prstGeom prst="line">
              <a:avLst/>
            </a:prstGeom>
            <a:ln w="57150"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H="1">
              <a:off x="3597860" y="2212388"/>
              <a:ext cx="206602" cy="19071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695642" y="1915816"/>
              <a:ext cx="978315" cy="0"/>
            </a:xfrm>
            <a:prstGeom prst="line">
              <a:avLst/>
            </a:prstGeom>
            <a:ln w="571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3600220" y="1828426"/>
              <a:ext cx="206976" cy="20697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V="1">
              <a:off x="3682728" y="2873463"/>
              <a:ext cx="432634" cy="1"/>
            </a:xfrm>
            <a:prstGeom prst="line">
              <a:avLst/>
            </a:prstGeom>
            <a:ln w="571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4110414" y="2858250"/>
              <a:ext cx="0" cy="342881"/>
            </a:xfrm>
            <a:prstGeom prst="line">
              <a:avLst/>
            </a:prstGeom>
            <a:ln w="571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3731656" y="3246093"/>
              <a:ext cx="958338" cy="0"/>
            </a:xfrm>
            <a:prstGeom prst="line">
              <a:avLst/>
            </a:prstGeom>
            <a:ln w="57150"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3671471" y="3191649"/>
              <a:ext cx="138932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flipH="1">
              <a:off x="4105234" y="3177591"/>
              <a:ext cx="579581" cy="0"/>
            </a:xfrm>
            <a:prstGeom prst="line">
              <a:avLst/>
            </a:prstGeom>
            <a:ln w="571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Rectangle 73"/>
            <p:cNvSpPr/>
            <p:nvPr/>
          </p:nvSpPr>
          <p:spPr>
            <a:xfrm>
              <a:off x="4689996" y="2989739"/>
              <a:ext cx="437989" cy="206812"/>
            </a:xfrm>
            <a:prstGeom prst="rect">
              <a:avLst/>
            </a:prstGeom>
            <a:solidFill>
              <a:srgbClr val="0000FF">
                <a:alpha val="52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4689996" y="3196551"/>
              <a:ext cx="437989" cy="206812"/>
            </a:xfrm>
            <a:prstGeom prst="rect">
              <a:avLst/>
            </a:prstGeom>
            <a:solidFill>
              <a:schemeClr val="accent4">
                <a:lumMod val="75000"/>
                <a:alpha val="67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83" name="Straight Connector 82"/>
            <p:cNvCxnSpPr/>
            <p:nvPr/>
          </p:nvCxnSpPr>
          <p:spPr>
            <a:xfrm flipV="1">
              <a:off x="1743377" y="2370020"/>
              <a:ext cx="740972" cy="5789"/>
            </a:xfrm>
            <a:prstGeom prst="line">
              <a:avLst/>
            </a:prstGeom>
            <a:ln w="28575">
              <a:solidFill>
                <a:srgbClr val="00FF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flipV="1">
              <a:off x="1979037" y="2370020"/>
              <a:ext cx="515208" cy="2473"/>
            </a:xfrm>
            <a:prstGeom prst="line">
              <a:avLst/>
            </a:prstGeom>
            <a:ln w="28575">
              <a:solidFill>
                <a:srgbClr val="0000FF">
                  <a:alpha val="77000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1911325" y="2311247"/>
              <a:ext cx="138932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2275671" y="2363390"/>
              <a:ext cx="218574" cy="6630"/>
            </a:xfrm>
            <a:prstGeom prst="line">
              <a:avLst/>
            </a:prstGeom>
            <a:ln w="28575">
              <a:solidFill>
                <a:srgbClr val="3399FF">
                  <a:alpha val="63000"/>
                </a:srgb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 flipH="1">
              <a:off x="2193227" y="2293925"/>
              <a:ext cx="150509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H="1">
              <a:off x="1678019" y="2293925"/>
              <a:ext cx="150509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Rectangle 94"/>
            <p:cNvSpPr/>
            <p:nvPr/>
          </p:nvSpPr>
          <p:spPr>
            <a:xfrm>
              <a:off x="4666110" y="1725086"/>
              <a:ext cx="1022654" cy="404832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Straight Connector 102"/>
            <p:cNvCxnSpPr/>
            <p:nvPr/>
          </p:nvCxnSpPr>
          <p:spPr>
            <a:xfrm>
              <a:off x="3269991" y="1379176"/>
              <a:ext cx="859220" cy="0"/>
            </a:xfrm>
            <a:prstGeom prst="line">
              <a:avLst/>
            </a:prstGeom>
            <a:ln w="793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4129211" y="1384858"/>
              <a:ext cx="19048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6034082" y="1074789"/>
              <a:ext cx="0" cy="25425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5127983" y="3196551"/>
              <a:ext cx="9060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 flipH="1">
              <a:off x="1944692" y="3617316"/>
              <a:ext cx="40893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Rounded Rectangle 114"/>
            <p:cNvSpPr/>
            <p:nvPr/>
          </p:nvSpPr>
          <p:spPr>
            <a:xfrm>
              <a:off x="1232832" y="1866725"/>
              <a:ext cx="1220286" cy="976229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Straight Connector 116"/>
            <p:cNvCxnSpPr/>
            <p:nvPr/>
          </p:nvCxnSpPr>
          <p:spPr>
            <a:xfrm>
              <a:off x="1947670" y="2858916"/>
              <a:ext cx="0" cy="7584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>
              <a:stCxn id="118" idx="3"/>
            </p:cNvCxnSpPr>
            <p:nvPr/>
          </p:nvCxnSpPr>
          <p:spPr>
            <a:xfrm flipV="1">
              <a:off x="3776193" y="1077363"/>
              <a:ext cx="2257889" cy="1189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4051607" y="2797706"/>
              <a:ext cx="138932" cy="13893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134"/>
            <p:cNvSpPr txBox="1"/>
            <p:nvPr/>
          </p:nvSpPr>
          <p:spPr>
            <a:xfrm>
              <a:off x="1301379" y="2343328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512871" y="3211987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316466" y="2489067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4343177" y="3346720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871815" y="2041533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464479" y="2129918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735151" y="2412081"/>
              <a:ext cx="292388" cy="26545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2099144" y="211754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3265167" y="1794684"/>
              <a:ext cx="4074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728286" y="2104814"/>
              <a:ext cx="4074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345770" y="277757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59" name="Oval 158"/>
            <p:cNvSpPr/>
            <p:nvPr/>
          </p:nvSpPr>
          <p:spPr>
            <a:xfrm rot="5400000">
              <a:off x="3680684" y="2376706"/>
              <a:ext cx="62984" cy="411271"/>
            </a:xfrm>
            <a:prstGeom prst="ellipse">
              <a:avLst/>
            </a:prstGeom>
            <a:solidFill>
              <a:schemeClr val="tx1">
                <a:alpha val="46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Oval 160"/>
            <p:cNvSpPr/>
            <p:nvPr/>
          </p:nvSpPr>
          <p:spPr>
            <a:xfrm>
              <a:off x="4452112" y="3017035"/>
              <a:ext cx="81356" cy="375035"/>
            </a:xfrm>
            <a:prstGeom prst="ellipse">
              <a:avLst/>
            </a:prstGeom>
            <a:solidFill>
              <a:schemeClr val="tx1">
                <a:alpha val="46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699601" y="1482987"/>
              <a:ext cx="6760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X Obj.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682090" y="1787682"/>
              <a:ext cx="999669" cy="307777"/>
            </a:xfrm>
            <a:prstGeom prst="rect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ulticolor LED</a:t>
              </a:r>
            </a:p>
            <a:p>
              <a:pPr algn="ct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" name="Group 54"/>
            <p:cNvGrpSpPr/>
            <p:nvPr/>
          </p:nvGrpSpPr>
          <p:grpSpPr>
            <a:xfrm>
              <a:off x="3637635" y="974781"/>
              <a:ext cx="138559" cy="260319"/>
              <a:chOff x="3332837" y="1156785"/>
              <a:chExt cx="138559" cy="260319"/>
            </a:xfrm>
          </p:grpSpPr>
          <p:sp>
            <p:nvSpPr>
              <p:cNvPr id="118" name="Rectangle 117"/>
              <p:cNvSpPr/>
              <p:nvPr/>
            </p:nvSpPr>
            <p:spPr>
              <a:xfrm>
                <a:off x="3332837" y="1156785"/>
                <a:ext cx="138559" cy="228963"/>
              </a:xfrm>
              <a:prstGeom prst="rect">
                <a:avLst/>
              </a:prstGeom>
              <a:gradFill flip="none" rotWithShape="1">
                <a:gsLst>
                  <a:gs pos="39000">
                    <a:schemeClr val="bg1"/>
                  </a:gs>
                  <a:gs pos="97000">
                    <a:schemeClr val="tx1">
                      <a:lumMod val="50000"/>
                      <a:lumOff val="5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Rectangle 173"/>
              <p:cNvSpPr/>
              <p:nvPr/>
            </p:nvSpPr>
            <p:spPr>
              <a:xfrm>
                <a:off x="3377930" y="1386424"/>
                <a:ext cx="48928" cy="3068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6" name="TextBox 175"/>
            <p:cNvSpPr txBox="1"/>
            <p:nvPr/>
          </p:nvSpPr>
          <p:spPr>
            <a:xfrm>
              <a:off x="4657298" y="3409540"/>
              <a:ext cx="5116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MCCD</a:t>
              </a:r>
            </a:p>
          </p:txBody>
        </p:sp>
        <p:sp>
          <p:nvSpPr>
            <p:cNvPr id="4" name="Rounded Rectangle 3"/>
            <p:cNvSpPr/>
            <p:nvPr/>
          </p:nvSpPr>
          <p:spPr>
            <a:xfrm>
              <a:off x="3883376" y="3133352"/>
              <a:ext cx="55452" cy="233504"/>
            </a:xfrm>
            <a:prstGeom prst="roundRect">
              <a:avLst/>
            </a:prstGeom>
            <a:solidFill>
              <a:schemeClr val="bg1">
                <a:lumMod val="75000"/>
                <a:alpha val="66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ounded Rectangle 83"/>
            <p:cNvSpPr/>
            <p:nvPr/>
          </p:nvSpPr>
          <p:spPr>
            <a:xfrm>
              <a:off x="3883376" y="2758258"/>
              <a:ext cx="55452" cy="233504"/>
            </a:xfrm>
            <a:prstGeom prst="roundRect">
              <a:avLst/>
            </a:prstGeom>
            <a:solidFill>
              <a:schemeClr val="bg1">
                <a:lumMod val="75000"/>
                <a:alpha val="66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780024" y="3340976"/>
              <a:ext cx="3321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F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754053" y="2566311"/>
              <a:ext cx="3321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F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385526" y="1628987"/>
              <a:ext cx="925253" cy="20005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nalog modulation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554603" y="2562405"/>
              <a:ext cx="6687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iber Optics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V="1">
              <a:off x="2789965" y="2420935"/>
              <a:ext cx="136767" cy="18583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4014846" y="3130464"/>
              <a:ext cx="106083" cy="9010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5214848" y="2872639"/>
              <a:ext cx="6559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Hardware </a:t>
              </a:r>
            </a:p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equencing</a:t>
              </a:r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3636647" y="2830057"/>
              <a:ext cx="139802" cy="13980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Rounded Rectangle 159"/>
            <p:cNvSpPr/>
            <p:nvPr/>
          </p:nvSpPr>
          <p:spPr>
            <a:xfrm>
              <a:off x="3695642" y="2365498"/>
              <a:ext cx="55452" cy="233504"/>
            </a:xfrm>
            <a:prstGeom prst="roundRect">
              <a:avLst/>
            </a:prstGeom>
            <a:solidFill>
              <a:schemeClr val="bg1">
                <a:lumMod val="75000"/>
                <a:alpha val="66000"/>
              </a:schemeClr>
            </a:solidFill>
            <a:ln w="12700">
              <a:solidFill>
                <a:schemeClr val="tx1"/>
              </a:solidFill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2460955" y="3413190"/>
              <a:ext cx="999669" cy="415498"/>
            </a:xfrm>
            <a:prstGeom prst="rect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mputer</a:t>
              </a:r>
            </a:p>
            <a:p>
              <a:pPr algn="ct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0"/>
            <p:cNvCxnSpPr/>
            <p:nvPr/>
          </p:nvCxnSpPr>
          <p:spPr>
            <a:xfrm flipV="1">
              <a:off x="5677713" y="1907887"/>
              <a:ext cx="356372" cy="186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1215147" y="1031481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2366598" y="1492757"/>
              <a:ext cx="9444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Objective Heater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515785" y="1540756"/>
              <a:ext cx="81272" cy="94749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Arrow Connector 27"/>
            <p:cNvCxnSpPr>
              <a:endCxn id="21" idx="1"/>
            </p:cNvCxnSpPr>
            <p:nvPr/>
          </p:nvCxnSpPr>
          <p:spPr>
            <a:xfrm flipV="1">
              <a:off x="3182357" y="1588131"/>
              <a:ext cx="333428" cy="5296"/>
            </a:xfrm>
            <a:prstGeom prst="straightConnector1">
              <a:avLst/>
            </a:prstGeom>
            <a:ln>
              <a:solidFill>
                <a:schemeClr val="tx1"/>
              </a:solidFill>
              <a:headEnd w="sm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</a:t>
            </a:r>
          </a:p>
        </p:txBody>
      </p: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A12D592F-9FC7-4A58-BBC5-26B66877C713}"/>
              </a:ext>
            </a:extLst>
          </p:cNvPr>
          <p:cNvGrpSpPr/>
          <p:nvPr/>
        </p:nvGrpSpPr>
        <p:grpSpPr>
          <a:xfrm>
            <a:off x="2171997" y="549783"/>
            <a:ext cx="2815103" cy="3780305"/>
            <a:chOff x="1934253" y="1299591"/>
            <a:chExt cx="2815103" cy="3780305"/>
          </a:xfrm>
        </p:grpSpPr>
        <p:sp>
          <p:nvSpPr>
            <p:cNvPr id="226" name="Rectangle 225">
              <a:extLst>
                <a:ext uri="{FF2B5EF4-FFF2-40B4-BE49-F238E27FC236}">
                  <a16:creationId xmlns:a16="http://schemas.microsoft.com/office/drawing/2014/main" id="{15C987AE-75A6-4D43-9DE8-5206EEC8CE3F}"/>
                </a:ext>
              </a:extLst>
            </p:cNvPr>
            <p:cNvSpPr/>
            <p:nvPr/>
          </p:nvSpPr>
          <p:spPr>
            <a:xfrm>
              <a:off x="2255168" y="4501020"/>
              <a:ext cx="1700711" cy="35288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27" name="Picture 226">
              <a:extLst>
                <a:ext uri="{FF2B5EF4-FFF2-40B4-BE49-F238E27FC236}">
                  <a16:creationId xmlns:a16="http://schemas.microsoft.com/office/drawing/2014/main" id="{66FADCD0-DE63-4978-8F8A-EE65652898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08" r="19988" b="8929"/>
            <a:stretch/>
          </p:blipFill>
          <p:spPr>
            <a:xfrm>
              <a:off x="2250457" y="1381306"/>
              <a:ext cx="1737770" cy="2728731"/>
            </a:xfrm>
            <a:prstGeom prst="rect">
              <a:avLst/>
            </a:prstGeom>
          </p:spPr>
        </p:pic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88963968-A8C0-4452-932B-266BCC3F7B22}"/>
                </a:ext>
              </a:extLst>
            </p:cNvPr>
            <p:cNvSpPr txBox="1"/>
            <p:nvPr/>
          </p:nvSpPr>
          <p:spPr>
            <a:xfrm>
              <a:off x="3506123" y="2817680"/>
              <a:ext cx="4110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y5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BE59D4EF-3641-40DB-BC66-E3D891266D74}"/>
                </a:ext>
              </a:extLst>
            </p:cNvPr>
            <p:cNvSpPr txBox="1"/>
            <p:nvPr/>
          </p:nvSpPr>
          <p:spPr>
            <a:xfrm>
              <a:off x="1934253" y="1864386"/>
              <a:ext cx="41710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 Cell</a:t>
              </a:r>
            </a:p>
          </p:txBody>
        </p:sp>
        <p:sp>
          <p:nvSpPr>
            <p:cNvPr id="230" name="5-Point Star 13">
              <a:extLst>
                <a:ext uri="{FF2B5EF4-FFF2-40B4-BE49-F238E27FC236}">
                  <a16:creationId xmlns:a16="http://schemas.microsoft.com/office/drawing/2014/main" id="{24C4DB33-093B-427C-A21F-4D925711F392}"/>
                </a:ext>
              </a:extLst>
            </p:cNvPr>
            <p:cNvSpPr/>
            <p:nvPr/>
          </p:nvSpPr>
          <p:spPr>
            <a:xfrm>
              <a:off x="3031960" y="3115100"/>
              <a:ext cx="137160" cy="137160"/>
            </a:xfrm>
            <a:prstGeom prst="star5">
              <a:avLst/>
            </a:prstGeom>
            <a:solidFill>
              <a:srgbClr val="00FF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5-Point Star 14">
              <a:extLst>
                <a:ext uri="{FF2B5EF4-FFF2-40B4-BE49-F238E27FC236}">
                  <a16:creationId xmlns:a16="http://schemas.microsoft.com/office/drawing/2014/main" id="{12D59F41-705D-422C-957D-F4D38EA81494}"/>
                </a:ext>
              </a:extLst>
            </p:cNvPr>
            <p:cNvSpPr/>
            <p:nvPr/>
          </p:nvSpPr>
          <p:spPr>
            <a:xfrm>
              <a:off x="3436788" y="2770152"/>
              <a:ext cx="137160" cy="137160"/>
            </a:xfrm>
            <a:prstGeom prst="star5">
              <a:avLst/>
            </a:prstGeom>
            <a:solidFill>
              <a:srgbClr val="FF0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2DC18020-06E7-4480-8491-77671AA25B53}"/>
                </a:ext>
              </a:extLst>
            </p:cNvPr>
            <p:cNvSpPr txBox="1"/>
            <p:nvPr/>
          </p:nvSpPr>
          <p:spPr>
            <a:xfrm rot="18850014">
              <a:off x="3226595" y="2998578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RET1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210B5FAD-F3BA-4D70-AA39-BF230FE21880}"/>
                </a:ext>
              </a:extLst>
            </p:cNvPr>
            <p:cNvSpPr txBox="1"/>
            <p:nvPr/>
          </p:nvSpPr>
          <p:spPr>
            <a:xfrm>
              <a:off x="2351355" y="3328109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MHC</a:t>
              </a:r>
            </a:p>
          </p:txBody>
        </p:sp>
        <p:cxnSp>
          <p:nvCxnSpPr>
            <p:cNvPr id="237" name="Straight Arrow Connector 236">
              <a:extLst>
                <a:ext uri="{FF2B5EF4-FFF2-40B4-BE49-F238E27FC236}">
                  <a16:creationId xmlns:a16="http://schemas.microsoft.com/office/drawing/2014/main" id="{95EF9DB3-2E72-4F72-B9D3-0D12A8ED3EF0}"/>
                </a:ext>
              </a:extLst>
            </p:cNvPr>
            <p:cNvCxnSpPr/>
            <p:nvPr/>
          </p:nvCxnSpPr>
          <p:spPr>
            <a:xfrm flipH="1" flipV="1">
              <a:off x="3171036" y="3233903"/>
              <a:ext cx="197287" cy="132587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D4404508-84B0-4208-A0FE-65E496D30759}"/>
                </a:ext>
              </a:extLst>
            </p:cNvPr>
            <p:cNvSpPr txBox="1"/>
            <p:nvPr/>
          </p:nvSpPr>
          <p:spPr>
            <a:xfrm>
              <a:off x="2586611" y="1299591"/>
              <a:ext cx="6174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E5A07993-6CD5-4165-A5E9-2958F5335C20}"/>
                </a:ext>
              </a:extLst>
            </p:cNvPr>
            <p:cNvSpPr txBox="1"/>
            <p:nvPr/>
          </p:nvSpPr>
          <p:spPr>
            <a:xfrm rot="2716429">
              <a:off x="3370240" y="1790337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FRET2</a:t>
              </a:r>
            </a:p>
          </p:txBody>
        </p:sp>
        <p:sp>
          <p:nvSpPr>
            <p:cNvPr id="241" name="Rectangle 240">
              <a:extLst>
                <a:ext uri="{FF2B5EF4-FFF2-40B4-BE49-F238E27FC236}">
                  <a16:creationId xmlns:a16="http://schemas.microsoft.com/office/drawing/2014/main" id="{818A7AAA-84AD-4929-A3D2-1587A8E0D59D}"/>
                </a:ext>
              </a:extLst>
            </p:cNvPr>
            <p:cNvSpPr/>
            <p:nvPr/>
          </p:nvSpPr>
          <p:spPr>
            <a:xfrm>
              <a:off x="2240848" y="4856244"/>
              <a:ext cx="1737360" cy="6058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5-Point Star 22">
              <a:extLst>
                <a:ext uri="{FF2B5EF4-FFF2-40B4-BE49-F238E27FC236}">
                  <a16:creationId xmlns:a16="http://schemas.microsoft.com/office/drawing/2014/main" id="{899EAF97-4744-4788-A8B2-A5E2A410231F}"/>
                </a:ext>
              </a:extLst>
            </p:cNvPr>
            <p:cNvSpPr/>
            <p:nvPr/>
          </p:nvSpPr>
          <p:spPr>
            <a:xfrm>
              <a:off x="3818026" y="2263892"/>
              <a:ext cx="137160" cy="137160"/>
            </a:xfrm>
            <a:prstGeom prst="star5">
              <a:avLst/>
            </a:prstGeom>
            <a:solidFill>
              <a:srgbClr val="FF0000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8EDEF9BA-8A14-4BB6-B43D-7A75DA4F7821}"/>
                </a:ext>
              </a:extLst>
            </p:cNvPr>
            <p:cNvSpPr/>
            <p:nvPr/>
          </p:nvSpPr>
          <p:spPr>
            <a:xfrm>
              <a:off x="3750328" y="2556531"/>
              <a:ext cx="40107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cFv</a:t>
              </a:r>
            </a:p>
          </p:txBody>
        </p:sp>
        <p:sp>
          <p:nvSpPr>
            <p:cNvPr id="244" name="Rectangle 243">
              <a:extLst>
                <a:ext uri="{FF2B5EF4-FFF2-40B4-BE49-F238E27FC236}">
                  <a16:creationId xmlns:a16="http://schemas.microsoft.com/office/drawing/2014/main" id="{AF34BD9D-9F95-48B0-9A69-0A7A98C832F5}"/>
                </a:ext>
              </a:extLst>
            </p:cNvPr>
            <p:cNvSpPr/>
            <p:nvPr/>
          </p:nvSpPr>
          <p:spPr>
            <a:xfrm>
              <a:off x="3294254" y="3281451"/>
              <a:ext cx="36740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y3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E023E0FE-C01B-468B-8B4E-EC73BFDE9586}"/>
                </a:ext>
              </a:extLst>
            </p:cNvPr>
            <p:cNvSpPr txBox="1"/>
            <p:nvPr/>
          </p:nvSpPr>
          <p:spPr>
            <a:xfrm>
              <a:off x="2364632" y="2725575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</a:p>
          </p:txBody>
        </p:sp>
        <p:cxnSp>
          <p:nvCxnSpPr>
            <p:cNvPr id="246" name="Straight Arrow Connector 245">
              <a:extLst>
                <a:ext uri="{FF2B5EF4-FFF2-40B4-BE49-F238E27FC236}">
                  <a16:creationId xmlns:a16="http://schemas.microsoft.com/office/drawing/2014/main" id="{F0276A8A-8FC3-43E7-94D4-CC4EBA92BA72}"/>
                </a:ext>
              </a:extLst>
            </p:cNvPr>
            <p:cNvCxnSpPr/>
            <p:nvPr/>
          </p:nvCxnSpPr>
          <p:spPr>
            <a:xfrm>
              <a:off x="2995492" y="1450132"/>
              <a:ext cx="72935" cy="16219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Arrow Connector 246">
              <a:extLst>
                <a:ext uri="{FF2B5EF4-FFF2-40B4-BE49-F238E27FC236}">
                  <a16:creationId xmlns:a16="http://schemas.microsoft.com/office/drawing/2014/main" id="{5AFB418B-DCFF-4E70-8D07-0CCB39E3940B}"/>
                </a:ext>
              </a:extLst>
            </p:cNvPr>
            <p:cNvCxnSpPr/>
            <p:nvPr/>
          </p:nvCxnSpPr>
          <p:spPr>
            <a:xfrm flipH="1">
              <a:off x="2662374" y="1455773"/>
              <a:ext cx="129740" cy="97142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Arrow Connector 247">
              <a:extLst>
                <a:ext uri="{FF2B5EF4-FFF2-40B4-BE49-F238E27FC236}">
                  <a16:creationId xmlns:a16="http://schemas.microsoft.com/office/drawing/2014/main" id="{07ABDDDD-787F-409A-BA24-4B00FB39C9DF}"/>
                </a:ext>
              </a:extLst>
            </p:cNvPr>
            <p:cNvCxnSpPr/>
            <p:nvPr/>
          </p:nvCxnSpPr>
          <p:spPr>
            <a:xfrm flipH="1" flipV="1">
              <a:off x="3931040" y="2350594"/>
              <a:ext cx="319947" cy="50458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A6F50BD0-9C15-4C3F-8090-A89866BA653F}"/>
                </a:ext>
              </a:extLst>
            </p:cNvPr>
            <p:cNvSpPr txBox="1"/>
            <p:nvPr/>
          </p:nvSpPr>
          <p:spPr>
            <a:xfrm>
              <a:off x="3360813" y="4879841"/>
              <a:ext cx="6783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ver Glass</a:t>
              </a:r>
            </a:p>
          </p:txBody>
        </p:sp>
        <p:cxnSp>
          <p:nvCxnSpPr>
            <p:cNvPr id="250" name="Straight Arrow Connector 249">
              <a:extLst>
                <a:ext uri="{FF2B5EF4-FFF2-40B4-BE49-F238E27FC236}">
                  <a16:creationId xmlns:a16="http://schemas.microsoft.com/office/drawing/2014/main" id="{5DBAEE37-6F71-4445-97A3-624ADDCAF7E4}"/>
                </a:ext>
              </a:extLst>
            </p:cNvPr>
            <p:cNvCxnSpPr/>
            <p:nvPr/>
          </p:nvCxnSpPr>
          <p:spPr>
            <a:xfrm>
              <a:off x="3350407" y="1800113"/>
              <a:ext cx="485775" cy="481012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sysDash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Straight Arrow Connector 250">
              <a:extLst>
                <a:ext uri="{FF2B5EF4-FFF2-40B4-BE49-F238E27FC236}">
                  <a16:creationId xmlns:a16="http://schemas.microsoft.com/office/drawing/2014/main" id="{9C67FA6D-7E76-46AC-9C14-6587EA54CE50}"/>
                </a:ext>
              </a:extLst>
            </p:cNvPr>
            <p:cNvCxnSpPr/>
            <p:nvPr/>
          </p:nvCxnSpPr>
          <p:spPr>
            <a:xfrm flipV="1">
              <a:off x="3160778" y="2898762"/>
              <a:ext cx="331127" cy="298166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sysDash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40A45B66-24D1-414D-B4B6-E6DD0FCB3C60}"/>
                </a:ext>
              </a:extLst>
            </p:cNvPr>
            <p:cNvSpPr txBox="1"/>
            <p:nvPr/>
          </p:nvSpPr>
          <p:spPr>
            <a:xfrm>
              <a:off x="4162336" y="2311337"/>
              <a:ext cx="5870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lexa-568</a:t>
              </a:r>
            </a:p>
          </p:txBody>
        </p:sp>
        <p:grpSp>
          <p:nvGrpSpPr>
            <p:cNvPr id="253" name="Group 252">
              <a:extLst>
                <a:ext uri="{FF2B5EF4-FFF2-40B4-BE49-F238E27FC236}">
                  <a16:creationId xmlns:a16="http://schemas.microsoft.com/office/drawing/2014/main" id="{6322B2B3-93C6-4BEB-B0E2-2D9E60F3E2B6}"/>
                </a:ext>
              </a:extLst>
            </p:cNvPr>
            <p:cNvGrpSpPr/>
            <p:nvPr/>
          </p:nvGrpSpPr>
          <p:grpSpPr>
            <a:xfrm>
              <a:off x="3726947" y="4446464"/>
              <a:ext cx="319318" cy="240294"/>
              <a:chOff x="3726947" y="4446464"/>
              <a:chExt cx="319318" cy="240294"/>
            </a:xfrm>
          </p:grpSpPr>
          <p:cxnSp>
            <p:nvCxnSpPr>
              <p:cNvPr id="274" name="Straight Connector 273">
                <a:extLst>
                  <a:ext uri="{FF2B5EF4-FFF2-40B4-BE49-F238E27FC236}">
                    <a16:creationId xmlns:a16="http://schemas.microsoft.com/office/drawing/2014/main" id="{2430DD82-2A1D-4F39-81AB-09FA01F8785D}"/>
                  </a:ext>
                </a:extLst>
              </p:cNvPr>
              <p:cNvCxnSpPr/>
              <p:nvPr/>
            </p:nvCxnSpPr>
            <p:spPr>
              <a:xfrm flipV="1">
                <a:off x="3851610" y="4591965"/>
                <a:ext cx="0" cy="9479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B530B007-F87C-4DA1-AEAF-E72AF02F7354}"/>
                  </a:ext>
                </a:extLst>
              </p:cNvPr>
              <p:cNvSpPr txBox="1"/>
              <p:nvPr/>
            </p:nvSpPr>
            <p:spPr>
              <a:xfrm>
                <a:off x="3726947" y="4446464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H</a:t>
                </a:r>
              </a:p>
            </p:txBody>
          </p:sp>
        </p:grpSp>
        <p:grpSp>
          <p:nvGrpSpPr>
            <p:cNvPr id="254" name="Group 253">
              <a:extLst>
                <a:ext uri="{FF2B5EF4-FFF2-40B4-BE49-F238E27FC236}">
                  <a16:creationId xmlns:a16="http://schemas.microsoft.com/office/drawing/2014/main" id="{B90B073D-ED8F-468E-896E-39FF1080E98E}"/>
                </a:ext>
              </a:extLst>
            </p:cNvPr>
            <p:cNvGrpSpPr/>
            <p:nvPr/>
          </p:nvGrpSpPr>
          <p:grpSpPr>
            <a:xfrm>
              <a:off x="3360813" y="4446464"/>
              <a:ext cx="319318" cy="240294"/>
              <a:chOff x="3726947" y="4446464"/>
              <a:chExt cx="319318" cy="240294"/>
            </a:xfrm>
          </p:grpSpPr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CB07217C-15DD-4400-A988-6DCDB2311244}"/>
                  </a:ext>
                </a:extLst>
              </p:cNvPr>
              <p:cNvCxnSpPr/>
              <p:nvPr/>
            </p:nvCxnSpPr>
            <p:spPr>
              <a:xfrm flipV="1">
                <a:off x="3851610" y="4591965"/>
                <a:ext cx="0" cy="9479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558A2EB7-1D07-40AF-92C7-336662A1AEA3}"/>
                  </a:ext>
                </a:extLst>
              </p:cNvPr>
              <p:cNvSpPr txBox="1"/>
              <p:nvPr/>
            </p:nvSpPr>
            <p:spPr>
              <a:xfrm>
                <a:off x="3726947" y="4446464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H</a:t>
                </a:r>
              </a:p>
            </p:txBody>
          </p:sp>
        </p:grpSp>
        <p:grpSp>
          <p:nvGrpSpPr>
            <p:cNvPr id="255" name="Group 254">
              <a:extLst>
                <a:ext uri="{FF2B5EF4-FFF2-40B4-BE49-F238E27FC236}">
                  <a16:creationId xmlns:a16="http://schemas.microsoft.com/office/drawing/2014/main" id="{B04BD59D-D18A-41F4-9BD7-3A91D896AE34}"/>
                </a:ext>
              </a:extLst>
            </p:cNvPr>
            <p:cNvGrpSpPr/>
            <p:nvPr/>
          </p:nvGrpSpPr>
          <p:grpSpPr>
            <a:xfrm>
              <a:off x="2994679" y="4446464"/>
              <a:ext cx="319318" cy="240294"/>
              <a:chOff x="3726947" y="4446464"/>
              <a:chExt cx="319318" cy="240294"/>
            </a:xfrm>
          </p:grpSpPr>
          <p:cxnSp>
            <p:nvCxnSpPr>
              <p:cNvPr id="270" name="Straight Connector 269">
                <a:extLst>
                  <a:ext uri="{FF2B5EF4-FFF2-40B4-BE49-F238E27FC236}">
                    <a16:creationId xmlns:a16="http://schemas.microsoft.com/office/drawing/2014/main" id="{6B999102-455B-451B-9D06-D87D8B9BA956}"/>
                  </a:ext>
                </a:extLst>
              </p:cNvPr>
              <p:cNvCxnSpPr/>
              <p:nvPr/>
            </p:nvCxnSpPr>
            <p:spPr>
              <a:xfrm flipV="1">
                <a:off x="3851610" y="4591965"/>
                <a:ext cx="0" cy="9479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1" name="TextBox 270">
                <a:extLst>
                  <a:ext uri="{FF2B5EF4-FFF2-40B4-BE49-F238E27FC236}">
                    <a16:creationId xmlns:a16="http://schemas.microsoft.com/office/drawing/2014/main" id="{CCF10E44-C446-4A88-8053-C0192A560405}"/>
                  </a:ext>
                </a:extLst>
              </p:cNvPr>
              <p:cNvSpPr txBox="1"/>
              <p:nvPr/>
            </p:nvSpPr>
            <p:spPr>
              <a:xfrm>
                <a:off x="3726947" y="4446464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H</a:t>
                </a:r>
              </a:p>
            </p:txBody>
          </p:sp>
        </p:grpSp>
        <p:grpSp>
          <p:nvGrpSpPr>
            <p:cNvPr id="256" name="Group 255">
              <a:extLst>
                <a:ext uri="{FF2B5EF4-FFF2-40B4-BE49-F238E27FC236}">
                  <a16:creationId xmlns:a16="http://schemas.microsoft.com/office/drawing/2014/main" id="{EB9DC91B-6957-46B6-A59D-DB11E09A2FCC}"/>
                </a:ext>
              </a:extLst>
            </p:cNvPr>
            <p:cNvGrpSpPr/>
            <p:nvPr/>
          </p:nvGrpSpPr>
          <p:grpSpPr>
            <a:xfrm>
              <a:off x="2628545" y="4446464"/>
              <a:ext cx="319318" cy="240294"/>
              <a:chOff x="3726947" y="4446464"/>
              <a:chExt cx="319318" cy="240294"/>
            </a:xfrm>
          </p:grpSpPr>
          <p:cxnSp>
            <p:nvCxnSpPr>
              <p:cNvPr id="268" name="Straight Connector 267">
                <a:extLst>
                  <a:ext uri="{FF2B5EF4-FFF2-40B4-BE49-F238E27FC236}">
                    <a16:creationId xmlns:a16="http://schemas.microsoft.com/office/drawing/2014/main" id="{222CD337-A797-4A75-BDF8-F0AE32D1270A}"/>
                  </a:ext>
                </a:extLst>
              </p:cNvPr>
              <p:cNvCxnSpPr/>
              <p:nvPr/>
            </p:nvCxnSpPr>
            <p:spPr>
              <a:xfrm flipV="1">
                <a:off x="3851610" y="4591965"/>
                <a:ext cx="0" cy="9479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id="{10187A70-70EC-4CE4-A3D7-26917C32260F}"/>
                  </a:ext>
                </a:extLst>
              </p:cNvPr>
              <p:cNvSpPr txBox="1"/>
              <p:nvPr/>
            </p:nvSpPr>
            <p:spPr>
              <a:xfrm>
                <a:off x="3726947" y="4446464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H</a:t>
                </a:r>
              </a:p>
            </p:txBody>
          </p:sp>
        </p:grpSp>
        <p:grpSp>
          <p:nvGrpSpPr>
            <p:cNvPr id="257" name="Group 256">
              <a:extLst>
                <a:ext uri="{FF2B5EF4-FFF2-40B4-BE49-F238E27FC236}">
                  <a16:creationId xmlns:a16="http://schemas.microsoft.com/office/drawing/2014/main" id="{8A534F9B-7BC5-4F38-AED1-83B71A56E9B8}"/>
                </a:ext>
              </a:extLst>
            </p:cNvPr>
            <p:cNvGrpSpPr/>
            <p:nvPr/>
          </p:nvGrpSpPr>
          <p:grpSpPr>
            <a:xfrm>
              <a:off x="2232839" y="4446464"/>
              <a:ext cx="319318" cy="240294"/>
              <a:chOff x="3726947" y="4446464"/>
              <a:chExt cx="319318" cy="240294"/>
            </a:xfrm>
          </p:grpSpPr>
          <p:cxnSp>
            <p:nvCxnSpPr>
              <p:cNvPr id="266" name="Straight Connector 265">
                <a:extLst>
                  <a:ext uri="{FF2B5EF4-FFF2-40B4-BE49-F238E27FC236}">
                    <a16:creationId xmlns:a16="http://schemas.microsoft.com/office/drawing/2014/main" id="{19ECAF71-F88A-4697-9CE5-6976ECE8F870}"/>
                  </a:ext>
                </a:extLst>
              </p:cNvPr>
              <p:cNvCxnSpPr/>
              <p:nvPr/>
            </p:nvCxnSpPr>
            <p:spPr>
              <a:xfrm flipV="1">
                <a:off x="3851610" y="4591965"/>
                <a:ext cx="0" cy="9479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1EACDE9C-A8A5-4701-9444-ABF44D76671C}"/>
                  </a:ext>
                </a:extLst>
              </p:cNvPr>
              <p:cNvSpPr txBox="1"/>
              <p:nvPr/>
            </p:nvSpPr>
            <p:spPr>
              <a:xfrm>
                <a:off x="3726947" y="4446464"/>
                <a:ext cx="31931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H</a:t>
                </a:r>
              </a:p>
            </p:txBody>
          </p:sp>
        </p:grpSp>
        <p:grpSp>
          <p:nvGrpSpPr>
            <p:cNvPr id="258" name="Group 257">
              <a:extLst>
                <a:ext uri="{FF2B5EF4-FFF2-40B4-BE49-F238E27FC236}">
                  <a16:creationId xmlns:a16="http://schemas.microsoft.com/office/drawing/2014/main" id="{317F69BD-7CA5-403F-B7E4-8BBFBA649DFD}"/>
                </a:ext>
              </a:extLst>
            </p:cNvPr>
            <p:cNvGrpSpPr/>
            <p:nvPr/>
          </p:nvGrpSpPr>
          <p:grpSpPr>
            <a:xfrm>
              <a:off x="2945606" y="4226802"/>
              <a:ext cx="194576" cy="478546"/>
              <a:chOff x="2945606" y="4200611"/>
              <a:chExt cx="194576" cy="478546"/>
            </a:xfrm>
          </p:grpSpPr>
          <p:sp>
            <p:nvSpPr>
              <p:cNvPr id="264" name="Freeform 46">
                <a:extLst>
                  <a:ext uri="{FF2B5EF4-FFF2-40B4-BE49-F238E27FC236}">
                    <a16:creationId xmlns:a16="http://schemas.microsoft.com/office/drawing/2014/main" id="{75C9C0D8-B653-4608-A281-EE026978FAE5}"/>
                  </a:ext>
                </a:extLst>
              </p:cNvPr>
              <p:cNvSpPr/>
              <p:nvPr/>
            </p:nvSpPr>
            <p:spPr>
              <a:xfrm>
                <a:off x="2945606" y="4274344"/>
                <a:ext cx="80963" cy="404813"/>
              </a:xfrm>
              <a:custGeom>
                <a:avLst/>
                <a:gdLst>
                  <a:gd name="connsiteX0" fmla="*/ 19050 w 80963"/>
                  <a:gd name="connsiteY0" fmla="*/ 404813 h 404813"/>
                  <a:gd name="connsiteX1" fmla="*/ 28575 w 80963"/>
                  <a:gd name="connsiteY1" fmla="*/ 376238 h 404813"/>
                  <a:gd name="connsiteX2" fmla="*/ 35719 w 80963"/>
                  <a:gd name="connsiteY2" fmla="*/ 366713 h 404813"/>
                  <a:gd name="connsiteX3" fmla="*/ 40482 w 80963"/>
                  <a:gd name="connsiteY3" fmla="*/ 359569 h 404813"/>
                  <a:gd name="connsiteX4" fmla="*/ 42863 w 80963"/>
                  <a:gd name="connsiteY4" fmla="*/ 352425 h 404813"/>
                  <a:gd name="connsiteX5" fmla="*/ 30957 w 80963"/>
                  <a:gd name="connsiteY5" fmla="*/ 295275 h 404813"/>
                  <a:gd name="connsiteX6" fmla="*/ 40482 w 80963"/>
                  <a:gd name="connsiteY6" fmla="*/ 247650 h 404813"/>
                  <a:gd name="connsiteX7" fmla="*/ 50007 w 80963"/>
                  <a:gd name="connsiteY7" fmla="*/ 238125 h 404813"/>
                  <a:gd name="connsiteX8" fmla="*/ 54769 w 80963"/>
                  <a:gd name="connsiteY8" fmla="*/ 228600 h 404813"/>
                  <a:gd name="connsiteX9" fmla="*/ 50007 w 80963"/>
                  <a:gd name="connsiteY9" fmla="*/ 207169 h 404813"/>
                  <a:gd name="connsiteX10" fmla="*/ 40482 w 80963"/>
                  <a:gd name="connsiteY10" fmla="*/ 183356 h 404813"/>
                  <a:gd name="connsiteX11" fmla="*/ 33338 w 80963"/>
                  <a:gd name="connsiteY11" fmla="*/ 176213 h 404813"/>
                  <a:gd name="connsiteX12" fmla="*/ 23813 w 80963"/>
                  <a:gd name="connsiteY12" fmla="*/ 161925 h 404813"/>
                  <a:gd name="connsiteX13" fmla="*/ 19050 w 80963"/>
                  <a:gd name="connsiteY13" fmla="*/ 152400 h 404813"/>
                  <a:gd name="connsiteX14" fmla="*/ 23813 w 80963"/>
                  <a:gd name="connsiteY14" fmla="*/ 100013 h 404813"/>
                  <a:gd name="connsiteX15" fmla="*/ 0 w 80963"/>
                  <a:gd name="connsiteY15" fmla="*/ 88106 h 404813"/>
                  <a:gd name="connsiteX16" fmla="*/ 9525 w 80963"/>
                  <a:gd name="connsiteY16" fmla="*/ 59531 h 404813"/>
                  <a:gd name="connsiteX17" fmla="*/ 23813 w 80963"/>
                  <a:gd name="connsiteY17" fmla="*/ 54769 h 404813"/>
                  <a:gd name="connsiteX18" fmla="*/ 38100 w 80963"/>
                  <a:gd name="connsiteY18" fmla="*/ 19050 h 404813"/>
                  <a:gd name="connsiteX19" fmla="*/ 52388 w 80963"/>
                  <a:gd name="connsiteY19" fmla="*/ 14288 h 404813"/>
                  <a:gd name="connsiteX20" fmla="*/ 59532 w 80963"/>
                  <a:gd name="connsiteY20" fmla="*/ 11906 h 404813"/>
                  <a:gd name="connsiteX21" fmla="*/ 73819 w 80963"/>
                  <a:gd name="connsiteY21" fmla="*/ 2381 h 404813"/>
                  <a:gd name="connsiteX22" fmla="*/ 80963 w 80963"/>
                  <a:gd name="connsiteY22" fmla="*/ 0 h 4048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80963" h="404813">
                    <a:moveTo>
                      <a:pt x="19050" y="404813"/>
                    </a:moveTo>
                    <a:cubicBezTo>
                      <a:pt x="21140" y="397499"/>
                      <a:pt x="24513" y="383550"/>
                      <a:pt x="28575" y="376238"/>
                    </a:cubicBezTo>
                    <a:cubicBezTo>
                      <a:pt x="30502" y="372769"/>
                      <a:pt x="33412" y="369942"/>
                      <a:pt x="35719" y="366713"/>
                    </a:cubicBezTo>
                    <a:cubicBezTo>
                      <a:pt x="37383" y="364384"/>
                      <a:pt x="38894" y="361950"/>
                      <a:pt x="40482" y="359569"/>
                    </a:cubicBezTo>
                    <a:cubicBezTo>
                      <a:pt x="41276" y="357188"/>
                      <a:pt x="43080" y="354926"/>
                      <a:pt x="42863" y="352425"/>
                    </a:cubicBezTo>
                    <a:cubicBezTo>
                      <a:pt x="39095" y="309095"/>
                      <a:pt x="42034" y="317432"/>
                      <a:pt x="30957" y="295275"/>
                    </a:cubicBezTo>
                    <a:cubicBezTo>
                      <a:pt x="32978" y="262932"/>
                      <a:pt x="25892" y="264324"/>
                      <a:pt x="40482" y="247650"/>
                    </a:cubicBezTo>
                    <a:cubicBezTo>
                      <a:pt x="43439" y="244271"/>
                      <a:pt x="46832" y="241300"/>
                      <a:pt x="50007" y="238125"/>
                    </a:cubicBezTo>
                    <a:cubicBezTo>
                      <a:pt x="51594" y="234950"/>
                      <a:pt x="54769" y="232150"/>
                      <a:pt x="54769" y="228600"/>
                    </a:cubicBezTo>
                    <a:cubicBezTo>
                      <a:pt x="54769" y="221282"/>
                      <a:pt x="51782" y="214268"/>
                      <a:pt x="50007" y="207169"/>
                    </a:cubicBezTo>
                    <a:cubicBezTo>
                      <a:pt x="48520" y="201221"/>
                      <a:pt x="41854" y="185643"/>
                      <a:pt x="40482" y="183356"/>
                    </a:cubicBezTo>
                    <a:cubicBezTo>
                      <a:pt x="38749" y="180468"/>
                      <a:pt x="35719" y="178594"/>
                      <a:pt x="33338" y="176213"/>
                    </a:cubicBezTo>
                    <a:cubicBezTo>
                      <a:pt x="28231" y="160890"/>
                      <a:pt x="34961" y="177531"/>
                      <a:pt x="23813" y="161925"/>
                    </a:cubicBezTo>
                    <a:cubicBezTo>
                      <a:pt x="21750" y="159036"/>
                      <a:pt x="20638" y="155575"/>
                      <a:pt x="19050" y="152400"/>
                    </a:cubicBezTo>
                    <a:cubicBezTo>
                      <a:pt x="21473" y="142708"/>
                      <a:pt x="32578" y="111966"/>
                      <a:pt x="23813" y="100013"/>
                    </a:cubicBezTo>
                    <a:cubicBezTo>
                      <a:pt x="18565" y="92856"/>
                      <a:pt x="0" y="88106"/>
                      <a:pt x="0" y="88106"/>
                    </a:cubicBezTo>
                    <a:cubicBezTo>
                      <a:pt x="1264" y="78001"/>
                      <a:pt x="-458" y="66186"/>
                      <a:pt x="9525" y="59531"/>
                    </a:cubicBezTo>
                    <a:cubicBezTo>
                      <a:pt x="13702" y="56746"/>
                      <a:pt x="23813" y="54769"/>
                      <a:pt x="23813" y="54769"/>
                    </a:cubicBezTo>
                    <a:cubicBezTo>
                      <a:pt x="26473" y="44129"/>
                      <a:pt x="25833" y="25865"/>
                      <a:pt x="38100" y="19050"/>
                    </a:cubicBezTo>
                    <a:cubicBezTo>
                      <a:pt x="42488" y="16612"/>
                      <a:pt x="47625" y="15876"/>
                      <a:pt x="52388" y="14288"/>
                    </a:cubicBezTo>
                    <a:cubicBezTo>
                      <a:pt x="54769" y="13494"/>
                      <a:pt x="57443" y="13298"/>
                      <a:pt x="59532" y="11906"/>
                    </a:cubicBezTo>
                    <a:cubicBezTo>
                      <a:pt x="64294" y="8731"/>
                      <a:pt x="68389" y="4191"/>
                      <a:pt x="73819" y="2381"/>
                    </a:cubicBezTo>
                    <a:lnTo>
                      <a:pt x="80963" y="0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5" name="Freeform 47">
                <a:extLst>
                  <a:ext uri="{FF2B5EF4-FFF2-40B4-BE49-F238E27FC236}">
                    <a16:creationId xmlns:a16="http://schemas.microsoft.com/office/drawing/2014/main" id="{D664FD9D-BCA8-438F-85D1-A02CB0FFEDC9}"/>
                  </a:ext>
                </a:extLst>
              </p:cNvPr>
              <p:cNvSpPr/>
              <p:nvPr/>
            </p:nvSpPr>
            <p:spPr>
              <a:xfrm>
                <a:off x="2955035" y="4200611"/>
                <a:ext cx="185147" cy="75642"/>
              </a:xfrm>
              <a:custGeom>
                <a:avLst/>
                <a:gdLst>
                  <a:gd name="connsiteX0" fmla="*/ 0 w 247650"/>
                  <a:gd name="connsiteY0" fmla="*/ 0 h 142875"/>
                  <a:gd name="connsiteX1" fmla="*/ 7144 w 247650"/>
                  <a:gd name="connsiteY1" fmla="*/ 14287 h 142875"/>
                  <a:gd name="connsiteX2" fmla="*/ 14288 w 247650"/>
                  <a:gd name="connsiteY2" fmla="*/ 23812 h 142875"/>
                  <a:gd name="connsiteX3" fmla="*/ 21432 w 247650"/>
                  <a:gd name="connsiteY3" fmla="*/ 61912 h 142875"/>
                  <a:gd name="connsiteX4" fmla="*/ 28575 w 247650"/>
                  <a:gd name="connsiteY4" fmla="*/ 73818 h 142875"/>
                  <a:gd name="connsiteX5" fmla="*/ 42863 w 247650"/>
                  <a:gd name="connsiteY5" fmla="*/ 88106 h 142875"/>
                  <a:gd name="connsiteX6" fmla="*/ 47625 w 247650"/>
                  <a:gd name="connsiteY6" fmla="*/ 95250 h 142875"/>
                  <a:gd name="connsiteX7" fmla="*/ 50007 w 247650"/>
                  <a:gd name="connsiteY7" fmla="*/ 102393 h 142875"/>
                  <a:gd name="connsiteX8" fmla="*/ 57150 w 247650"/>
                  <a:gd name="connsiteY8" fmla="*/ 109537 h 142875"/>
                  <a:gd name="connsiteX9" fmla="*/ 59532 w 247650"/>
                  <a:gd name="connsiteY9" fmla="*/ 116681 h 142875"/>
                  <a:gd name="connsiteX10" fmla="*/ 73819 w 247650"/>
                  <a:gd name="connsiteY10" fmla="*/ 133350 h 142875"/>
                  <a:gd name="connsiteX11" fmla="*/ 80963 w 247650"/>
                  <a:gd name="connsiteY11" fmla="*/ 138112 h 142875"/>
                  <a:gd name="connsiteX12" fmla="*/ 97632 w 247650"/>
                  <a:gd name="connsiteY12" fmla="*/ 142875 h 142875"/>
                  <a:gd name="connsiteX13" fmla="*/ 166688 w 247650"/>
                  <a:gd name="connsiteY13" fmla="*/ 140493 h 142875"/>
                  <a:gd name="connsiteX14" fmla="*/ 180975 w 247650"/>
                  <a:gd name="connsiteY14" fmla="*/ 133350 h 142875"/>
                  <a:gd name="connsiteX15" fmla="*/ 188119 w 247650"/>
                  <a:gd name="connsiteY15" fmla="*/ 130968 h 142875"/>
                  <a:gd name="connsiteX16" fmla="*/ 214313 w 247650"/>
                  <a:gd name="connsiteY16" fmla="*/ 119062 h 142875"/>
                  <a:gd name="connsiteX17" fmla="*/ 240507 w 247650"/>
                  <a:gd name="connsiteY17" fmla="*/ 97631 h 142875"/>
                  <a:gd name="connsiteX18" fmla="*/ 247650 w 247650"/>
                  <a:gd name="connsiteY18" fmla="*/ 88106 h 1428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247650" h="142875">
                    <a:moveTo>
                      <a:pt x="0" y="0"/>
                    </a:moveTo>
                    <a:cubicBezTo>
                      <a:pt x="2381" y="4762"/>
                      <a:pt x="4404" y="9721"/>
                      <a:pt x="7144" y="14287"/>
                    </a:cubicBezTo>
                    <a:cubicBezTo>
                      <a:pt x="9186" y="17690"/>
                      <a:pt x="12814" y="20127"/>
                      <a:pt x="14288" y="23812"/>
                    </a:cubicBezTo>
                    <a:cubicBezTo>
                      <a:pt x="19971" y="38020"/>
                      <a:pt x="12417" y="46886"/>
                      <a:pt x="21432" y="61912"/>
                    </a:cubicBezTo>
                    <a:cubicBezTo>
                      <a:pt x="23813" y="65881"/>
                      <a:pt x="25644" y="70236"/>
                      <a:pt x="28575" y="73818"/>
                    </a:cubicBezTo>
                    <a:cubicBezTo>
                      <a:pt x="32840" y="79031"/>
                      <a:pt x="39127" y="82502"/>
                      <a:pt x="42863" y="88106"/>
                    </a:cubicBezTo>
                    <a:cubicBezTo>
                      <a:pt x="44450" y="90487"/>
                      <a:pt x="46345" y="92690"/>
                      <a:pt x="47625" y="95250"/>
                    </a:cubicBezTo>
                    <a:cubicBezTo>
                      <a:pt x="48748" y="97495"/>
                      <a:pt x="48615" y="100305"/>
                      <a:pt x="50007" y="102393"/>
                    </a:cubicBezTo>
                    <a:cubicBezTo>
                      <a:pt x="51875" y="105195"/>
                      <a:pt x="54769" y="107156"/>
                      <a:pt x="57150" y="109537"/>
                    </a:cubicBezTo>
                    <a:cubicBezTo>
                      <a:pt x="57944" y="111918"/>
                      <a:pt x="58409" y="114436"/>
                      <a:pt x="59532" y="116681"/>
                    </a:cubicBezTo>
                    <a:cubicBezTo>
                      <a:pt x="62693" y="123002"/>
                      <a:pt x="68690" y="128954"/>
                      <a:pt x="73819" y="133350"/>
                    </a:cubicBezTo>
                    <a:cubicBezTo>
                      <a:pt x="75992" y="135212"/>
                      <a:pt x="78306" y="137049"/>
                      <a:pt x="80963" y="138112"/>
                    </a:cubicBezTo>
                    <a:cubicBezTo>
                      <a:pt x="86328" y="140258"/>
                      <a:pt x="92076" y="141287"/>
                      <a:pt x="97632" y="142875"/>
                    </a:cubicBezTo>
                    <a:cubicBezTo>
                      <a:pt x="120651" y="142081"/>
                      <a:pt x="143701" y="141930"/>
                      <a:pt x="166688" y="140493"/>
                    </a:cubicBezTo>
                    <a:cubicBezTo>
                      <a:pt x="173529" y="140065"/>
                      <a:pt x="175184" y="136246"/>
                      <a:pt x="180975" y="133350"/>
                    </a:cubicBezTo>
                    <a:cubicBezTo>
                      <a:pt x="183220" y="132227"/>
                      <a:pt x="185834" y="132007"/>
                      <a:pt x="188119" y="130968"/>
                    </a:cubicBezTo>
                    <a:cubicBezTo>
                      <a:pt x="217391" y="117662"/>
                      <a:pt x="197613" y="124628"/>
                      <a:pt x="214313" y="119062"/>
                    </a:cubicBezTo>
                    <a:cubicBezTo>
                      <a:pt x="233492" y="99883"/>
                      <a:pt x="223954" y="105907"/>
                      <a:pt x="240507" y="97631"/>
                    </a:cubicBezTo>
                    <a:cubicBezTo>
                      <a:pt x="245892" y="89553"/>
                      <a:pt x="243245" y="92511"/>
                      <a:pt x="247650" y="88106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67A05817-68A8-4E98-86F8-12E7AAA442A4}"/>
                </a:ext>
              </a:extLst>
            </p:cNvPr>
            <p:cNvSpPr txBox="1"/>
            <p:nvPr/>
          </p:nvSpPr>
          <p:spPr>
            <a:xfrm>
              <a:off x="2909386" y="4146638"/>
              <a:ext cx="3369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i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</a:p>
          </p:txBody>
        </p:sp>
        <p:cxnSp>
          <p:nvCxnSpPr>
            <p:cNvPr id="260" name="Straight Connector 259">
              <a:extLst>
                <a:ext uri="{FF2B5EF4-FFF2-40B4-BE49-F238E27FC236}">
                  <a16:creationId xmlns:a16="http://schemas.microsoft.com/office/drawing/2014/main" id="{41A92141-6231-4BD6-B21D-1FBB48580875}"/>
                </a:ext>
              </a:extLst>
            </p:cNvPr>
            <p:cNvCxnSpPr/>
            <p:nvPr/>
          </p:nvCxnSpPr>
          <p:spPr>
            <a:xfrm flipH="1">
              <a:off x="3068427" y="4089122"/>
              <a:ext cx="18870" cy="10263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Straight Connector 260">
              <a:extLst>
                <a:ext uri="{FF2B5EF4-FFF2-40B4-BE49-F238E27FC236}">
                  <a16:creationId xmlns:a16="http://schemas.microsoft.com/office/drawing/2014/main" id="{CD7EF7D7-5A1E-4923-8DE1-9B01F32FD9D5}"/>
                </a:ext>
              </a:extLst>
            </p:cNvPr>
            <p:cNvCxnSpPr/>
            <p:nvPr/>
          </p:nvCxnSpPr>
          <p:spPr>
            <a:xfrm>
              <a:off x="2994679" y="4098764"/>
              <a:ext cx="52929" cy="92988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Straight Connector 261">
              <a:extLst>
                <a:ext uri="{FF2B5EF4-FFF2-40B4-BE49-F238E27FC236}">
                  <a16:creationId xmlns:a16="http://schemas.microsoft.com/office/drawing/2014/main" id="{6872A5BA-F004-45EF-BD57-BBBBB53302BF}"/>
                </a:ext>
              </a:extLst>
            </p:cNvPr>
            <p:cNvCxnSpPr/>
            <p:nvPr/>
          </p:nvCxnSpPr>
          <p:spPr>
            <a:xfrm>
              <a:off x="2941750" y="4105760"/>
              <a:ext cx="89803" cy="9251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101D4DCC-2B79-4617-A07E-DD2CCA09EB45}"/>
                </a:ext>
              </a:extLst>
            </p:cNvPr>
            <p:cNvSpPr txBox="1"/>
            <p:nvPr/>
          </p:nvSpPr>
          <p:spPr>
            <a:xfrm>
              <a:off x="2601412" y="4694382"/>
              <a:ext cx="7072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EG Coating</a:t>
              </a:r>
            </a:p>
          </p:txBody>
        </p:sp>
      </p:grpSp>
      <p:sp>
        <p:nvSpPr>
          <p:cNvPr id="276" name="TextBox 275">
            <a:extLst>
              <a:ext uri="{FF2B5EF4-FFF2-40B4-BE49-F238E27FC236}">
                <a16:creationId xmlns:a16="http://schemas.microsoft.com/office/drawing/2014/main" id="{9140BC96-04F8-4939-9AD2-92651E947B34}"/>
              </a:ext>
            </a:extLst>
          </p:cNvPr>
          <p:cNvSpPr txBox="1"/>
          <p:nvPr/>
        </p:nvSpPr>
        <p:spPr>
          <a:xfrm>
            <a:off x="1187194" y="6403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8896277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4843463" y="8475136"/>
            <a:ext cx="1543050" cy="486833"/>
          </a:xfrm>
        </p:spPr>
        <p:txBody>
          <a:bodyPr/>
          <a:lstStyle/>
          <a:p>
            <a:r>
              <a:rPr lang="en-US" dirty="0"/>
              <a:t>10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E1CC15B-68AC-6148-B09B-88F65C4448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5966" y="356579"/>
            <a:ext cx="2286000" cy="161077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84CA4822-4C73-954B-BCA0-6114E3CE80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1193" y="356580"/>
            <a:ext cx="2286000" cy="161891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8E267A3A-7E2C-E54A-874F-131F877BABC8}"/>
              </a:ext>
            </a:extLst>
          </p:cNvPr>
          <p:cNvSpPr txBox="1"/>
          <p:nvPr/>
        </p:nvSpPr>
        <p:spPr>
          <a:xfrm>
            <a:off x="2247229" y="1270979"/>
            <a:ext cx="38982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CC                                                            102S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C867C364-59F8-A142-A577-665BFEA055E1}"/>
              </a:ext>
            </a:extLst>
          </p:cNvPr>
          <p:cNvGrpSpPr/>
          <p:nvPr/>
        </p:nvGrpSpPr>
        <p:grpSpPr>
          <a:xfrm>
            <a:off x="812803" y="2312736"/>
            <a:ext cx="4918243" cy="2861121"/>
            <a:chOff x="787403" y="2110205"/>
            <a:chExt cx="4918243" cy="2861121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56BC343-2079-154A-AAFB-249A7DC489D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5424" y="2110206"/>
              <a:ext cx="2286000" cy="1403131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8F9479F4-B5ED-E647-B437-CCE57E73A3A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19646" y="2110205"/>
              <a:ext cx="2286000" cy="1403131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FD92EC22-2A5D-9E4A-AC23-96122E41403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7403" y="3523004"/>
              <a:ext cx="2286000" cy="1448322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7F23065D-8A94-F743-B2F9-4169C184E1C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411625" y="3517515"/>
              <a:ext cx="2286000" cy="1448322"/>
            </a:xfrm>
            <a:prstGeom prst="rect">
              <a:avLst/>
            </a:prstGeom>
          </p:spPr>
        </p:pic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C36EE151-60CC-6C48-8351-7343986BB419}"/>
              </a:ext>
            </a:extLst>
          </p:cNvPr>
          <p:cNvSpPr txBox="1"/>
          <p:nvPr/>
        </p:nvSpPr>
        <p:spPr>
          <a:xfrm>
            <a:off x="2805699" y="2070401"/>
            <a:ext cx="732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CC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F9BA32C3-2A32-BA4B-9F2B-503F23C6A4A0}"/>
              </a:ext>
            </a:extLst>
          </p:cNvPr>
          <p:cNvGrpSpPr/>
          <p:nvPr/>
        </p:nvGrpSpPr>
        <p:grpSpPr>
          <a:xfrm>
            <a:off x="736266" y="5467293"/>
            <a:ext cx="4964699" cy="2834141"/>
            <a:chOff x="710866" y="5352993"/>
            <a:chExt cx="4964699" cy="2834141"/>
          </a:xfrm>
        </p:grpSpPr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1F574105-59CB-4A41-B055-F98855662C7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10866" y="6795780"/>
              <a:ext cx="2286000" cy="1391151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666454FE-7E7C-F341-BD25-87E28500EC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389565" y="6758384"/>
              <a:ext cx="2286000" cy="1428750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C6985141-0CF3-0347-A8DF-33DF105530C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42950" y="5358520"/>
              <a:ext cx="2286000" cy="1365463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9F63A157-8571-4747-A429-0F323A1D6F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374106" y="5352993"/>
              <a:ext cx="2286000" cy="1365463"/>
            </a:xfrm>
            <a:prstGeom prst="rect">
              <a:avLst/>
            </a:prstGeom>
          </p:spPr>
        </p:pic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75A4886B-338F-1344-9583-1D53A04188FC}"/>
              </a:ext>
            </a:extLst>
          </p:cNvPr>
          <p:cNvSpPr txBox="1"/>
          <p:nvPr/>
        </p:nvSpPr>
        <p:spPr>
          <a:xfrm>
            <a:off x="2805700" y="5294869"/>
            <a:ext cx="732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102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AF7ADCF-2B58-D942-AC14-F9213B621A9F}"/>
              </a:ext>
            </a:extLst>
          </p:cNvPr>
          <p:cNvSpPr txBox="1"/>
          <p:nvPr/>
        </p:nvSpPr>
        <p:spPr>
          <a:xfrm>
            <a:off x="1170407" y="284782"/>
            <a:ext cx="43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1058EA0-9673-4E4D-AEDF-EC81052EBDF2}"/>
              </a:ext>
            </a:extLst>
          </p:cNvPr>
          <p:cNvSpPr txBox="1"/>
          <p:nvPr/>
        </p:nvSpPr>
        <p:spPr>
          <a:xfrm>
            <a:off x="3777250" y="284783"/>
            <a:ext cx="43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b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9C30459-5B06-494C-81ED-8456C5C15AB8}"/>
              </a:ext>
            </a:extLst>
          </p:cNvPr>
          <p:cNvSpPr txBox="1"/>
          <p:nvPr/>
        </p:nvSpPr>
        <p:spPr>
          <a:xfrm>
            <a:off x="1176722" y="2065449"/>
            <a:ext cx="43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3E55996-90C1-E34E-BB0A-6A4421EC2B19}"/>
              </a:ext>
            </a:extLst>
          </p:cNvPr>
          <p:cNvSpPr txBox="1"/>
          <p:nvPr/>
        </p:nvSpPr>
        <p:spPr>
          <a:xfrm>
            <a:off x="1176723" y="5225747"/>
            <a:ext cx="43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2518625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76275" y="657344"/>
            <a:ext cx="5495926" cy="227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Single-molecule tracking of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pMHCs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on lipid bilayer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a-b</a:t>
            </a:r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presentative diffusion trajectories of single MCC (a) and 102S (b) pMHCs at free (red) and bound (black) conditions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-d) Horizontal position 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nd vertical positio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single tracked MCC (c) and 102S (d) pMHCs were plotted versus time 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for representative single free (red) and bound (black) pMHCs. Corresponding sliding standard deviations σ of 3 consecutive points of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ons were calculated to reveal the position change of single tracked pMHCs, respectively. 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41076777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Slide Number Placeholder 1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2</a:t>
            </a: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052C56C7-68FC-45EB-AC4B-AF87A4A9EB92}"/>
              </a:ext>
            </a:extLst>
          </p:cNvPr>
          <p:cNvSpPr/>
          <p:nvPr/>
        </p:nvSpPr>
        <p:spPr>
          <a:xfrm>
            <a:off x="341832" y="4673408"/>
            <a:ext cx="6129864" cy="17211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9.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Transmembrane FRET2 measurements for MCC, 102S and Null pMHCs on lipid bilayer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(a-c) Representative transmembrane FRET measurements between CD3ζ-GFP and TCR-Alexa568 for MCC (a), 102S (b) and Null </a:t>
            </a:r>
            <a:r>
              <a:rPr lang="de-DE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. Scale bar: 5 µm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(d) Line scanning of CD3ζ, TCR and composite channels for K5 pMHC after forming a stable immunological synapse. Scale bar: 5 µm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31442" y="228739"/>
            <a:ext cx="6562128" cy="4364572"/>
            <a:chOff x="231442" y="228739"/>
            <a:chExt cx="6562128" cy="4364572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25716" y="2513558"/>
              <a:ext cx="724809" cy="822960"/>
            </a:xfrm>
            <a:prstGeom prst="rect">
              <a:avLst/>
            </a:prstGeom>
          </p:spPr>
        </p:pic>
        <p:sp>
          <p:nvSpPr>
            <p:cNvPr id="123" name="TextBox 122"/>
            <p:cNvSpPr txBox="1"/>
            <p:nvPr/>
          </p:nvSpPr>
          <p:spPr>
            <a:xfrm>
              <a:off x="1383880" y="2302105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931351" y="2323046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322497" y="2339575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</a:p>
          </p:txBody>
        </p:sp>
        <p:cxnSp>
          <p:nvCxnSpPr>
            <p:cNvPr id="202" name="Straight Connector 201"/>
            <p:cNvCxnSpPr/>
            <p:nvPr/>
          </p:nvCxnSpPr>
          <p:spPr>
            <a:xfrm>
              <a:off x="4538663" y="2587486"/>
              <a:ext cx="441296" cy="716130"/>
            </a:xfrm>
            <a:prstGeom prst="line">
              <a:avLst/>
            </a:prstGeom>
            <a:ln w="1270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/>
            <p:cNvSpPr txBox="1"/>
            <p:nvPr/>
          </p:nvSpPr>
          <p:spPr>
            <a:xfrm>
              <a:off x="1731899" y="4393256"/>
              <a:ext cx="8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osition (µm)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309669" y="3296767"/>
              <a:ext cx="292388" cy="837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ignal 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1387" y="3605826"/>
              <a:ext cx="990113" cy="838200"/>
            </a:xfrm>
            <a:prstGeom prst="rect">
              <a:avLst/>
            </a:prstGeom>
          </p:spPr>
        </p:pic>
        <p:sp>
          <p:nvSpPr>
            <p:cNvPr id="177" name="TextBox 176"/>
            <p:cNvSpPr txBox="1"/>
            <p:nvPr/>
          </p:nvSpPr>
          <p:spPr>
            <a:xfrm>
              <a:off x="3143696" y="4375944"/>
              <a:ext cx="8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osition (µm)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2745063" y="3603460"/>
              <a:ext cx="292388" cy="55189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ignal 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5538" y="3682026"/>
              <a:ext cx="875869" cy="7620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51712" y="3605826"/>
              <a:ext cx="990113" cy="838200"/>
            </a:xfrm>
            <a:prstGeom prst="rect">
              <a:avLst/>
            </a:prstGeom>
          </p:spPr>
        </p:pic>
        <p:sp>
          <p:nvSpPr>
            <p:cNvPr id="200" name="TextBox 199"/>
            <p:cNvSpPr txBox="1"/>
            <p:nvPr/>
          </p:nvSpPr>
          <p:spPr>
            <a:xfrm>
              <a:off x="4396057" y="4367633"/>
              <a:ext cx="8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osition (µm)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4011228" y="3283178"/>
              <a:ext cx="292388" cy="837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ignal 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429446" y="2323046"/>
              <a:ext cx="7360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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+TCR</a:t>
              </a:r>
            </a:p>
          </p:txBody>
        </p:sp>
        <p:cxnSp>
          <p:nvCxnSpPr>
            <p:cNvPr id="145" name="Straight Connector 144"/>
            <p:cNvCxnSpPr/>
            <p:nvPr/>
          </p:nvCxnSpPr>
          <p:spPr>
            <a:xfrm>
              <a:off x="4462885" y="3276915"/>
              <a:ext cx="187742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6" name="Group 175"/>
            <p:cNvGrpSpPr/>
            <p:nvPr/>
          </p:nvGrpSpPr>
          <p:grpSpPr>
            <a:xfrm>
              <a:off x="6274614" y="874093"/>
              <a:ext cx="518956" cy="1084435"/>
              <a:chOff x="318234" y="5792851"/>
              <a:chExt cx="606621" cy="1267627"/>
            </a:xfrm>
          </p:grpSpPr>
          <p:sp>
            <p:nvSpPr>
              <p:cNvPr id="151" name="TextBox 150"/>
              <p:cNvSpPr txBox="1"/>
              <p:nvPr/>
            </p:nvSpPr>
            <p:spPr>
              <a:xfrm>
                <a:off x="324793" y="5792851"/>
                <a:ext cx="419177" cy="2518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 m</a:t>
                </a: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318234" y="6808639"/>
                <a:ext cx="606621" cy="2518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 m</a:t>
                </a:r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>
              <a:off x="3202796" y="251649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2S</a:t>
              </a: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8761" y="683574"/>
              <a:ext cx="438065" cy="43806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7592" y="683574"/>
              <a:ext cx="438065" cy="438065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8781" y="1149750"/>
              <a:ext cx="438065" cy="438065"/>
            </a:xfrm>
            <a:prstGeom prst="rect">
              <a:avLst/>
            </a:prstGeom>
          </p:spPr>
        </p:pic>
        <p:pic>
          <p:nvPicPr>
            <p:cNvPr id="88" name="Picture 8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1667" y="1149751"/>
              <a:ext cx="438065" cy="438065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10427" y="1614915"/>
              <a:ext cx="438065" cy="438065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1667" y="1613732"/>
              <a:ext cx="438065" cy="438065"/>
            </a:xfrm>
            <a:prstGeom prst="rect">
              <a:avLst/>
            </a:prstGeom>
          </p:spPr>
        </p:pic>
        <p:grpSp>
          <p:nvGrpSpPr>
            <p:cNvPr id="140" name="Group 139"/>
            <p:cNvGrpSpPr/>
            <p:nvPr/>
          </p:nvGrpSpPr>
          <p:grpSpPr>
            <a:xfrm>
              <a:off x="2728363" y="489743"/>
              <a:ext cx="1422676" cy="215444"/>
              <a:chOff x="819667" y="1657114"/>
              <a:chExt cx="1662999" cy="251837"/>
            </a:xfrm>
          </p:grpSpPr>
          <p:sp>
            <p:nvSpPr>
              <p:cNvPr id="142" name="TextBox 141"/>
              <p:cNvSpPr txBox="1"/>
              <p:nvPr/>
            </p:nvSpPr>
            <p:spPr>
              <a:xfrm>
                <a:off x="819667" y="1657114"/>
                <a:ext cx="508171" cy="2518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1401654" y="1657114"/>
                <a:ext cx="461327" cy="2518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1953882" y="1657114"/>
                <a:ext cx="528784" cy="2518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RET</a:t>
                </a:r>
              </a:p>
            </p:txBody>
          </p:sp>
        </p:grpSp>
        <p:grpSp>
          <p:nvGrpSpPr>
            <p:cNvPr id="164" name="Group 163"/>
            <p:cNvGrpSpPr/>
            <p:nvPr/>
          </p:nvGrpSpPr>
          <p:grpSpPr>
            <a:xfrm>
              <a:off x="4067904" y="851581"/>
              <a:ext cx="421886" cy="1125547"/>
              <a:chOff x="2913947" y="2051650"/>
              <a:chExt cx="493154" cy="1315679"/>
            </a:xfrm>
          </p:grpSpPr>
          <p:sp>
            <p:nvSpPr>
              <p:cNvPr id="165" name="TextBox 164"/>
              <p:cNvSpPr txBox="1"/>
              <p:nvPr/>
            </p:nvSpPr>
            <p:spPr>
              <a:xfrm>
                <a:off x="2927073" y="2051650"/>
                <a:ext cx="416358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 m</a:t>
                </a: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2913947" y="2566349"/>
                <a:ext cx="483814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6 m</a:t>
                </a:r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2923287" y="3115491"/>
                <a:ext cx="483814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 m</a:t>
                </a:r>
              </a:p>
            </p:txBody>
          </p:sp>
        </p:grpSp>
        <p:sp>
          <p:nvSpPr>
            <p:cNvPr id="128" name="TextBox 127"/>
            <p:cNvSpPr txBox="1"/>
            <p:nvPr/>
          </p:nvSpPr>
          <p:spPr>
            <a:xfrm>
              <a:off x="2448761" y="623752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37" name="Straight Connector 36"/>
            <p:cNvCxnSpPr/>
            <p:nvPr/>
          </p:nvCxnSpPr>
          <p:spPr>
            <a:xfrm>
              <a:off x="6471696" y="613494"/>
              <a:ext cx="26535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8" name="Picture 97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1177" y="710075"/>
              <a:ext cx="438065" cy="438065"/>
            </a:xfrm>
            <a:prstGeom prst="rect">
              <a:avLst/>
            </a:prstGeom>
          </p:spPr>
        </p:pic>
        <p:pic>
          <p:nvPicPr>
            <p:cNvPr id="99" name="Picture 98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3132" y="710075"/>
              <a:ext cx="438065" cy="438065"/>
            </a:xfrm>
            <a:prstGeom prst="rect">
              <a:avLst/>
            </a:prstGeom>
          </p:spPr>
        </p:pic>
        <p:pic>
          <p:nvPicPr>
            <p:cNvPr id="103" name="Picture 102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1177" y="1614646"/>
              <a:ext cx="438065" cy="438065"/>
            </a:xfrm>
            <a:prstGeom prst="rect">
              <a:avLst/>
            </a:prstGeom>
          </p:spPr>
        </p:pic>
        <p:pic>
          <p:nvPicPr>
            <p:cNvPr id="104" name="Picture 103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3132" y="1614646"/>
              <a:ext cx="438065" cy="438065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4885675" y="517833"/>
              <a:ext cx="1422676" cy="215444"/>
              <a:chOff x="1298686" y="3284640"/>
              <a:chExt cx="1422676" cy="215444"/>
            </a:xfrm>
          </p:grpSpPr>
          <p:sp>
            <p:nvSpPr>
              <p:cNvPr id="154" name="TextBox 153"/>
              <p:cNvSpPr txBox="1"/>
              <p:nvPr/>
            </p:nvSpPr>
            <p:spPr>
              <a:xfrm>
                <a:off x="1298686" y="3284640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1796569" y="3284640"/>
                <a:ext cx="3946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2268994" y="3284640"/>
                <a:ext cx="4523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RET</a:t>
                </a:r>
              </a:p>
            </p:txBody>
          </p:sp>
        </p:grpSp>
        <p:cxnSp>
          <p:nvCxnSpPr>
            <p:cNvPr id="179" name="Straight Connector 178"/>
            <p:cNvCxnSpPr/>
            <p:nvPr/>
          </p:nvCxnSpPr>
          <p:spPr>
            <a:xfrm>
              <a:off x="6035643" y="1592653"/>
              <a:ext cx="187742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/>
            <p:cNvSpPr txBox="1"/>
            <p:nvPr/>
          </p:nvSpPr>
          <p:spPr>
            <a:xfrm>
              <a:off x="4622033" y="625193"/>
              <a:ext cx="243259" cy="283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62" name="Group 161"/>
            <p:cNvGrpSpPr/>
            <p:nvPr/>
          </p:nvGrpSpPr>
          <p:grpSpPr>
            <a:xfrm>
              <a:off x="1841391" y="874491"/>
              <a:ext cx="442750" cy="1125547"/>
              <a:chOff x="2913947" y="2051650"/>
              <a:chExt cx="517542" cy="1315679"/>
            </a:xfrm>
          </p:grpSpPr>
          <p:sp>
            <p:nvSpPr>
              <p:cNvPr id="159" name="TextBox 158"/>
              <p:cNvSpPr txBox="1"/>
              <p:nvPr/>
            </p:nvSpPr>
            <p:spPr>
              <a:xfrm>
                <a:off x="2927073" y="2051650"/>
                <a:ext cx="416357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 m</a:t>
                </a: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2913947" y="2566349"/>
                <a:ext cx="517542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 m</a:t>
                </a: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2923287" y="3115491"/>
                <a:ext cx="483814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 m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987181" y="228739"/>
              <a:ext cx="4849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CC</a:t>
              </a:r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8391" y="700492"/>
              <a:ext cx="438065" cy="438064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225" y="700492"/>
              <a:ext cx="438065" cy="438064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8391" y="1157646"/>
              <a:ext cx="438065" cy="438064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225" y="1157646"/>
              <a:ext cx="438065" cy="438064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8391" y="1608515"/>
              <a:ext cx="438065" cy="438064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225" y="1610786"/>
              <a:ext cx="438065" cy="438064"/>
            </a:xfrm>
            <a:prstGeom prst="rect">
              <a:avLst/>
            </a:prstGeom>
          </p:spPr>
        </p:pic>
        <p:grpSp>
          <p:nvGrpSpPr>
            <p:cNvPr id="133" name="Group 132"/>
            <p:cNvGrpSpPr/>
            <p:nvPr/>
          </p:nvGrpSpPr>
          <p:grpSpPr>
            <a:xfrm>
              <a:off x="489298" y="510743"/>
              <a:ext cx="1422676" cy="215444"/>
              <a:chOff x="819667" y="1601444"/>
              <a:chExt cx="1662999" cy="251838"/>
            </a:xfrm>
          </p:grpSpPr>
          <p:sp>
            <p:nvSpPr>
              <p:cNvPr id="124" name="TextBox 123"/>
              <p:cNvSpPr txBox="1"/>
              <p:nvPr/>
            </p:nvSpPr>
            <p:spPr>
              <a:xfrm>
                <a:off x="819667" y="1601444"/>
                <a:ext cx="508171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1401654" y="1601444"/>
                <a:ext cx="461327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1953883" y="1601444"/>
                <a:ext cx="528783" cy="251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RET</a:t>
                </a:r>
              </a:p>
            </p:txBody>
          </p:sp>
        </p:grpSp>
        <p:sp>
          <p:nvSpPr>
            <p:cNvPr id="127" name="TextBox 126"/>
            <p:cNvSpPr txBox="1"/>
            <p:nvPr/>
          </p:nvSpPr>
          <p:spPr>
            <a:xfrm>
              <a:off x="231442" y="62266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5224" y="2513558"/>
              <a:ext cx="742561" cy="834424"/>
            </a:xfrm>
            <a:prstGeom prst="rect">
              <a:avLst/>
            </a:prstGeom>
          </p:spPr>
        </p:pic>
        <p:cxnSp>
          <p:nvCxnSpPr>
            <p:cNvPr id="147" name="Straight Connector 146"/>
            <p:cNvCxnSpPr/>
            <p:nvPr/>
          </p:nvCxnSpPr>
          <p:spPr>
            <a:xfrm>
              <a:off x="1873616" y="2549490"/>
              <a:ext cx="441296" cy="716130"/>
            </a:xfrm>
            <a:prstGeom prst="line">
              <a:avLst/>
            </a:prstGeom>
            <a:ln w="1270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1204" y="2513558"/>
              <a:ext cx="725678" cy="823947"/>
            </a:xfrm>
            <a:prstGeom prst="rect">
              <a:avLst/>
            </a:prstGeom>
          </p:spPr>
        </p:pic>
        <p:cxnSp>
          <p:nvCxnSpPr>
            <p:cNvPr id="199" name="Straight Connector 198"/>
            <p:cNvCxnSpPr/>
            <p:nvPr/>
          </p:nvCxnSpPr>
          <p:spPr>
            <a:xfrm>
              <a:off x="3190519" y="2542239"/>
              <a:ext cx="441296" cy="716130"/>
            </a:xfrm>
            <a:prstGeom prst="line">
              <a:avLst/>
            </a:prstGeom>
            <a:ln w="1270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25404677-694C-4507-BE29-6CE15E4A6E68}"/>
                </a:ext>
              </a:extLst>
            </p:cNvPr>
            <p:cNvSpPr txBox="1"/>
            <p:nvPr/>
          </p:nvSpPr>
          <p:spPr>
            <a:xfrm>
              <a:off x="5383007" y="241492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</a:p>
          </p:txBody>
        </p:sp>
        <p:grpSp>
          <p:nvGrpSpPr>
            <p:cNvPr id="84" name="Group 83"/>
            <p:cNvGrpSpPr/>
            <p:nvPr/>
          </p:nvGrpSpPr>
          <p:grpSpPr>
            <a:xfrm rot="5400000">
              <a:off x="1578282" y="1790240"/>
              <a:ext cx="223779" cy="681084"/>
              <a:chOff x="6470961" y="1369398"/>
              <a:chExt cx="223779" cy="681084"/>
            </a:xfrm>
          </p:grpSpPr>
          <p:pic>
            <p:nvPicPr>
              <p:cNvPr id="86" name="Picture 85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6557995" y="1543577"/>
                <a:ext cx="50195" cy="339994"/>
              </a:xfrm>
              <a:prstGeom prst="rect">
                <a:avLst/>
              </a:prstGeom>
            </p:spPr>
          </p:pic>
          <p:sp>
            <p:nvSpPr>
              <p:cNvPr id="89" name="TextBox 88"/>
              <p:cNvSpPr txBox="1"/>
              <p:nvPr/>
            </p:nvSpPr>
            <p:spPr>
              <a:xfrm rot="16200000">
                <a:off x="6448248" y="1815000"/>
                <a:ext cx="261610" cy="209353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6200000">
                <a:off x="6452046" y="1388313"/>
                <a:ext cx="261610" cy="223779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grpSp>
          <p:nvGrpSpPr>
            <p:cNvPr id="94" name="Group 93"/>
            <p:cNvGrpSpPr/>
            <p:nvPr/>
          </p:nvGrpSpPr>
          <p:grpSpPr>
            <a:xfrm rot="5400000">
              <a:off x="3826725" y="1808847"/>
              <a:ext cx="223779" cy="681084"/>
              <a:chOff x="6470961" y="1369398"/>
              <a:chExt cx="223779" cy="681084"/>
            </a:xfrm>
          </p:grpSpPr>
          <p:pic>
            <p:nvPicPr>
              <p:cNvPr id="96" name="Picture 95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6557995" y="1543577"/>
                <a:ext cx="50195" cy="339994"/>
              </a:xfrm>
              <a:prstGeom prst="rect">
                <a:avLst/>
              </a:prstGeom>
            </p:spPr>
          </p:pic>
          <p:sp>
            <p:nvSpPr>
              <p:cNvPr id="97" name="TextBox 96"/>
              <p:cNvSpPr txBox="1"/>
              <p:nvPr/>
            </p:nvSpPr>
            <p:spPr>
              <a:xfrm rot="16200000">
                <a:off x="6448248" y="1815000"/>
                <a:ext cx="261610" cy="209353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 rot="16200000">
                <a:off x="6452046" y="1388313"/>
                <a:ext cx="261610" cy="223779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grpSp>
          <p:nvGrpSpPr>
            <p:cNvPr id="102" name="Group 101"/>
            <p:cNvGrpSpPr/>
            <p:nvPr/>
          </p:nvGrpSpPr>
          <p:grpSpPr>
            <a:xfrm rot="5400000">
              <a:off x="6075168" y="1827454"/>
              <a:ext cx="223779" cy="681084"/>
              <a:chOff x="6470961" y="1369398"/>
              <a:chExt cx="223779" cy="681084"/>
            </a:xfrm>
          </p:grpSpPr>
          <p:pic>
            <p:nvPicPr>
              <p:cNvPr id="105" name="Picture 104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6557995" y="1543577"/>
                <a:ext cx="50195" cy="339994"/>
              </a:xfrm>
              <a:prstGeom prst="rect">
                <a:avLst/>
              </a:prstGeom>
            </p:spPr>
          </p:pic>
          <p:sp>
            <p:nvSpPr>
              <p:cNvPr id="107" name="TextBox 106"/>
              <p:cNvSpPr txBox="1"/>
              <p:nvPr/>
            </p:nvSpPr>
            <p:spPr>
              <a:xfrm rot="16200000">
                <a:off x="6448248" y="1815000"/>
                <a:ext cx="261610" cy="209353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 rot="16200000">
                <a:off x="6452046" y="1388313"/>
                <a:ext cx="261610" cy="223779"/>
              </a:xfrm>
              <a:prstGeom prst="rect">
                <a:avLst/>
              </a:prstGeom>
              <a:noFill/>
            </p:spPr>
            <p:txBody>
              <a:bodyPr vert="vert" wrap="none" rtlCol="0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2007" y="699835"/>
              <a:ext cx="438912" cy="43891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2007" y="1161790"/>
              <a:ext cx="438912" cy="43891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2007" y="1608515"/>
              <a:ext cx="438912" cy="438912"/>
            </a:xfrm>
            <a:prstGeom prst="rect">
              <a:avLst/>
            </a:prstGeom>
          </p:spPr>
        </p:pic>
        <p:cxnSp>
          <p:nvCxnSpPr>
            <p:cNvPr id="190" name="Straight Connector 189"/>
            <p:cNvCxnSpPr>
              <a:cxnSpLocks/>
            </p:cNvCxnSpPr>
            <p:nvPr/>
          </p:nvCxnSpPr>
          <p:spPr>
            <a:xfrm>
              <a:off x="1769104" y="2003350"/>
              <a:ext cx="10058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3257" y="683574"/>
              <a:ext cx="438912" cy="43891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3257" y="1150543"/>
              <a:ext cx="438912" cy="43891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3257" y="1614882"/>
              <a:ext cx="438912" cy="438912"/>
            </a:xfrm>
            <a:prstGeom prst="rect">
              <a:avLst/>
            </a:prstGeom>
          </p:spPr>
        </p:pic>
        <p:cxnSp>
          <p:nvCxnSpPr>
            <p:cNvPr id="109" name="Straight Connector 108"/>
            <p:cNvCxnSpPr>
              <a:cxnSpLocks/>
            </p:cNvCxnSpPr>
            <p:nvPr/>
          </p:nvCxnSpPr>
          <p:spPr>
            <a:xfrm>
              <a:off x="4000270" y="2018893"/>
              <a:ext cx="10058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16" y="710075"/>
              <a:ext cx="438912" cy="43891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16" y="1161790"/>
              <a:ext cx="438912" cy="43891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9616" y="1614646"/>
              <a:ext cx="438912" cy="43891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1177" y="1161790"/>
              <a:ext cx="438912" cy="43891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3132" y="1161790"/>
              <a:ext cx="438912" cy="438912"/>
            </a:xfrm>
            <a:prstGeom prst="rect">
              <a:avLst/>
            </a:prstGeom>
          </p:spPr>
        </p:pic>
        <p:grpSp>
          <p:nvGrpSpPr>
            <p:cNvPr id="101" name="Group 100"/>
            <p:cNvGrpSpPr/>
            <p:nvPr/>
          </p:nvGrpSpPr>
          <p:grpSpPr>
            <a:xfrm>
              <a:off x="3871982" y="2479794"/>
              <a:ext cx="390260" cy="928562"/>
              <a:chOff x="6016419" y="1357480"/>
              <a:chExt cx="390260" cy="928562"/>
            </a:xfrm>
          </p:grpSpPr>
          <p:pic>
            <p:nvPicPr>
              <p:cNvPr id="106" name="Picture 105"/>
              <p:cNvPicPr>
                <a:picLocks noChangeAspect="1"/>
              </p:cNvPicPr>
              <p:nvPr/>
            </p:nvPicPr>
            <p:blipFill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16419" y="1420446"/>
                <a:ext cx="110579" cy="823071"/>
              </a:xfrm>
              <a:prstGeom prst="rect">
                <a:avLst/>
              </a:prstGeom>
            </p:spPr>
          </p:pic>
          <p:sp>
            <p:nvSpPr>
              <p:cNvPr id="110" name="TextBox 109"/>
              <p:cNvSpPr txBox="1"/>
              <p:nvPr/>
            </p:nvSpPr>
            <p:spPr>
              <a:xfrm>
                <a:off x="6043507" y="2085987"/>
                <a:ext cx="34817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6039271" y="1357480"/>
                <a:ext cx="3674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grpSp>
          <p:nvGrpSpPr>
            <p:cNvPr id="112" name="Group 111"/>
            <p:cNvGrpSpPr/>
            <p:nvPr/>
          </p:nvGrpSpPr>
          <p:grpSpPr>
            <a:xfrm>
              <a:off x="2576612" y="2461942"/>
              <a:ext cx="387114" cy="928562"/>
              <a:chOff x="6007421" y="503776"/>
              <a:chExt cx="387114" cy="928562"/>
            </a:xfrm>
          </p:grpSpPr>
          <p:pic>
            <p:nvPicPr>
              <p:cNvPr id="113" name="Picture 112"/>
              <p:cNvPicPr>
                <a:picLocks noChangeAspect="1"/>
              </p:cNvPicPr>
              <p:nvPr/>
            </p:nvPicPr>
            <p:blipFill>
              <a:blip r:embed="rId3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07421" y="573467"/>
                <a:ext cx="111369" cy="837587"/>
              </a:xfrm>
              <a:prstGeom prst="rect">
                <a:avLst/>
              </a:prstGeom>
            </p:spPr>
          </p:pic>
          <p:sp>
            <p:nvSpPr>
              <p:cNvPr id="114" name="TextBox 113"/>
              <p:cNvSpPr txBox="1"/>
              <p:nvPr/>
            </p:nvSpPr>
            <p:spPr>
              <a:xfrm>
                <a:off x="6031363" y="1232283"/>
                <a:ext cx="34817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6027127" y="503776"/>
                <a:ext cx="3674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670426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3</a:t>
            </a: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327862B0-50B9-4A40-8A63-51063967048C}"/>
              </a:ext>
            </a:extLst>
          </p:cNvPr>
          <p:cNvSpPr/>
          <p:nvPr/>
        </p:nvSpPr>
        <p:spPr>
          <a:xfrm>
            <a:off x="316296" y="5527690"/>
            <a:ext cx="6155506" cy="17211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. </a:t>
            </a:r>
            <a:r>
              <a:rPr lang="en-US" sz="1200" b="1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Colocalization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and tracking of TCR and CD3ζ on lipid bilayer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Time series of line scanning intensity profile for TCR and CD3ζ. The colocalization between TCR and CD3ζ was quantified by Pearson correlation coefficient (PCC). The average PCC values were 0.93±0.07. Scale bar: 5 µm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b) Real-time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racking of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3ζ (green) and TCR (red) microclusters during transmembrane FRET experiments. Also see Supplementary Movie 4-5. </a:t>
            </a:r>
            <a:endParaRPr lang="en-US" sz="1200" dirty="0"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341905" y="298831"/>
            <a:ext cx="6023446" cy="4762713"/>
            <a:chOff x="341905" y="298831"/>
            <a:chExt cx="6023446" cy="4762713"/>
          </a:xfrm>
        </p:grpSpPr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FBC6929A-979D-4287-8C3E-633101FB6879}"/>
                </a:ext>
              </a:extLst>
            </p:cNvPr>
            <p:cNvGrpSpPr/>
            <p:nvPr/>
          </p:nvGrpSpPr>
          <p:grpSpPr>
            <a:xfrm>
              <a:off x="1039507" y="3307488"/>
              <a:ext cx="4891096" cy="1754056"/>
              <a:chOff x="1160005" y="467253"/>
              <a:chExt cx="4891096" cy="1754056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A6ECCFA2-3D0A-4DEA-ADEC-DB9456A45037}"/>
                  </a:ext>
                </a:extLst>
              </p:cNvPr>
              <p:cNvSpPr txBox="1"/>
              <p:nvPr/>
            </p:nvSpPr>
            <p:spPr>
              <a:xfrm>
                <a:off x="4687590" y="1986772"/>
                <a:ext cx="86938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-position (µm)</a:t>
                </a:r>
              </a:p>
            </p:txBody>
          </p:sp>
          <p:sp>
            <p:nvSpPr>
              <p:cNvPr id="63" name="Text Box 207">
                <a:extLst>
                  <a:ext uri="{FF2B5EF4-FFF2-40B4-BE49-F238E27FC236}">
                    <a16:creationId xmlns:a16="http://schemas.microsoft.com/office/drawing/2014/main" id="{0569FBA8-A75B-45D1-AB64-B58D2BD611D2}"/>
                  </a:ext>
                </a:extLst>
              </p:cNvPr>
              <p:cNvSpPr txBox="1"/>
              <p:nvPr/>
            </p:nvSpPr>
            <p:spPr>
              <a:xfrm>
                <a:off x="1160005" y="467253"/>
                <a:ext cx="333003" cy="21729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78226" tIns="39113" rIns="78226" bIns="39113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684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6E620DCA-8152-4EFE-9723-A209FBB07106}"/>
                  </a:ext>
                </a:extLst>
              </p:cNvPr>
              <p:cNvGrpSpPr/>
              <p:nvPr/>
            </p:nvGrpSpPr>
            <p:grpSpPr>
              <a:xfrm>
                <a:off x="1450758" y="499408"/>
                <a:ext cx="2035295" cy="1721901"/>
                <a:chOff x="1450758" y="499408"/>
                <a:chExt cx="2035295" cy="1721901"/>
              </a:xfrm>
            </p:grpSpPr>
            <p:pic>
              <p:nvPicPr>
                <p:cNvPr id="75" name="Picture 74">
                  <a:extLst>
                    <a:ext uri="{FF2B5EF4-FFF2-40B4-BE49-F238E27FC236}">
                      <a16:creationId xmlns:a16="http://schemas.microsoft.com/office/drawing/2014/main" id="{A09691F7-6439-4C70-95B5-77141C9296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 flipH="1" flipV="1">
                  <a:off x="1583411" y="635194"/>
                  <a:ext cx="1879600" cy="1498600"/>
                </a:xfrm>
                <a:prstGeom prst="rect">
                  <a:avLst/>
                </a:prstGeom>
              </p:spPr>
            </p:pic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BB2F565D-DE6A-4190-A527-079326C842C2}"/>
                    </a:ext>
                  </a:extLst>
                </p:cNvPr>
                <p:cNvSpPr txBox="1"/>
                <p:nvPr/>
              </p:nvSpPr>
              <p:spPr>
                <a:xfrm>
                  <a:off x="2639987" y="707445"/>
                  <a:ext cx="84606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  <a:r>
                    <a:rPr lang="el-GR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ζ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rack path</a:t>
                  </a:r>
                </a:p>
              </p:txBody>
            </p:sp>
            <p:cxnSp>
              <p:nvCxnSpPr>
                <p:cNvPr id="84" name="Straight Arrow Connector 83">
                  <a:extLst>
                    <a:ext uri="{FF2B5EF4-FFF2-40B4-BE49-F238E27FC236}">
                      <a16:creationId xmlns:a16="http://schemas.microsoft.com/office/drawing/2014/main" id="{A581C37C-A7CD-40D7-8AF0-90303D865BA7}"/>
                    </a:ext>
                  </a:extLst>
                </p:cNvPr>
                <p:cNvCxnSpPr/>
                <p:nvPr/>
              </p:nvCxnSpPr>
              <p:spPr>
                <a:xfrm flipH="1">
                  <a:off x="2577578" y="851316"/>
                  <a:ext cx="136852" cy="611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Arrow Connector 84">
                  <a:extLst>
                    <a:ext uri="{FF2B5EF4-FFF2-40B4-BE49-F238E27FC236}">
                      <a16:creationId xmlns:a16="http://schemas.microsoft.com/office/drawing/2014/main" id="{6D00DEC9-2F89-46B6-9853-F0B8869AC9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890752" y="862105"/>
                  <a:ext cx="81478" cy="196317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Arrow Connector 85">
                  <a:extLst>
                    <a:ext uri="{FF2B5EF4-FFF2-40B4-BE49-F238E27FC236}">
                      <a16:creationId xmlns:a16="http://schemas.microsoft.com/office/drawing/2014/main" id="{A9B7080F-0D21-4C2C-BF4B-07EC8F1D01FB}"/>
                    </a:ext>
                  </a:extLst>
                </p:cNvPr>
                <p:cNvCxnSpPr/>
                <p:nvPr/>
              </p:nvCxnSpPr>
              <p:spPr>
                <a:xfrm>
                  <a:off x="3020792" y="928050"/>
                  <a:ext cx="67992" cy="25452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005B50B0-F025-40BA-B256-53DA1AE1F843}"/>
                    </a:ext>
                  </a:extLst>
                </p:cNvPr>
                <p:cNvSpPr txBox="1"/>
                <p:nvPr/>
              </p:nvSpPr>
              <p:spPr>
                <a:xfrm>
                  <a:off x="2206236" y="2021254"/>
                  <a:ext cx="86938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x-position (µm)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2F1B60CA-33BE-4EE2-8486-E1F8F474783E}"/>
                    </a:ext>
                  </a:extLst>
                </p:cNvPr>
                <p:cNvSpPr txBox="1"/>
                <p:nvPr/>
              </p:nvSpPr>
              <p:spPr>
                <a:xfrm>
                  <a:off x="1450758" y="850504"/>
                  <a:ext cx="292388" cy="803402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-position (µm)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DA97B434-B0D4-4658-9ED1-7747D163F1AD}"/>
                    </a:ext>
                  </a:extLst>
                </p:cNvPr>
                <p:cNvSpPr txBox="1"/>
                <p:nvPr/>
              </p:nvSpPr>
              <p:spPr>
                <a:xfrm>
                  <a:off x="1901232" y="499408"/>
                  <a:ext cx="12615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  <a:r>
                    <a:rPr lang="el-GR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ζ</a:t>
                  </a:r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3502CB06-0F60-4C0B-9526-E2216C11E34D}"/>
                  </a:ext>
                </a:extLst>
              </p:cNvPr>
              <p:cNvGrpSpPr/>
              <p:nvPr/>
            </p:nvGrpSpPr>
            <p:grpSpPr>
              <a:xfrm>
                <a:off x="3960050" y="496604"/>
                <a:ext cx="2091051" cy="1640400"/>
                <a:chOff x="3960050" y="454479"/>
                <a:chExt cx="2091051" cy="1640400"/>
              </a:xfrm>
            </p:grpSpPr>
            <p:pic>
              <p:nvPicPr>
                <p:cNvPr id="66" name="Picture 65">
                  <a:extLst>
                    <a:ext uri="{FF2B5EF4-FFF2-40B4-BE49-F238E27FC236}">
                      <a16:creationId xmlns:a16="http://schemas.microsoft.com/office/drawing/2014/main" id="{13582B53-4793-4915-BB24-A757AFAC55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 flipH="1" flipV="1">
                  <a:off x="4081099" y="596279"/>
                  <a:ext cx="1879600" cy="1498600"/>
                </a:xfrm>
                <a:prstGeom prst="rect">
                  <a:avLst/>
                </a:prstGeom>
              </p:spPr>
            </p:pic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0953820F-B0E2-4CCE-AB28-E7ECCFE5B5D9}"/>
                    </a:ext>
                  </a:extLst>
                </p:cNvPr>
                <p:cNvSpPr txBox="1"/>
                <p:nvPr/>
              </p:nvSpPr>
              <p:spPr>
                <a:xfrm>
                  <a:off x="3960050" y="906764"/>
                  <a:ext cx="292388" cy="803402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-position (µm)</a:t>
                  </a:r>
                </a:p>
              </p:txBody>
            </p:sp>
            <p:cxnSp>
              <p:nvCxnSpPr>
                <p:cNvPr id="68" name="Straight Arrow Connector 67">
                  <a:extLst>
                    <a:ext uri="{FF2B5EF4-FFF2-40B4-BE49-F238E27FC236}">
                      <a16:creationId xmlns:a16="http://schemas.microsoft.com/office/drawing/2014/main" id="{845B4645-0E0A-489D-84CB-6FB4D9BED2DD}"/>
                    </a:ext>
                  </a:extLst>
                </p:cNvPr>
                <p:cNvCxnSpPr/>
                <p:nvPr/>
              </p:nvCxnSpPr>
              <p:spPr>
                <a:xfrm flipH="1" flipV="1">
                  <a:off x="5243978" y="1479559"/>
                  <a:ext cx="190892" cy="6538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57F9229E-CFB4-4EAC-A452-565352BFDF04}"/>
                    </a:ext>
                  </a:extLst>
                </p:cNvPr>
                <p:cNvSpPr txBox="1"/>
                <p:nvPr/>
              </p:nvSpPr>
              <p:spPr>
                <a:xfrm>
                  <a:off x="5370402" y="1464800"/>
                  <a:ext cx="6678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ynapse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6CB6C439-B7C5-4A87-B87B-F01FF0A3B480}"/>
                    </a:ext>
                  </a:extLst>
                </p:cNvPr>
                <p:cNvSpPr txBox="1"/>
                <p:nvPr/>
              </p:nvSpPr>
              <p:spPr>
                <a:xfrm>
                  <a:off x="4588590" y="454479"/>
                  <a:ext cx="9165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CR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A46145A0-7B26-445F-A463-7FE63BECD7CD}"/>
                    </a:ext>
                  </a:extLst>
                </p:cNvPr>
                <p:cNvSpPr txBox="1"/>
                <p:nvPr/>
              </p:nvSpPr>
              <p:spPr>
                <a:xfrm>
                  <a:off x="5149777" y="724573"/>
                  <a:ext cx="90132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CR track path</a:t>
                  </a:r>
                </a:p>
              </p:txBody>
            </p:sp>
            <p:cxnSp>
              <p:nvCxnSpPr>
                <p:cNvPr id="73" name="Straight Arrow Connector 72">
                  <a:extLst>
                    <a:ext uri="{FF2B5EF4-FFF2-40B4-BE49-F238E27FC236}">
                      <a16:creationId xmlns:a16="http://schemas.microsoft.com/office/drawing/2014/main" id="{80948BB6-0C5C-4232-B47E-5085DC8FC35B}"/>
                    </a:ext>
                  </a:extLst>
                </p:cNvPr>
                <p:cNvCxnSpPr/>
                <p:nvPr/>
              </p:nvCxnSpPr>
              <p:spPr>
                <a:xfrm flipH="1">
                  <a:off x="5434870" y="904631"/>
                  <a:ext cx="131573" cy="13532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15" name="TextBox 114"/>
            <p:cNvSpPr txBox="1"/>
            <p:nvPr/>
          </p:nvSpPr>
          <p:spPr>
            <a:xfrm>
              <a:off x="3104008" y="2998379"/>
              <a:ext cx="897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osition (µm)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32983" y="638662"/>
              <a:ext cx="272202" cy="7108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532983" y="1271382"/>
              <a:ext cx="272202" cy="116955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CR-Alexa568</a:t>
              </a:r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483701" y="382668"/>
              <a:ext cx="5507755" cy="2682635"/>
              <a:chOff x="708" y="62137"/>
              <a:chExt cx="6538936" cy="3184889"/>
            </a:xfrm>
          </p:grpSpPr>
          <p:grpSp>
            <p:nvGrpSpPr>
              <p:cNvPr id="81" name="Group 80"/>
              <p:cNvGrpSpPr/>
              <p:nvPr/>
            </p:nvGrpSpPr>
            <p:grpSpPr>
              <a:xfrm>
                <a:off x="708" y="62137"/>
                <a:ext cx="6538936" cy="3184889"/>
                <a:chOff x="708" y="266971"/>
                <a:chExt cx="6538936" cy="3184889"/>
              </a:xfrm>
            </p:grpSpPr>
            <p:pic>
              <p:nvPicPr>
                <p:cNvPr id="89" name="Picture 88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4722" y="1507490"/>
                  <a:ext cx="6128377" cy="976598"/>
                </a:xfrm>
                <a:prstGeom prst="rect">
                  <a:avLst/>
                </a:prstGeom>
              </p:spPr>
            </p:pic>
            <p:pic>
              <p:nvPicPr>
                <p:cNvPr id="90" name="Picture 89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4722" y="501381"/>
                  <a:ext cx="6134936" cy="967740"/>
                </a:xfrm>
                <a:prstGeom prst="rect">
                  <a:avLst/>
                </a:prstGeom>
              </p:spPr>
            </p:pic>
            <p:pic>
              <p:nvPicPr>
                <p:cNvPr id="88" name="Picture 87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6622" y="2598926"/>
                  <a:ext cx="6213022" cy="852934"/>
                </a:xfrm>
                <a:prstGeom prst="rect">
                  <a:avLst/>
                </a:prstGeom>
              </p:spPr>
            </p:pic>
            <p:grpSp>
              <p:nvGrpSpPr>
                <p:cNvPr id="91" name="Group 90"/>
                <p:cNvGrpSpPr/>
                <p:nvPr/>
              </p:nvGrpSpPr>
              <p:grpSpPr>
                <a:xfrm>
                  <a:off x="708" y="266971"/>
                  <a:ext cx="6360440" cy="308133"/>
                  <a:chOff x="641711" y="104458"/>
                  <a:chExt cx="3397035" cy="308133"/>
                </a:xfrm>
              </p:grpSpPr>
              <p:sp>
                <p:nvSpPr>
                  <p:cNvPr id="92" name="TextBox 91"/>
                  <p:cNvSpPr txBox="1"/>
                  <p:nvPr/>
                </p:nvSpPr>
                <p:spPr>
                  <a:xfrm>
                    <a:off x="3311044" y="106588"/>
                    <a:ext cx="1328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3731219" y="130024"/>
                    <a:ext cx="30752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 (min.)</a:t>
                    </a:r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1434125" y="117240"/>
                    <a:ext cx="20136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 </a:t>
                    </a: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>
                    <a:off x="1903181" y="112980"/>
                    <a:ext cx="18424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7</a:t>
                    </a: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2385408" y="104458"/>
                    <a:ext cx="18424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6</a:t>
                    </a: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2855478" y="112980"/>
                    <a:ext cx="1328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grpSp>
                <p:nvGrpSpPr>
                  <p:cNvPr id="98" name="Group 97"/>
                  <p:cNvGrpSpPr/>
                  <p:nvPr/>
                </p:nvGrpSpPr>
                <p:grpSpPr>
                  <a:xfrm>
                    <a:off x="641711" y="130024"/>
                    <a:ext cx="552496" cy="282567"/>
                    <a:chOff x="641711" y="131610"/>
                    <a:chExt cx="552496" cy="282567"/>
                  </a:xfrm>
                </p:grpSpPr>
                <p:sp>
                  <p:nvSpPr>
                    <p:cNvPr id="99" name="TextBox 98"/>
                    <p:cNvSpPr txBox="1"/>
                    <p:nvPr/>
                  </p:nvSpPr>
                  <p:spPr>
                    <a:xfrm>
                      <a:off x="1044211" y="131610"/>
                      <a:ext cx="14999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</a:p>
                  </p:txBody>
                </p:sp>
                <p:sp>
                  <p:nvSpPr>
                    <p:cNvPr id="100" name="TextBox 99"/>
                    <p:cNvSpPr txBox="1"/>
                    <p:nvPr/>
                  </p:nvSpPr>
                  <p:spPr>
                    <a:xfrm>
                      <a:off x="641711" y="140129"/>
                      <a:ext cx="441091" cy="2740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= </a:t>
                      </a:r>
                    </a:p>
                  </p:txBody>
                </p:sp>
              </p:grpSp>
            </p:grpSp>
          </p:grpSp>
          <p:cxnSp>
            <p:nvCxnSpPr>
              <p:cNvPr id="41" name="Straight Connector 40"/>
              <p:cNvCxnSpPr/>
              <p:nvPr/>
            </p:nvCxnSpPr>
            <p:spPr>
              <a:xfrm>
                <a:off x="563403" y="296278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1401603" y="296278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/>
              <p:cNvCxnSpPr/>
              <p:nvPr/>
            </p:nvCxnSpPr>
            <p:spPr>
              <a:xfrm>
                <a:off x="2282677" y="291513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/>
              <p:cNvCxnSpPr/>
              <p:nvPr/>
            </p:nvCxnSpPr>
            <p:spPr>
              <a:xfrm>
                <a:off x="3173277" y="291511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4049588" y="296272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4964003" y="301033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5845081" y="301031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563403" y="1299787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>
                <a:off x="1420655" y="1294212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2277907" y="1288637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>
                <a:off x="3173263" y="1283062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4054324" y="1301302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Straight Connector 112"/>
              <p:cNvCxnSpPr/>
              <p:nvPr/>
            </p:nvCxnSpPr>
            <p:spPr>
              <a:xfrm>
                <a:off x="4944914" y="1305253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>
                <a:off x="5825984" y="1299678"/>
                <a:ext cx="127458" cy="96800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8" name="TextBox 117"/>
            <p:cNvSpPr txBox="1"/>
            <p:nvPr/>
          </p:nvSpPr>
          <p:spPr>
            <a:xfrm>
              <a:off x="369358" y="2245101"/>
              <a:ext cx="461665" cy="71887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ormalized Intensity</a:t>
              </a:r>
            </a:p>
          </p:txBody>
        </p:sp>
        <p:sp>
          <p:nvSpPr>
            <p:cNvPr id="149" name="Text Box 207"/>
            <p:cNvSpPr txBox="1"/>
            <p:nvPr/>
          </p:nvSpPr>
          <p:spPr>
            <a:xfrm>
              <a:off x="341905" y="298831"/>
              <a:ext cx="280489" cy="183027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1245760" y="1331755"/>
              <a:ext cx="211093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815330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86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548051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82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275153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91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984345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97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720091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98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402102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98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164482" y="2223208"/>
              <a:ext cx="660524" cy="213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C = 0.98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5975091" y="1362646"/>
              <a:ext cx="390260" cy="928562"/>
              <a:chOff x="6016419" y="1357480"/>
              <a:chExt cx="390260" cy="928562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16419" y="1420446"/>
                <a:ext cx="110579" cy="823071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6043507" y="2085987"/>
                <a:ext cx="34817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039271" y="1357480"/>
                <a:ext cx="3674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5976425" y="503776"/>
              <a:ext cx="387114" cy="928562"/>
              <a:chOff x="6007421" y="503776"/>
              <a:chExt cx="387114" cy="928562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07421" y="573467"/>
                <a:ext cx="111369" cy="837587"/>
              </a:xfrm>
              <a:prstGeom prst="rect">
                <a:avLst/>
              </a:prstGeom>
            </p:spPr>
          </p:pic>
          <p:sp>
            <p:nvSpPr>
              <p:cNvPr id="123" name="TextBox 122"/>
              <p:cNvSpPr txBox="1"/>
              <p:nvPr/>
            </p:nvSpPr>
            <p:spPr>
              <a:xfrm>
                <a:off x="6031363" y="1232283"/>
                <a:ext cx="34817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6027127" y="503776"/>
                <a:ext cx="3674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02790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001EB80-6CE9-47A9-9930-03678E2B8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4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14C3579-1292-4D0D-A0EA-473DAB95C0A9}"/>
              </a:ext>
            </a:extLst>
          </p:cNvPr>
          <p:cNvSpPr/>
          <p:nvPr/>
        </p:nvSpPr>
        <p:spPr>
          <a:xfrm>
            <a:off x="657827" y="3292402"/>
            <a:ext cx="5793665" cy="6131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The representative TCR-CD3ζ intramolecular distance changes with (black) and without (red) PP2 treatment for MCC (a) and 102S (b). 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D9A22863-3145-1342-BBC7-2997EC8CC272}"/>
              </a:ext>
            </a:extLst>
          </p:cNvPr>
          <p:cNvGrpSpPr/>
          <p:nvPr/>
        </p:nvGrpSpPr>
        <p:grpSpPr>
          <a:xfrm>
            <a:off x="1429759" y="1031010"/>
            <a:ext cx="3936786" cy="2105667"/>
            <a:chOff x="1437364" y="1467900"/>
            <a:chExt cx="3936786" cy="210566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9B074E8-1F39-43EE-9F90-882C312CCF9A}"/>
                </a:ext>
              </a:extLst>
            </p:cNvPr>
            <p:cNvSpPr txBox="1"/>
            <p:nvPr/>
          </p:nvSpPr>
          <p:spPr>
            <a:xfrm>
              <a:off x="1556728" y="1485227"/>
              <a:ext cx="12615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C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3E2B135-BF8B-4BD6-B249-C0701B62181A}"/>
                </a:ext>
              </a:extLst>
            </p:cNvPr>
            <p:cNvSpPr txBox="1"/>
            <p:nvPr/>
          </p:nvSpPr>
          <p:spPr>
            <a:xfrm>
              <a:off x="3554660" y="1467900"/>
              <a:ext cx="12615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2S</a:t>
              </a:r>
            </a:p>
          </p:txBody>
        </p:sp>
        <p:sp>
          <p:nvSpPr>
            <p:cNvPr id="8" name="Text Box 207">
              <a:extLst>
                <a:ext uri="{FF2B5EF4-FFF2-40B4-BE49-F238E27FC236}">
                  <a16:creationId xmlns:a16="http://schemas.microsoft.com/office/drawing/2014/main" id="{DDDD86F2-D3FB-4BC4-88DE-B7E99798E5B6}"/>
                </a:ext>
              </a:extLst>
            </p:cNvPr>
            <p:cNvSpPr txBox="1"/>
            <p:nvPr/>
          </p:nvSpPr>
          <p:spPr>
            <a:xfrm>
              <a:off x="1658422" y="1478296"/>
              <a:ext cx="333003" cy="21729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Vrinda" panose="020B0502040204020203" pitchFamily="34" charset="0"/>
                </a:rPr>
                <a:t>a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Vrinda" panose="020B0502040204020203" pitchFamily="34" charset="0"/>
              </a:endParaRPr>
            </a:p>
          </p:txBody>
        </p:sp>
        <p:sp>
          <p:nvSpPr>
            <p:cNvPr id="9" name="Text Box 207">
              <a:extLst>
                <a:ext uri="{FF2B5EF4-FFF2-40B4-BE49-F238E27FC236}">
                  <a16:creationId xmlns:a16="http://schemas.microsoft.com/office/drawing/2014/main" id="{BA58AEC5-16DA-4E3E-8E31-C539A808883F}"/>
                </a:ext>
              </a:extLst>
            </p:cNvPr>
            <p:cNvSpPr txBox="1"/>
            <p:nvPr/>
          </p:nvSpPr>
          <p:spPr>
            <a:xfrm>
              <a:off x="3494765" y="1478141"/>
              <a:ext cx="333003" cy="21729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Vrinda" panose="020B0502040204020203" pitchFamily="34" charset="0"/>
                </a:rPr>
                <a:t>b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Vrinda" panose="020B0502040204020203" pitchFamily="34" charset="0"/>
              </a:endParaRP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A7F9568-4FA6-8946-A85F-9860360BFA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6786" y="1761278"/>
              <a:ext cx="2047364" cy="164592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A19A6709-EB49-3344-BF2E-1196CA62B3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7364" y="1761278"/>
              <a:ext cx="2047364" cy="164592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7AC5394-5590-5F44-8B62-2FC92096325F}"/>
                </a:ext>
              </a:extLst>
            </p:cNvPr>
            <p:cNvSpPr txBox="1"/>
            <p:nvPr/>
          </p:nvSpPr>
          <p:spPr>
            <a:xfrm>
              <a:off x="2284600" y="3322480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Time (min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AAD69DB-04D2-674C-88E0-5E7E8911E59E}"/>
                </a:ext>
              </a:extLst>
            </p:cNvPr>
            <p:cNvSpPr txBox="1"/>
            <p:nvPr/>
          </p:nvSpPr>
          <p:spPr>
            <a:xfrm>
              <a:off x="3207448" y="2284880"/>
              <a:ext cx="338554" cy="36163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/D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CB6C4D2-A690-2C43-88F5-A4B8EFEEB554}"/>
                </a:ext>
              </a:extLst>
            </p:cNvPr>
            <p:cNvSpPr txBox="1"/>
            <p:nvPr/>
          </p:nvSpPr>
          <p:spPr>
            <a:xfrm>
              <a:off x="4182616" y="3327346"/>
              <a:ext cx="7986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Time (min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82DA7AC-5407-A044-BEA9-A06D35F496AC}"/>
                </a:ext>
              </a:extLst>
            </p:cNvPr>
            <p:cNvSpPr txBox="1"/>
            <p:nvPr/>
          </p:nvSpPr>
          <p:spPr>
            <a:xfrm>
              <a:off x="4383040" y="2784202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/ PP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611EBEC-525E-0D4F-80F4-41F104EC7F32}"/>
                </a:ext>
              </a:extLst>
            </p:cNvPr>
            <p:cNvSpPr txBox="1"/>
            <p:nvPr/>
          </p:nvSpPr>
          <p:spPr>
            <a:xfrm>
              <a:off x="4355881" y="2525955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/o PP2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3B5049BD-6631-415E-B731-8DE4977A1B77}"/>
              </a:ext>
            </a:extLst>
          </p:cNvPr>
          <p:cNvSpPr txBox="1"/>
          <p:nvPr/>
        </p:nvSpPr>
        <p:spPr>
          <a:xfrm>
            <a:off x="1305270" y="1849590"/>
            <a:ext cx="338554" cy="3616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/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16531AB-3DD5-438E-ACBA-53BB64F32AD2}"/>
              </a:ext>
            </a:extLst>
          </p:cNvPr>
          <p:cNvSpPr txBox="1"/>
          <p:nvPr/>
        </p:nvSpPr>
        <p:spPr>
          <a:xfrm>
            <a:off x="2518678" y="2006120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/o PP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BA2A8D1-2DBC-47F8-B859-C49CE459666A}"/>
              </a:ext>
            </a:extLst>
          </p:cNvPr>
          <p:cNvSpPr txBox="1"/>
          <p:nvPr/>
        </p:nvSpPr>
        <p:spPr>
          <a:xfrm>
            <a:off x="2518678" y="235636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/ PP2</a:t>
            </a:r>
          </a:p>
        </p:txBody>
      </p:sp>
    </p:spTree>
    <p:extLst>
      <p:ext uri="{BB962C8B-B14F-4D97-AF65-F5344CB8AC3E}">
        <p14:creationId xmlns:p14="http://schemas.microsoft.com/office/powerpoint/2010/main" val="78798464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529739" y="382306"/>
            <a:ext cx="3497602" cy="2748819"/>
            <a:chOff x="1263039" y="3871696"/>
            <a:chExt cx="3497602" cy="2748819"/>
          </a:xfrm>
        </p:grpSpPr>
        <p:grpSp>
          <p:nvGrpSpPr>
            <p:cNvPr id="4" name="Group 3"/>
            <p:cNvGrpSpPr/>
            <p:nvPr/>
          </p:nvGrpSpPr>
          <p:grpSpPr>
            <a:xfrm>
              <a:off x="1263039" y="3871696"/>
              <a:ext cx="3497602" cy="2748819"/>
              <a:chOff x="3571975" y="1200067"/>
              <a:chExt cx="2701436" cy="2123103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81007" y="1235075"/>
                <a:ext cx="2208713" cy="1879600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4730816" y="3085453"/>
                <a:ext cx="835773" cy="2377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min.)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571975" y="1621358"/>
                <a:ext cx="309032" cy="946660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ntensity (a.u.)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382898" y="1200067"/>
                <a:ext cx="70682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5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356125" y="1768022"/>
                <a:ext cx="76036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00CC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566589" y="2165752"/>
                <a:ext cx="70682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5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317926" y="2699068"/>
                <a:ext cx="76036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00CC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210264" y="4232492"/>
              <a:ext cx="4219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5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25310" y="5366957"/>
              <a:ext cx="6286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CC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834309" y="3250679"/>
            <a:ext cx="5473700" cy="44911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12. Negative controls of transmembrane FRET on the lipid bilayer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o rule out the possibility that transmembrane FRET in Fig. 4 was caused by different diffusion rates of TCRs and CD3ζ into a microcluster due to the ratiometric nature of FRET, we labelled TCRs with Cy5 and CD3ζ with GFP (GFP/Cy5 is a non-FRET pair). The GFP was excited by a 470-nm LED light and the Cy5 was excited by a 640-nm LED light sequentially. The mean fluorescence intensities of Cy5 and GFP (and their ratios) stayed constant in a representative microcluster upon TCR-pMHC ligation for K5 and MCC pMHCs. These experiments confirmed that the transmembrane FRET between CD3ζ-GFP and TCR-Alexa568 in Fig. 4 were merely due to TCR-CD3ζ conformational changes, as well as confirmed that TCR-CD3ζ complexes are very stable (also see TCR/CD3 colocalization in Extended data Fig. 10a). The mean fluorescence intensities were recorded in real time upon adding fluorescently labelled T cells to K5 (top panel) or MCC (bottom panel) pMHCs containing lipid bilayers. Shown are representative time trajectories of intensity out of 3 independent experiments for each pMHC. 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25791867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6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385152" y="557562"/>
            <a:ext cx="4210908" cy="1616184"/>
            <a:chOff x="363649" y="2731904"/>
            <a:chExt cx="4210908" cy="1616184"/>
          </a:xfrm>
        </p:grpSpPr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6F7416E5-0D8B-4B05-8057-F1DC24FDA0F3}"/>
                </a:ext>
              </a:extLst>
            </p:cNvPr>
            <p:cNvGrpSpPr/>
            <p:nvPr/>
          </p:nvGrpSpPr>
          <p:grpSpPr>
            <a:xfrm>
              <a:off x="2465169" y="2778174"/>
              <a:ext cx="2109388" cy="1549709"/>
              <a:chOff x="4173379" y="2293389"/>
              <a:chExt cx="2109388" cy="1549709"/>
            </a:xfrm>
          </p:grpSpPr>
          <p:pic>
            <p:nvPicPr>
              <p:cNvPr id="121" name="Picture 120">
                <a:extLst>
                  <a:ext uri="{FF2B5EF4-FFF2-40B4-BE49-F238E27FC236}">
                    <a16:creationId xmlns:a16="http://schemas.microsoft.com/office/drawing/2014/main" id="{BA3DC627-5628-4ABD-8415-2D3A27DA96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 flipH="1" flipV="1">
                <a:off x="4396386" y="2430818"/>
                <a:ext cx="1447800" cy="1231900"/>
              </a:xfrm>
              <a:prstGeom prst="rect">
                <a:avLst/>
              </a:prstGeom>
            </p:spPr>
          </p:pic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BA540E3A-351B-4D5D-9215-CD131EAE73F0}"/>
                  </a:ext>
                </a:extLst>
              </p:cNvPr>
              <p:cNvSpPr txBox="1"/>
              <p:nvPr/>
            </p:nvSpPr>
            <p:spPr>
              <a:xfrm>
                <a:off x="4776808" y="3643043"/>
                <a:ext cx="86938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-position (µm)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0097032C-FACD-4D3E-9ED2-DD059B8E1938}"/>
                  </a:ext>
                </a:extLst>
              </p:cNvPr>
              <p:cNvSpPr txBox="1"/>
              <p:nvPr/>
            </p:nvSpPr>
            <p:spPr>
              <a:xfrm>
                <a:off x="4173379" y="2538076"/>
                <a:ext cx="292388" cy="837294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-position (µm)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E946F1E3-14DA-4983-BC96-DC2FE5D44B6D}"/>
                  </a:ext>
                </a:extLst>
              </p:cNvPr>
              <p:cNvSpPr txBox="1"/>
              <p:nvPr/>
            </p:nvSpPr>
            <p:spPr>
              <a:xfrm>
                <a:off x="5405604" y="2293389"/>
                <a:ext cx="87716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CR microcluster</a:t>
                </a:r>
              </a:p>
            </p:txBody>
          </p:sp>
          <p:cxnSp>
            <p:nvCxnSpPr>
              <p:cNvPr id="126" name="Straight Arrow Connector 125">
                <a:extLst>
                  <a:ext uri="{FF2B5EF4-FFF2-40B4-BE49-F238E27FC236}">
                    <a16:creationId xmlns:a16="http://schemas.microsoft.com/office/drawing/2014/main" id="{DBB06FE1-F697-4261-A5AD-6FB67FE909D2}"/>
                  </a:ext>
                </a:extLst>
              </p:cNvPr>
              <p:cNvCxnSpPr/>
              <p:nvPr/>
            </p:nvCxnSpPr>
            <p:spPr>
              <a:xfrm flipH="1">
                <a:off x="5243978" y="2396649"/>
                <a:ext cx="221266" cy="30027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7" name="Text Box 207">
              <a:extLst>
                <a:ext uri="{FF2B5EF4-FFF2-40B4-BE49-F238E27FC236}">
                  <a16:creationId xmlns:a16="http://schemas.microsoft.com/office/drawing/2014/main" id="{D705795D-6C93-4187-9507-3D6478D727BE}"/>
                </a:ext>
              </a:extLst>
            </p:cNvPr>
            <p:cNvSpPr txBox="1"/>
            <p:nvPr/>
          </p:nvSpPr>
          <p:spPr>
            <a:xfrm>
              <a:off x="363649" y="2731904"/>
              <a:ext cx="333003" cy="21729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DFECD0C7-7F04-4B79-B178-917E7521B8C6}"/>
                </a:ext>
              </a:extLst>
            </p:cNvPr>
            <p:cNvGrpSpPr/>
            <p:nvPr/>
          </p:nvGrpSpPr>
          <p:grpSpPr>
            <a:xfrm>
              <a:off x="488563" y="2744473"/>
              <a:ext cx="1952119" cy="1603615"/>
              <a:chOff x="1451828" y="2291584"/>
              <a:chExt cx="1952119" cy="1603615"/>
            </a:xfrm>
          </p:grpSpPr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B4173653-E080-42C3-BC59-55A47F4729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 flipH="1" flipV="1">
                <a:off x="1697464" y="2469162"/>
                <a:ext cx="1447800" cy="1231900"/>
              </a:xfrm>
              <a:prstGeom prst="rect">
                <a:avLst/>
              </a:prstGeom>
            </p:spPr>
          </p:pic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0C981CEF-13C0-40D2-B135-05C28D1C7ECC}"/>
                  </a:ext>
                </a:extLst>
              </p:cNvPr>
              <p:cNvSpPr txBox="1"/>
              <p:nvPr/>
            </p:nvSpPr>
            <p:spPr>
              <a:xfrm>
                <a:off x="2735174" y="2291584"/>
                <a:ext cx="66877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crocluster</a:t>
                </a:r>
              </a:p>
            </p:txBody>
          </p:sp>
          <p:cxnSp>
            <p:nvCxnSpPr>
              <p:cNvPr id="103" name="Straight Arrow Connector 102">
                <a:extLst>
                  <a:ext uri="{FF2B5EF4-FFF2-40B4-BE49-F238E27FC236}">
                    <a16:creationId xmlns:a16="http://schemas.microsoft.com/office/drawing/2014/main" id="{A3F406D7-B10C-4C20-A595-3A159D5105BB}"/>
                  </a:ext>
                </a:extLst>
              </p:cNvPr>
              <p:cNvCxnSpPr>
                <a:stCxn id="102" idx="1"/>
              </p:cNvCxnSpPr>
              <p:nvPr/>
            </p:nvCxnSpPr>
            <p:spPr>
              <a:xfrm flipH="1">
                <a:off x="2543728" y="2445473"/>
                <a:ext cx="191446" cy="27193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2CA3FC59-0173-4CE0-B705-6CCB18133369}"/>
                  </a:ext>
                </a:extLst>
              </p:cNvPr>
              <p:cNvSpPr txBox="1"/>
              <p:nvPr/>
            </p:nvSpPr>
            <p:spPr>
              <a:xfrm>
                <a:off x="2055257" y="3695144"/>
                <a:ext cx="86938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-position (µm)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B4E2AC23-C66B-4204-83EF-16ECB2899292}"/>
                  </a:ext>
                </a:extLst>
              </p:cNvPr>
              <p:cNvSpPr txBox="1"/>
              <p:nvPr/>
            </p:nvSpPr>
            <p:spPr>
              <a:xfrm>
                <a:off x="1451828" y="2603147"/>
                <a:ext cx="292388" cy="837294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-position (µm)</a:t>
                </a:r>
              </a:p>
            </p:txBody>
          </p:sp>
        </p:grpSp>
      </p:grpSp>
      <p:grpSp>
        <p:nvGrpSpPr>
          <p:cNvPr id="5" name="Group 4"/>
          <p:cNvGrpSpPr/>
          <p:nvPr/>
        </p:nvGrpSpPr>
        <p:grpSpPr>
          <a:xfrm>
            <a:off x="1359488" y="2238283"/>
            <a:ext cx="4063154" cy="1581383"/>
            <a:chOff x="1002606" y="524624"/>
            <a:chExt cx="4063154" cy="1581383"/>
          </a:xfrm>
        </p:grpSpPr>
        <p:grpSp>
          <p:nvGrpSpPr>
            <p:cNvPr id="11" name="Group 10"/>
            <p:cNvGrpSpPr/>
            <p:nvPr/>
          </p:nvGrpSpPr>
          <p:grpSpPr>
            <a:xfrm>
              <a:off x="1002606" y="525368"/>
              <a:ext cx="1917546" cy="1580639"/>
              <a:chOff x="4400135" y="2293972"/>
              <a:chExt cx="1917546" cy="1580639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58209" y="2485641"/>
                <a:ext cx="1751738" cy="1308100"/>
              </a:xfrm>
              <a:prstGeom prst="rect">
                <a:avLst/>
              </a:prstGeom>
            </p:spPr>
          </p:pic>
          <p:sp>
            <p:nvSpPr>
              <p:cNvPr id="26" name="TextBox 25"/>
              <p:cNvSpPr txBox="1"/>
              <p:nvPr/>
            </p:nvSpPr>
            <p:spPr>
              <a:xfrm>
                <a:off x="4512603" y="2413936"/>
                <a:ext cx="23916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9993899">
                <a:off x="5527081" y="3632985"/>
                <a:ext cx="79060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-Position (µm)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374879">
                <a:off x="4630143" y="3674556"/>
                <a:ext cx="79060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-Position (µm)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21306642">
                <a:off x="4440193" y="2582151"/>
                <a:ext cx="292387" cy="104291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CR-CD3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istance (Å)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5703357" y="2532609"/>
                <a:ext cx="455574" cy="3077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5</a:t>
                </a:r>
              </a:p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Glass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400135" y="2293972"/>
                <a:ext cx="27924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695279" y="3419972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840582" y="3485564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981174" y="3548910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124367" y="3597544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279776" y="3667360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5432890" y="3648854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551444" y="3590127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5687256" y="3519999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5771248" y="34723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5874879" y="3419971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</p:grpSp>
        <p:grpSp>
          <p:nvGrpSpPr>
            <p:cNvPr id="2827" name="Group 2826">
              <a:extLst>
                <a:ext uri="{FF2B5EF4-FFF2-40B4-BE49-F238E27FC236}">
                  <a16:creationId xmlns:a16="http://schemas.microsoft.com/office/drawing/2014/main" id="{041F52C4-9ED2-4EE0-952C-E13B3B3E2067}"/>
                </a:ext>
              </a:extLst>
            </p:cNvPr>
            <p:cNvGrpSpPr/>
            <p:nvPr/>
          </p:nvGrpSpPr>
          <p:grpSpPr>
            <a:xfrm>
              <a:off x="3109276" y="524624"/>
              <a:ext cx="1956484" cy="1439784"/>
              <a:chOff x="2495590" y="3044732"/>
              <a:chExt cx="1956484" cy="1439784"/>
            </a:xfrm>
          </p:grpSpPr>
          <p:sp>
            <p:nvSpPr>
              <p:cNvPr id="68" name="TextBox 67"/>
              <p:cNvSpPr txBox="1"/>
              <p:nvPr/>
            </p:nvSpPr>
            <p:spPr>
              <a:xfrm>
                <a:off x="2920277" y="4283179"/>
                <a:ext cx="292388" cy="20133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5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326349" y="4283179"/>
                <a:ext cx="388248" cy="200055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CC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770199" y="4283179"/>
                <a:ext cx="681875" cy="200055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2S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2546489" y="3044732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2495590" y="3313082"/>
                <a:ext cx="292388" cy="105253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quilibrium Distance (Å)</a:t>
                </a:r>
              </a:p>
            </p:txBody>
          </p:sp>
          <p:grpSp>
            <p:nvGrpSpPr>
              <p:cNvPr id="79" name="Group 78"/>
              <p:cNvGrpSpPr/>
              <p:nvPr/>
            </p:nvGrpSpPr>
            <p:grpSpPr>
              <a:xfrm>
                <a:off x="3363117" y="3311224"/>
                <a:ext cx="568938" cy="323465"/>
                <a:chOff x="4112387" y="4382493"/>
                <a:chExt cx="568938" cy="323465"/>
              </a:xfrm>
            </p:grpSpPr>
            <p:sp>
              <p:nvSpPr>
                <p:cNvPr id="87" name="Rectangle 86"/>
                <p:cNvSpPr/>
                <p:nvPr/>
              </p:nvSpPr>
              <p:spPr>
                <a:xfrm>
                  <a:off x="4112387" y="4439719"/>
                  <a:ext cx="205660" cy="85738"/>
                </a:xfrm>
                <a:prstGeom prst="rect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8" name="Rectangle 87"/>
                <p:cNvSpPr/>
                <p:nvPr/>
              </p:nvSpPr>
              <p:spPr>
                <a:xfrm>
                  <a:off x="4112387" y="4555129"/>
                  <a:ext cx="205660" cy="85738"/>
                </a:xfrm>
                <a:prstGeom prst="rect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4271809" y="4382493"/>
                  <a:ext cx="37221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pid</a:t>
                  </a: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4267429" y="4505903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ass</a:t>
                  </a:r>
                </a:p>
              </p:txBody>
            </p:sp>
          </p:grpSp>
          <p:sp>
            <p:nvSpPr>
              <p:cNvPr id="160" name="Rectangle 2660">
                <a:extLst>
                  <a:ext uri="{FF2B5EF4-FFF2-40B4-BE49-F238E27FC236}">
                    <a16:creationId xmlns:a16="http://schemas.microsoft.com/office/drawing/2014/main" id="{FA3B537B-EE19-4095-BBC0-61A5ADD330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7825" y="3676650"/>
                <a:ext cx="153988" cy="611188"/>
              </a:xfrm>
              <a:prstGeom prst="rect">
                <a:avLst/>
              </a:prstGeom>
              <a:solidFill>
                <a:srgbClr val="FDC897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1" name="Rectangle 2661">
                <a:extLst>
                  <a:ext uri="{FF2B5EF4-FFF2-40B4-BE49-F238E27FC236}">
                    <a16:creationId xmlns:a16="http://schemas.microsoft.com/office/drawing/2014/main" id="{B281763E-22C4-46DE-A473-84CC4F4C9F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5975" y="3978275"/>
                <a:ext cx="153988" cy="309563"/>
              </a:xfrm>
              <a:prstGeom prst="rect">
                <a:avLst/>
              </a:prstGeom>
              <a:solidFill>
                <a:srgbClr val="FDC897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2" name="Rectangle 2662">
                <a:extLst>
                  <a:ext uri="{FF2B5EF4-FFF2-40B4-BE49-F238E27FC236}">
                    <a16:creationId xmlns:a16="http://schemas.microsoft.com/office/drawing/2014/main" id="{0BD6F783-B455-43B7-87C7-6B9EB4CBBD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2538" y="4071938"/>
                <a:ext cx="153988" cy="215900"/>
              </a:xfrm>
              <a:prstGeom prst="rect">
                <a:avLst/>
              </a:prstGeom>
              <a:solidFill>
                <a:srgbClr val="FDC897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3" name="Rectangle 2663">
                <a:extLst>
                  <a:ext uri="{FF2B5EF4-FFF2-40B4-BE49-F238E27FC236}">
                    <a16:creationId xmlns:a16="http://schemas.microsoft.com/office/drawing/2014/main" id="{9E1C1BE6-5138-4BC6-87BD-16A6DBE6F0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1813" y="3833813"/>
                <a:ext cx="153988" cy="454025"/>
              </a:xfrm>
              <a:prstGeom prst="rect">
                <a:avLst/>
              </a:prstGeom>
              <a:solidFill>
                <a:srgbClr val="9DD79D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4" name="Rectangle 2664">
                <a:extLst>
                  <a:ext uri="{FF2B5EF4-FFF2-40B4-BE49-F238E27FC236}">
                    <a16:creationId xmlns:a16="http://schemas.microsoft.com/office/drawing/2014/main" id="{D110D979-0B56-44C4-9BEF-36116F2944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09963" y="4111625"/>
                <a:ext cx="152400" cy="176213"/>
              </a:xfrm>
              <a:prstGeom prst="rect">
                <a:avLst/>
              </a:prstGeom>
              <a:solidFill>
                <a:srgbClr val="9DD79D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5" name="Rectangle 2665">
                <a:extLst>
                  <a:ext uri="{FF2B5EF4-FFF2-40B4-BE49-F238E27FC236}">
                    <a16:creationId xmlns:a16="http://schemas.microsoft.com/office/drawing/2014/main" id="{B0DC17A9-AE59-4D3E-AF0B-7EF7579ACB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6525" y="4111625"/>
                <a:ext cx="153988" cy="176213"/>
              </a:xfrm>
              <a:prstGeom prst="rect">
                <a:avLst/>
              </a:prstGeom>
              <a:solidFill>
                <a:srgbClr val="9DD79D"/>
              </a:solidFill>
              <a:ln w="793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6" name="Line 2666">
                <a:extLst>
                  <a:ext uri="{FF2B5EF4-FFF2-40B4-BE49-F238E27FC236}">
                    <a16:creationId xmlns:a16="http://schemas.microsoft.com/office/drawing/2014/main" id="{4690B649-8FD7-4C90-8AF5-B8747B4395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4025" y="3605213"/>
                <a:ext cx="0" cy="71438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7" name="Line 2667">
                <a:extLst>
                  <a:ext uri="{FF2B5EF4-FFF2-40B4-BE49-F238E27FC236}">
                    <a16:creationId xmlns:a16="http://schemas.microsoft.com/office/drawing/2014/main" id="{1A9EA704-C916-4D80-B572-47E8C895EC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4975" y="3605213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8" name="Line 2668">
                <a:extLst>
                  <a:ext uri="{FF2B5EF4-FFF2-40B4-BE49-F238E27FC236}">
                    <a16:creationId xmlns:a16="http://schemas.microsoft.com/office/drawing/2014/main" id="{08394B83-5AD3-48C0-859A-E215665450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94025" y="3676650"/>
                <a:ext cx="0" cy="698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9" name="Line 2669">
                <a:extLst>
                  <a:ext uri="{FF2B5EF4-FFF2-40B4-BE49-F238E27FC236}">
                    <a16:creationId xmlns:a16="http://schemas.microsoft.com/office/drawing/2014/main" id="{40162356-DE53-4B61-9192-F44CF80B9D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4975" y="37465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0" name="Line 2670">
                <a:extLst>
                  <a:ext uri="{FF2B5EF4-FFF2-40B4-BE49-F238E27FC236}">
                    <a16:creationId xmlns:a16="http://schemas.microsoft.com/office/drawing/2014/main" id="{EBFA0AAD-EDFB-4CF3-B874-098AE3485A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2175" y="3916363"/>
                <a:ext cx="0" cy="6191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1" name="Line 2671">
                <a:extLst>
                  <a:ext uri="{FF2B5EF4-FFF2-40B4-BE49-F238E27FC236}">
                    <a16:creationId xmlns:a16="http://schemas.microsoft.com/office/drawing/2014/main" id="{29EDB4B5-DDDE-41C4-8DE6-BC1A74BEE6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3125" y="3916363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2" name="Line 2672">
                <a:extLst>
                  <a:ext uri="{FF2B5EF4-FFF2-40B4-BE49-F238E27FC236}">
                    <a16:creationId xmlns:a16="http://schemas.microsoft.com/office/drawing/2014/main" id="{49A84754-C2FF-433C-B054-A1020286FD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2175" y="3978275"/>
                <a:ext cx="0" cy="6032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3" name="Line 2673">
                <a:extLst>
                  <a:ext uri="{FF2B5EF4-FFF2-40B4-BE49-F238E27FC236}">
                    <a16:creationId xmlns:a16="http://schemas.microsoft.com/office/drawing/2014/main" id="{7D132222-29C6-4FC6-BC20-5192E351F0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3125" y="40386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4" name="Line 2674">
                <a:extLst>
                  <a:ext uri="{FF2B5EF4-FFF2-40B4-BE49-F238E27FC236}">
                    <a16:creationId xmlns:a16="http://schemas.microsoft.com/office/drawing/2014/main" id="{BCEB183A-C629-4942-AF26-91CD9C1D65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0325" y="4025900"/>
                <a:ext cx="0" cy="46038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5" name="Line 2675">
                <a:extLst>
                  <a:ext uri="{FF2B5EF4-FFF2-40B4-BE49-F238E27FC236}">
                    <a16:creationId xmlns:a16="http://schemas.microsoft.com/office/drawing/2014/main" id="{1E5923BF-71E3-4F06-AD57-4D036A4918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1275" y="40259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6" name="Line 2676">
                <a:extLst>
                  <a:ext uri="{FF2B5EF4-FFF2-40B4-BE49-F238E27FC236}">
                    <a16:creationId xmlns:a16="http://schemas.microsoft.com/office/drawing/2014/main" id="{0EE055D7-1217-4D0B-B8A7-03BBA8E7DF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0325" y="4071938"/>
                <a:ext cx="0" cy="46038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7" name="Line 2677">
                <a:extLst>
                  <a:ext uri="{FF2B5EF4-FFF2-40B4-BE49-F238E27FC236}">
                    <a16:creationId xmlns:a16="http://schemas.microsoft.com/office/drawing/2014/main" id="{A155EF14-9682-46A5-89CD-84459F3F83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1275" y="4117975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8" name="Line 2678">
                <a:extLst>
                  <a:ext uri="{FF2B5EF4-FFF2-40B4-BE49-F238E27FC236}">
                    <a16:creationId xmlns:a16="http://schemas.microsoft.com/office/drawing/2014/main" id="{516D9932-96AB-49A6-B48C-1A59A0D364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8013" y="3732213"/>
                <a:ext cx="0" cy="1016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9" name="Line 2679">
                <a:extLst>
                  <a:ext uri="{FF2B5EF4-FFF2-40B4-BE49-F238E27FC236}">
                    <a16:creationId xmlns:a16="http://schemas.microsoft.com/office/drawing/2014/main" id="{366C5FE0-480C-429D-8860-CDE38ABB93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963" y="3732213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0" name="Line 2680">
                <a:extLst>
                  <a:ext uri="{FF2B5EF4-FFF2-40B4-BE49-F238E27FC236}">
                    <a16:creationId xmlns:a16="http://schemas.microsoft.com/office/drawing/2014/main" id="{D3B3DC61-2BAE-40B3-A493-71A530EFF9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8013" y="3833813"/>
                <a:ext cx="0" cy="103188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1" name="Line 2681">
                <a:extLst>
                  <a:ext uri="{FF2B5EF4-FFF2-40B4-BE49-F238E27FC236}">
                    <a16:creationId xmlns:a16="http://schemas.microsoft.com/office/drawing/2014/main" id="{9AEF5DA2-F5E5-4015-9B1D-840EAD484C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963" y="39370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2" name="Line 2682">
                <a:extLst>
                  <a:ext uri="{FF2B5EF4-FFF2-40B4-BE49-F238E27FC236}">
                    <a16:creationId xmlns:a16="http://schemas.microsoft.com/office/drawing/2014/main" id="{9390954E-C36A-4E9A-87EF-1F01A61BE8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6163" y="4051300"/>
                <a:ext cx="0" cy="6032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3" name="Line 2683">
                <a:extLst>
                  <a:ext uri="{FF2B5EF4-FFF2-40B4-BE49-F238E27FC236}">
                    <a16:creationId xmlns:a16="http://schemas.microsoft.com/office/drawing/2014/main" id="{41435BB7-CD21-45BA-8738-C7BC523D5E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7113" y="40513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4" name="Line 2684">
                <a:extLst>
                  <a:ext uri="{FF2B5EF4-FFF2-40B4-BE49-F238E27FC236}">
                    <a16:creationId xmlns:a16="http://schemas.microsoft.com/office/drawing/2014/main" id="{1360EDBA-3905-4B32-9024-DAED7AEF03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6163" y="4111625"/>
                <a:ext cx="0" cy="635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5" name="Line 2685">
                <a:extLst>
                  <a:ext uri="{FF2B5EF4-FFF2-40B4-BE49-F238E27FC236}">
                    <a16:creationId xmlns:a16="http://schemas.microsoft.com/office/drawing/2014/main" id="{6330B48E-BD04-4D9F-B415-1DB71F675A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7113" y="4175125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6" name="Line 2686">
                <a:extLst>
                  <a:ext uri="{FF2B5EF4-FFF2-40B4-BE49-F238E27FC236}">
                    <a16:creationId xmlns:a16="http://schemas.microsoft.com/office/drawing/2014/main" id="{F6651739-E797-4628-A7D3-A9AE236D5E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24313" y="4051300"/>
                <a:ext cx="0" cy="60325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7" name="Line 2687">
                <a:extLst>
                  <a:ext uri="{FF2B5EF4-FFF2-40B4-BE49-F238E27FC236}">
                    <a16:creationId xmlns:a16="http://schemas.microsoft.com/office/drawing/2014/main" id="{0F34987F-C0B4-498B-8A33-C417A354B7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5263" y="4051300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8" name="Line 2688">
                <a:extLst>
                  <a:ext uri="{FF2B5EF4-FFF2-40B4-BE49-F238E27FC236}">
                    <a16:creationId xmlns:a16="http://schemas.microsoft.com/office/drawing/2014/main" id="{94DE5753-9C7B-4FBB-A8E8-04C9C4FEDA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24313" y="4111625"/>
                <a:ext cx="0" cy="635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9" name="Line 2689">
                <a:extLst>
                  <a:ext uri="{FF2B5EF4-FFF2-40B4-BE49-F238E27FC236}">
                    <a16:creationId xmlns:a16="http://schemas.microsoft.com/office/drawing/2014/main" id="{F4E114BB-F8A1-4B92-8842-CF282DADCA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5263" y="4175125"/>
                <a:ext cx="396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08" name="Line 2708">
                <a:extLst>
                  <a:ext uri="{FF2B5EF4-FFF2-40B4-BE49-F238E27FC236}">
                    <a16:creationId xmlns:a16="http://schemas.microsoft.com/office/drawing/2014/main" id="{457D57C5-380D-484F-91C8-C241B0B4A9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4287838"/>
                <a:ext cx="1312863" cy="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0" name="Line 2710">
                <a:extLst>
                  <a:ext uri="{FF2B5EF4-FFF2-40B4-BE49-F238E27FC236}">
                    <a16:creationId xmlns:a16="http://schemas.microsoft.com/office/drawing/2014/main" id="{39DD6445-575D-47C4-90A0-74699933F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52738" y="4267200"/>
                <a:ext cx="0" cy="2063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1" name="Line 2711">
                <a:extLst>
                  <a:ext uri="{FF2B5EF4-FFF2-40B4-BE49-F238E27FC236}">
                    <a16:creationId xmlns:a16="http://schemas.microsoft.com/office/drawing/2014/main" id="{2A3CA8D6-B31C-43D5-A1A1-FA1EF5D7B5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90888" y="4267200"/>
                <a:ext cx="0" cy="2063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2" name="Line 2712">
                <a:extLst>
                  <a:ext uri="{FF2B5EF4-FFF2-40B4-BE49-F238E27FC236}">
                    <a16:creationId xmlns:a16="http://schemas.microsoft.com/office/drawing/2014/main" id="{F3599A02-9B54-449B-B3D4-5511F47C12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7450" y="4267200"/>
                <a:ext cx="0" cy="2063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3" name="Line 2713">
                <a:extLst>
                  <a:ext uri="{FF2B5EF4-FFF2-40B4-BE49-F238E27FC236}">
                    <a16:creationId xmlns:a16="http://schemas.microsoft.com/office/drawing/2014/main" id="{D8462CCF-7D41-42A3-A0E4-5967048ED3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65600" y="4267200"/>
                <a:ext cx="0" cy="2063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4" name="Line 2714">
                <a:extLst>
                  <a:ext uri="{FF2B5EF4-FFF2-40B4-BE49-F238E27FC236}">
                    <a16:creationId xmlns:a16="http://schemas.microsoft.com/office/drawing/2014/main" id="{A7F32EBC-EA41-4835-A135-F066022475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1813" y="4248150"/>
                <a:ext cx="0" cy="3968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5" name="Line 2715">
                <a:extLst>
                  <a:ext uri="{FF2B5EF4-FFF2-40B4-BE49-F238E27FC236}">
                    <a16:creationId xmlns:a16="http://schemas.microsoft.com/office/drawing/2014/main" id="{B303880E-0911-4343-AC85-CDCD9E956C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09963" y="4248150"/>
                <a:ext cx="0" cy="3968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6" name="Line 2716">
                <a:extLst>
                  <a:ext uri="{FF2B5EF4-FFF2-40B4-BE49-F238E27FC236}">
                    <a16:creationId xmlns:a16="http://schemas.microsoft.com/office/drawing/2014/main" id="{89F2A52C-4409-46C6-AE31-3CEE7C0006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46525" y="4248150"/>
                <a:ext cx="0" cy="3968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7" name="Line 2717">
                <a:extLst>
                  <a:ext uri="{FF2B5EF4-FFF2-40B4-BE49-F238E27FC236}">
                    <a16:creationId xmlns:a16="http://schemas.microsoft.com/office/drawing/2014/main" id="{8C033C97-5FA4-4AC1-B3BA-151D73415C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52738" y="3278188"/>
                <a:ext cx="0" cy="100965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8" name="Line 2718">
                <a:extLst>
                  <a:ext uri="{FF2B5EF4-FFF2-40B4-BE49-F238E27FC236}">
                    <a16:creationId xmlns:a16="http://schemas.microsoft.com/office/drawing/2014/main" id="{D47D2C98-3AFD-4E69-9655-9C11AFA386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4084638"/>
                <a:ext cx="20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9" name="Line 2719">
                <a:extLst>
                  <a:ext uri="{FF2B5EF4-FFF2-40B4-BE49-F238E27FC236}">
                    <a16:creationId xmlns:a16="http://schemas.microsoft.com/office/drawing/2014/main" id="{EAEBDC37-9911-47AB-B481-138B29FE4D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3681413"/>
                <a:ext cx="20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0" name="Line 2720">
                <a:extLst>
                  <a:ext uri="{FF2B5EF4-FFF2-40B4-BE49-F238E27FC236}">
                    <a16:creationId xmlns:a16="http://schemas.microsoft.com/office/drawing/2014/main" id="{BE4A198B-52B0-490A-ACF4-AD5791E696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3278188"/>
                <a:ext cx="20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1" name="Line 2721">
                <a:extLst>
                  <a:ext uri="{FF2B5EF4-FFF2-40B4-BE49-F238E27FC236}">
                    <a16:creationId xmlns:a16="http://schemas.microsoft.com/office/drawing/2014/main" id="{B4A0D1D7-4FEE-4EE0-BBE6-4D85F25BEC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4287838"/>
                <a:ext cx="3968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2" name="Line 2722">
                <a:extLst>
                  <a:ext uri="{FF2B5EF4-FFF2-40B4-BE49-F238E27FC236}">
                    <a16:creationId xmlns:a16="http://schemas.microsoft.com/office/drawing/2014/main" id="{9C558026-25EF-4CFE-8774-E723597426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3884613"/>
                <a:ext cx="3968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3" name="Line 2723">
                <a:extLst>
                  <a:ext uri="{FF2B5EF4-FFF2-40B4-BE49-F238E27FC236}">
                    <a16:creationId xmlns:a16="http://schemas.microsoft.com/office/drawing/2014/main" id="{25A9F1EB-0B70-416E-BD96-694265E2D5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3481388"/>
                <a:ext cx="3968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4" name="Rectangle 2724">
                <a:extLst>
                  <a:ext uri="{FF2B5EF4-FFF2-40B4-BE49-F238E27FC236}">
                    <a16:creationId xmlns:a16="http://schemas.microsoft.com/office/drawing/2014/main" id="{B5C68D79-AF73-4036-AD27-D2F8CEEEF9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3038" y="4230688"/>
                <a:ext cx="138113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Rectangle 2725">
                <a:extLst>
                  <a:ext uri="{FF2B5EF4-FFF2-40B4-BE49-F238E27FC236}">
                    <a16:creationId xmlns:a16="http://schemas.microsoft.com/office/drawing/2014/main" id="{6ADF9097-C276-4F7B-A597-50E63D953B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3038" y="3827463"/>
                <a:ext cx="138113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6" name="Rectangle 2726">
                <a:extLst>
                  <a:ext uri="{FF2B5EF4-FFF2-40B4-BE49-F238E27FC236}">
                    <a16:creationId xmlns:a16="http://schemas.microsoft.com/office/drawing/2014/main" id="{C6B4B354-3EB8-40D3-A385-F7F9AE621D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3038" y="3424238"/>
                <a:ext cx="138113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2828" name="Rectangle 2827">
            <a:extLst>
              <a:ext uri="{FF2B5EF4-FFF2-40B4-BE49-F238E27FC236}">
                <a16:creationId xmlns:a16="http://schemas.microsoft.com/office/drawing/2014/main" id="{B0079132-0CC0-4317-AABE-05FC264C6DDD}"/>
              </a:ext>
            </a:extLst>
          </p:cNvPr>
          <p:cNvSpPr/>
          <p:nvPr/>
        </p:nvSpPr>
        <p:spPr>
          <a:xfrm>
            <a:off x="723254" y="4298062"/>
            <a:ext cx="5434739" cy="2552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3. TCR-CD3</a:t>
            </a:r>
            <a:r>
              <a:rPr lang="el-GR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ζ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onformational changes on glass surface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Representative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3ζ (green) and TCR (red) microclusters on glass surface during transmembrane FRET experiments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at 37 °C for K5 pMHC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b) 3D illustration of the lateral movement (</a:t>
            </a:r>
            <a:r>
              <a:rPr lang="en-US" sz="1200" i="1" dirty="0">
                <a:latin typeface="Times New Roman" charset="0"/>
                <a:ea typeface="Times New Roman" charset="0"/>
                <a:cs typeface="Times New Roman" charset="0"/>
              </a:rPr>
              <a:t>x-y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) and intramolecular distance change (</a:t>
            </a:r>
            <a:r>
              <a:rPr lang="en-US" sz="1200" i="1" dirty="0">
                <a:latin typeface="Times New Roman" charset="0"/>
                <a:ea typeface="Times New Roman" charset="0"/>
                <a:cs typeface="Times New Roman" charset="0"/>
              </a:rPr>
              <a:t>z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) between TCR and CD3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  <a:sym typeface="Symbol" charset="2"/>
              </a:rPr>
              <a:t>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of individual TCR/CD3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  <a:sym typeface="Symbol" charset="2"/>
              </a:rPr>
              <a:t>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microclusters shown in panel (A) on the glass surface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he equilibrium-phase intramolecular TCR-CD3ζ distances induced by different pMHCs on lipid bilayer and glass surface.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6-8 independent experiments were repeated for each pMHC on glass surface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93335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/>
          <p:cNvSpPr/>
          <p:nvPr/>
        </p:nvSpPr>
        <p:spPr>
          <a:xfrm>
            <a:off x="646034" y="2729778"/>
            <a:ext cx="54800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4. CD3ζ phosphorylation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low showing the phosphorylation of CD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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 cells upon contacting antigen-presenting cells loaded with K5, MCC or 102S peptide for 0.5 and 2 mins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EE388A7-BDD6-4767-870F-2AD2EB96289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254" y="646263"/>
            <a:ext cx="4545622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037795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471487" y="4963185"/>
            <a:ext cx="5872829" cy="3647097"/>
            <a:chOff x="304797" y="491769"/>
            <a:chExt cx="5872829" cy="3647097"/>
          </a:xfrm>
        </p:grpSpPr>
        <p:sp>
          <p:nvSpPr>
            <p:cNvPr id="12" name="TextBox 11"/>
            <p:cNvSpPr txBox="1"/>
            <p:nvPr/>
          </p:nvSpPr>
          <p:spPr>
            <a:xfrm>
              <a:off x="812203" y="504209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CC</a:t>
              </a: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7743" y="793997"/>
              <a:ext cx="4855902" cy="1343122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884124" y="1963557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45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09198" y="196355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326084" y="1963557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524542" y="1963557"/>
              <a:ext cx="54053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 (min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50880" y="1240319"/>
              <a:ext cx="4122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27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30425" y="1240319"/>
              <a:ext cx="41549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 cell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5418444" y="2054916"/>
              <a:ext cx="265359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 Box 207"/>
            <p:cNvSpPr txBox="1"/>
            <p:nvPr/>
          </p:nvSpPr>
          <p:spPr>
            <a:xfrm>
              <a:off x="452434" y="702668"/>
              <a:ext cx="333003" cy="21729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endParaRPr 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5708588" y="679882"/>
              <a:ext cx="434734" cy="1369247"/>
              <a:chOff x="5454679" y="358892"/>
              <a:chExt cx="434734" cy="1369247"/>
            </a:xfrm>
          </p:grpSpPr>
          <p:grpSp>
            <p:nvGrpSpPr>
              <p:cNvPr id="43" name="Group 42"/>
              <p:cNvGrpSpPr/>
              <p:nvPr/>
            </p:nvGrpSpPr>
            <p:grpSpPr>
              <a:xfrm>
                <a:off x="5539194" y="583828"/>
                <a:ext cx="307967" cy="1144311"/>
                <a:chOff x="5639957" y="524876"/>
                <a:chExt cx="307967" cy="1144311"/>
              </a:xfrm>
            </p:grpSpPr>
            <p:pic>
              <p:nvPicPr>
                <p:cNvPr id="45" name="Picture 44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639957" y="587858"/>
                  <a:ext cx="135770" cy="1044345"/>
                </a:xfrm>
                <a:prstGeom prst="rect">
                  <a:avLst/>
                </a:prstGeom>
              </p:spPr>
            </p:pic>
            <p:sp>
              <p:nvSpPr>
                <p:cNvPr id="46" name="TextBox 45"/>
                <p:cNvSpPr txBox="1"/>
                <p:nvPr/>
              </p:nvSpPr>
              <p:spPr>
                <a:xfrm>
                  <a:off x="5713564" y="524876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5713564" y="839628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5713564" y="1187721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5713564" y="1469132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  <p:sp>
            <p:nvSpPr>
              <p:cNvPr id="44" name="TextBox 43"/>
              <p:cNvSpPr txBox="1"/>
              <p:nvPr/>
            </p:nvSpPr>
            <p:spPr>
              <a:xfrm>
                <a:off x="5454679" y="358892"/>
                <a:ext cx="434734" cy="253916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F/F</a:t>
                </a:r>
                <a:r>
                  <a:rPr lang="en-US" sz="105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323661" y="49176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304797" y="2446148"/>
              <a:ext cx="5872829" cy="1692718"/>
              <a:chOff x="304797" y="2903348"/>
              <a:chExt cx="5872829" cy="169271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785437" y="2903348"/>
                <a:ext cx="5392189" cy="1692718"/>
                <a:chOff x="785437" y="2080628"/>
                <a:chExt cx="5392189" cy="1692718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785437" y="2080628"/>
                  <a:ext cx="54213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2S</a:t>
                  </a:r>
                </a:p>
              </p:txBody>
            </p:sp>
            <p:grpSp>
              <p:nvGrpSpPr>
                <p:cNvPr id="19" name="Group 18"/>
                <p:cNvGrpSpPr/>
                <p:nvPr/>
              </p:nvGrpSpPr>
              <p:grpSpPr>
                <a:xfrm>
                  <a:off x="856360" y="2355694"/>
                  <a:ext cx="4887285" cy="1417652"/>
                  <a:chOff x="199085" y="4013190"/>
                  <a:chExt cx="5712866" cy="1657126"/>
                </a:xfrm>
              </p:grpSpPr>
              <p:pic>
                <p:nvPicPr>
                  <p:cNvPr id="31" name="Picture 30"/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35770" y="4013190"/>
                    <a:ext cx="5676181" cy="1612552"/>
                  </a:xfrm>
                  <a:prstGeom prst="rect">
                    <a:avLst/>
                  </a:prstGeom>
                </p:spPr>
              </p:pic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199085" y="5436466"/>
                    <a:ext cx="455705" cy="2338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0.43</a:t>
                    </a: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1625458" y="5436467"/>
                    <a:ext cx="273949" cy="2338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3085814" y="5436467"/>
                    <a:ext cx="420104" cy="2338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35</a:t>
                    </a: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4478561" y="5436467"/>
                    <a:ext cx="689929" cy="2338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.15 (min)</a:t>
                    </a:r>
                  </a:p>
                </p:txBody>
              </p:sp>
            </p:grp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5418444" y="3658863"/>
                  <a:ext cx="265359" cy="0"/>
                </a:xfrm>
                <a:prstGeom prst="line">
                  <a:avLst/>
                </a:prstGeom>
                <a:ln w="381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/>
                <p:cNvSpPr txBox="1"/>
                <p:nvPr/>
              </p:nvSpPr>
              <p:spPr>
                <a:xfrm>
                  <a:off x="1065638" y="2844617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27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1545185" y="2844617"/>
                  <a:ext cx="415497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 cell</a:t>
                  </a:r>
                </a:p>
              </p:txBody>
            </p:sp>
            <p:grpSp>
              <p:nvGrpSpPr>
                <p:cNvPr id="50" name="Group 49"/>
                <p:cNvGrpSpPr/>
                <p:nvPr/>
              </p:nvGrpSpPr>
              <p:grpSpPr>
                <a:xfrm>
                  <a:off x="5709804" y="2221599"/>
                  <a:ext cx="467822" cy="1416139"/>
                  <a:chOff x="5454679" y="312000"/>
                  <a:chExt cx="467822" cy="1416139"/>
                </a:xfrm>
              </p:grpSpPr>
              <p:grpSp>
                <p:nvGrpSpPr>
                  <p:cNvPr id="51" name="Group 50"/>
                  <p:cNvGrpSpPr/>
                  <p:nvPr/>
                </p:nvGrpSpPr>
                <p:grpSpPr>
                  <a:xfrm>
                    <a:off x="5539194" y="583828"/>
                    <a:ext cx="383307" cy="1144311"/>
                    <a:chOff x="5639957" y="524876"/>
                    <a:chExt cx="383307" cy="1144311"/>
                  </a:xfrm>
                </p:grpSpPr>
                <p:pic>
                  <p:nvPicPr>
                    <p:cNvPr id="53" name="Picture 52"/>
                    <p:cNvPicPr>
                      <a:picLocks noChangeAspect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639957" y="587858"/>
                      <a:ext cx="135770" cy="104434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4" name="TextBox 53"/>
                    <p:cNvSpPr txBox="1"/>
                    <p:nvPr/>
                  </p:nvSpPr>
                  <p:spPr>
                    <a:xfrm>
                      <a:off x="5713564" y="524876"/>
                      <a:ext cx="30970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</a:p>
                  </p:txBody>
                </p:sp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5713564" y="839628"/>
                      <a:ext cx="23436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5713564" y="1187721"/>
                      <a:ext cx="23436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5713564" y="1469132"/>
                      <a:ext cx="23436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</p:grp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5454679" y="312000"/>
                    <a:ext cx="449162" cy="261610"/>
                  </a:xfrm>
                  <a:prstGeom prst="rect">
                    <a:avLst/>
                  </a:prstGeom>
                  <a:noFill/>
                </p:spPr>
                <p:txBody>
                  <a:bodyPr vert="horz" wrap="none" rtlCol="0">
                    <a:spAutoFit/>
                  </a:bodyPr>
                  <a:lstStyle/>
                  <a:p>
                    <a:r>
                      <a: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/F</a:t>
                    </a:r>
                    <a:r>
                      <a:rPr lang="en-US" sz="11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</p:grpSp>
          <p:sp>
            <p:nvSpPr>
              <p:cNvPr id="59" name="TextBox 58"/>
              <p:cNvSpPr txBox="1"/>
              <p:nvPr/>
            </p:nvSpPr>
            <p:spPr>
              <a:xfrm>
                <a:off x="304797" y="2903348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</p:grp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8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A7C5B3E2-6528-4C1A-AD1B-FEE5ABA0DA52}"/>
              </a:ext>
            </a:extLst>
          </p:cNvPr>
          <p:cNvGrpSpPr/>
          <p:nvPr/>
        </p:nvGrpSpPr>
        <p:grpSpPr>
          <a:xfrm>
            <a:off x="1229996" y="286589"/>
            <a:ext cx="4089708" cy="4582391"/>
            <a:chOff x="974213" y="3930315"/>
            <a:chExt cx="4089708" cy="4582391"/>
          </a:xfrm>
        </p:grpSpPr>
        <p:grpSp>
          <p:nvGrpSpPr>
            <p:cNvPr id="144" name="Group 143">
              <a:extLst>
                <a:ext uri="{FF2B5EF4-FFF2-40B4-BE49-F238E27FC236}">
                  <a16:creationId xmlns:a16="http://schemas.microsoft.com/office/drawing/2014/main" id="{0598B36E-AF1C-4182-9C30-73908C3B605F}"/>
                </a:ext>
              </a:extLst>
            </p:cNvPr>
            <p:cNvGrpSpPr/>
            <p:nvPr/>
          </p:nvGrpSpPr>
          <p:grpSpPr>
            <a:xfrm>
              <a:off x="1928259" y="6737001"/>
              <a:ext cx="3135662" cy="1775705"/>
              <a:chOff x="2000607" y="6644395"/>
              <a:chExt cx="3135662" cy="1775705"/>
            </a:xfrm>
          </p:grpSpPr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A0E5D05F-FB41-45BE-B553-9E9860488C92}"/>
                  </a:ext>
                </a:extLst>
              </p:cNvPr>
              <p:cNvSpPr txBox="1"/>
              <p:nvPr/>
            </p:nvSpPr>
            <p:spPr>
              <a:xfrm>
                <a:off x="2110614" y="7984458"/>
                <a:ext cx="4748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etract</a:t>
                </a:r>
              </a:p>
            </p:txBody>
          </p:sp>
          <p:grpSp>
            <p:nvGrpSpPr>
              <p:cNvPr id="194" name="Group 193">
                <a:extLst>
                  <a:ext uri="{FF2B5EF4-FFF2-40B4-BE49-F238E27FC236}">
                    <a16:creationId xmlns:a16="http://schemas.microsoft.com/office/drawing/2014/main" id="{C461AC00-61E4-4E94-AA5E-608EAC1F1936}"/>
                  </a:ext>
                </a:extLst>
              </p:cNvPr>
              <p:cNvGrpSpPr/>
              <p:nvPr/>
            </p:nvGrpSpPr>
            <p:grpSpPr>
              <a:xfrm>
                <a:off x="2000607" y="6644395"/>
                <a:ext cx="3135662" cy="1775705"/>
                <a:chOff x="1822807" y="6955545"/>
                <a:chExt cx="3135662" cy="1775705"/>
              </a:xfrm>
            </p:grpSpPr>
            <p:sp>
              <p:nvSpPr>
                <p:cNvPr id="197" name="Oval 196">
                  <a:extLst>
                    <a:ext uri="{FF2B5EF4-FFF2-40B4-BE49-F238E27FC236}">
                      <a16:creationId xmlns:a16="http://schemas.microsoft.com/office/drawing/2014/main" id="{68C15E25-D974-46CD-A4C8-7C437DDF34AD}"/>
                    </a:ext>
                  </a:extLst>
                </p:cNvPr>
                <p:cNvSpPr/>
                <p:nvPr/>
              </p:nvSpPr>
              <p:spPr>
                <a:xfrm>
                  <a:off x="2318685" y="7460185"/>
                  <a:ext cx="717631" cy="717631"/>
                </a:xfrm>
                <a:prstGeom prst="ellipse">
                  <a:avLst/>
                </a:prstGeom>
                <a:solidFill>
                  <a:srgbClr val="EA527A"/>
                </a:solidFill>
                <a:ln>
                  <a:noFill/>
                </a:ln>
                <a:scene3d>
                  <a:camera prst="orthographicFront"/>
                  <a:lightRig rig="threePt" dir="t"/>
                </a:scene3d>
                <a:sp3d>
                  <a:bevelT w="356870" h="356870"/>
                  <a:bevelB w="356870" h="35687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98" name="Picture 197">
                  <a:extLst>
                    <a:ext uri="{FF2B5EF4-FFF2-40B4-BE49-F238E27FC236}">
                      <a16:creationId xmlns:a16="http://schemas.microsoft.com/office/drawing/2014/main" id="{97FF1D38-A244-45A7-9D48-A1B45803A5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artisticPencilSketch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87357" y="7435373"/>
                  <a:ext cx="558800" cy="7493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99" name="Rectangle 198">
                  <a:extLst>
                    <a:ext uri="{FF2B5EF4-FFF2-40B4-BE49-F238E27FC236}">
                      <a16:creationId xmlns:a16="http://schemas.microsoft.com/office/drawing/2014/main" id="{762ACB93-316B-4421-B366-F90B0892D892}"/>
                    </a:ext>
                  </a:extLst>
                </p:cNvPr>
                <p:cNvSpPr/>
                <p:nvPr/>
              </p:nvSpPr>
              <p:spPr>
                <a:xfrm>
                  <a:off x="3033186" y="7801764"/>
                  <a:ext cx="182880" cy="9144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00" name="Group 199">
                  <a:extLst>
                    <a:ext uri="{FF2B5EF4-FFF2-40B4-BE49-F238E27FC236}">
                      <a16:creationId xmlns:a16="http://schemas.microsoft.com/office/drawing/2014/main" id="{5CAB5E5A-8FCC-4906-AA24-AE2E05E7BBF5}"/>
                    </a:ext>
                  </a:extLst>
                </p:cNvPr>
                <p:cNvGrpSpPr/>
                <p:nvPr/>
              </p:nvGrpSpPr>
              <p:grpSpPr>
                <a:xfrm>
                  <a:off x="3254558" y="7482085"/>
                  <a:ext cx="1657595" cy="757501"/>
                  <a:chOff x="2110731" y="1131516"/>
                  <a:chExt cx="1657595" cy="757501"/>
                </a:xfrm>
              </p:grpSpPr>
              <p:grpSp>
                <p:nvGrpSpPr>
                  <p:cNvPr id="210" name="Group 209">
                    <a:extLst>
                      <a:ext uri="{FF2B5EF4-FFF2-40B4-BE49-F238E27FC236}">
                        <a16:creationId xmlns:a16="http://schemas.microsoft.com/office/drawing/2014/main" id="{6B328C58-9A40-4A49-836A-C6CC938D6802}"/>
                      </a:ext>
                    </a:extLst>
                  </p:cNvPr>
                  <p:cNvGrpSpPr/>
                  <p:nvPr/>
                </p:nvGrpSpPr>
                <p:grpSpPr>
                  <a:xfrm>
                    <a:off x="2609494" y="1131516"/>
                    <a:ext cx="1158832" cy="757501"/>
                    <a:chOff x="2077059" y="1131516"/>
                    <a:chExt cx="1158832" cy="757501"/>
                  </a:xfrm>
                </p:grpSpPr>
                <p:sp>
                  <p:nvSpPr>
                    <p:cNvPr id="214" name="Oval 213">
                      <a:extLst>
                        <a:ext uri="{FF2B5EF4-FFF2-40B4-BE49-F238E27FC236}">
                          <a16:creationId xmlns:a16="http://schemas.microsoft.com/office/drawing/2014/main" id="{36E2E082-C334-40F9-98C0-BBF9E6D9CC4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77059" y="1131516"/>
                      <a:ext cx="717631" cy="717631"/>
                    </a:xfrm>
                    <a:prstGeom prst="ellipse">
                      <a:avLst/>
                    </a:prstGeom>
                    <a:solidFill>
                      <a:schemeClr val="accent2">
                        <a:lumMod val="75000"/>
                        <a:alpha val="77000"/>
                      </a:schemeClr>
                    </a:solidFill>
                    <a:ln>
                      <a:noFill/>
                    </a:ln>
                    <a:scene3d>
                      <a:camera prst="orthographicFront"/>
                      <a:lightRig rig="threePt" dir="t"/>
                    </a:scene3d>
                    <a:sp3d>
                      <a:bevelT w="356870" h="356870"/>
                      <a:bevelB w="356870" h="356870"/>
                    </a:sp3d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215" name="Picture 214">
                      <a:extLst>
                        <a:ext uri="{FF2B5EF4-FFF2-40B4-BE49-F238E27FC236}">
                          <a16:creationId xmlns:a16="http://schemas.microsoft.com/office/drawing/2014/main" id="{F3FF2B6C-CCAC-4C98-A751-7A63CFB5FEA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>
                      <a:extLst>
                        <a:ext uri="{BEBA8EAE-BF5A-486C-A8C5-ECC9F3942E4B}">
                          <a14:imgProps xmlns:a14="http://schemas.microsoft.com/office/drawing/2010/main">
                            <a14:imgLayer r:embed="rId8">
                              <a14:imgEffect>
                                <a14:artisticLineDrawing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689791" y="1152417"/>
                      <a:ext cx="546100" cy="736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</p:grpSp>
              <p:grpSp>
                <p:nvGrpSpPr>
                  <p:cNvPr id="211" name="Group 210">
                    <a:extLst>
                      <a:ext uri="{FF2B5EF4-FFF2-40B4-BE49-F238E27FC236}">
                        <a16:creationId xmlns:a16="http://schemas.microsoft.com/office/drawing/2014/main" id="{4D072A6B-00D1-4E63-8800-621E7FD79F93}"/>
                      </a:ext>
                    </a:extLst>
                  </p:cNvPr>
                  <p:cNvGrpSpPr/>
                  <p:nvPr/>
                </p:nvGrpSpPr>
                <p:grpSpPr>
                  <a:xfrm>
                    <a:off x="2110731" y="1313651"/>
                    <a:ext cx="489546" cy="338010"/>
                    <a:chOff x="2006556" y="1313651"/>
                    <a:chExt cx="489546" cy="338010"/>
                  </a:xfrm>
                </p:grpSpPr>
                <p:sp>
                  <p:nvSpPr>
                    <p:cNvPr id="212" name="Rectangle 211">
                      <a:extLst>
                        <a:ext uri="{FF2B5EF4-FFF2-40B4-BE49-F238E27FC236}">
                          <a16:creationId xmlns:a16="http://schemas.microsoft.com/office/drawing/2014/main" id="{8CD4AF01-9D73-4486-BE07-18866E8C496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313222" y="1441550"/>
                      <a:ext cx="182880" cy="91440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3" name="Arc 212">
                      <a:extLst>
                        <a:ext uri="{FF2B5EF4-FFF2-40B4-BE49-F238E27FC236}">
                          <a16:creationId xmlns:a16="http://schemas.microsoft.com/office/drawing/2014/main" id="{8016F3CE-1A6E-4B3E-9C61-3DA638A9835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06556" y="1313651"/>
                      <a:ext cx="307282" cy="338010"/>
                    </a:xfrm>
                    <a:prstGeom prst="arc">
                      <a:avLst>
                        <a:gd name="adj1" fmla="val 17691132"/>
                        <a:gd name="adj2" fmla="val 4025380"/>
                      </a:avLst>
                    </a:prstGeom>
                    <a:ln w="222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F15460BC-3A9D-4557-8197-D7BA436D8C27}"/>
                    </a:ext>
                  </a:extLst>
                </p:cNvPr>
                <p:cNvSpPr txBox="1"/>
                <p:nvPr/>
              </p:nvSpPr>
              <p:spPr>
                <a:xfrm>
                  <a:off x="2493739" y="7723544"/>
                  <a:ext cx="37702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RBC</a:t>
                  </a:r>
                </a:p>
              </p:txBody>
            </p:sp>
            <p:cxnSp>
              <p:nvCxnSpPr>
                <p:cNvPr id="202" name="Straight Arrow Connector 201">
                  <a:extLst>
                    <a:ext uri="{FF2B5EF4-FFF2-40B4-BE49-F238E27FC236}">
                      <a16:creationId xmlns:a16="http://schemas.microsoft.com/office/drawing/2014/main" id="{EC8FCFF5-0F7B-43DF-8B3C-1C5017AAF877}"/>
                    </a:ext>
                  </a:extLst>
                </p:cNvPr>
                <p:cNvCxnSpPr/>
                <p:nvPr/>
              </p:nvCxnSpPr>
              <p:spPr>
                <a:xfrm>
                  <a:off x="3111283" y="7327900"/>
                  <a:ext cx="14798" cy="488266"/>
                </a:xfrm>
                <a:prstGeom prst="straightConnector1">
                  <a:avLst/>
                </a:prstGeom>
                <a:ln w="349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7AD1980A-4D91-44E0-AF80-CE7DE7CCD28A}"/>
                    </a:ext>
                  </a:extLst>
                </p:cNvPr>
                <p:cNvSpPr txBox="1"/>
                <p:nvPr/>
              </p:nvSpPr>
              <p:spPr>
                <a:xfrm>
                  <a:off x="2705390" y="7103686"/>
                  <a:ext cx="43794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pMHC</a:t>
                  </a:r>
                </a:p>
              </p:txBody>
            </p:sp>
            <p:sp>
              <p:nvSpPr>
                <p:cNvPr id="204" name="TextBox 203">
                  <a:extLst>
                    <a:ext uri="{FF2B5EF4-FFF2-40B4-BE49-F238E27FC236}">
                      <a16:creationId xmlns:a16="http://schemas.microsoft.com/office/drawing/2014/main" id="{A934ECA1-558C-41EF-893D-40EEABDB72E8}"/>
                    </a:ext>
                  </a:extLst>
                </p:cNvPr>
                <p:cNvSpPr txBox="1"/>
                <p:nvPr/>
              </p:nvSpPr>
              <p:spPr>
                <a:xfrm>
                  <a:off x="3415552" y="7190036"/>
                  <a:ext cx="36740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TCR</a:t>
                  </a:r>
                </a:p>
              </p:txBody>
            </p:sp>
            <p:cxnSp>
              <p:nvCxnSpPr>
                <p:cNvPr id="205" name="Straight Arrow Connector 204">
                  <a:extLst>
                    <a:ext uri="{FF2B5EF4-FFF2-40B4-BE49-F238E27FC236}">
                      <a16:creationId xmlns:a16="http://schemas.microsoft.com/office/drawing/2014/main" id="{8CCA5D26-CF25-44A1-89EB-E191949D3F64}"/>
                    </a:ext>
                  </a:extLst>
                </p:cNvPr>
                <p:cNvCxnSpPr/>
                <p:nvPr/>
              </p:nvCxnSpPr>
              <p:spPr>
                <a:xfrm flipH="1">
                  <a:off x="3577205" y="7441403"/>
                  <a:ext cx="9216" cy="316112"/>
                </a:xfrm>
                <a:prstGeom prst="straightConnector1">
                  <a:avLst/>
                </a:prstGeom>
                <a:ln w="349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8C662556-58C2-48DA-85EB-0CCCA5EA5AE8}"/>
                    </a:ext>
                  </a:extLst>
                </p:cNvPr>
                <p:cNvSpPr txBox="1"/>
                <p:nvPr/>
              </p:nvSpPr>
              <p:spPr>
                <a:xfrm>
                  <a:off x="3898445" y="7732314"/>
                  <a:ext cx="43473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T-Cell</a:t>
                  </a:r>
                </a:p>
              </p:txBody>
            </p:sp>
            <p:sp>
              <p:nvSpPr>
                <p:cNvPr id="207" name="Rectangle 206">
                  <a:extLst>
                    <a:ext uri="{FF2B5EF4-FFF2-40B4-BE49-F238E27FC236}">
                      <a16:creationId xmlns:a16="http://schemas.microsoft.com/office/drawing/2014/main" id="{7A97FFAD-7D31-49E0-823F-99B92A4B0333}"/>
                    </a:ext>
                  </a:extLst>
                </p:cNvPr>
                <p:cNvSpPr/>
                <p:nvPr/>
              </p:nvSpPr>
              <p:spPr>
                <a:xfrm>
                  <a:off x="1822807" y="6955545"/>
                  <a:ext cx="3135662" cy="1775705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F703F086-4936-4B96-850C-5A94574D83C9}"/>
                    </a:ext>
                  </a:extLst>
                </p:cNvPr>
                <p:cNvSpPr txBox="1"/>
                <p:nvPr/>
              </p:nvSpPr>
              <p:spPr>
                <a:xfrm>
                  <a:off x="3956572" y="6984296"/>
                  <a:ext cx="70884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Glass pipette</a:t>
                  </a:r>
                </a:p>
              </p:txBody>
            </p:sp>
            <p:cxnSp>
              <p:nvCxnSpPr>
                <p:cNvPr id="209" name="Straight Arrow Connector 208">
                  <a:extLst>
                    <a:ext uri="{FF2B5EF4-FFF2-40B4-BE49-F238E27FC236}">
                      <a16:creationId xmlns:a16="http://schemas.microsoft.com/office/drawing/2014/main" id="{4FA08B38-E885-4018-AC8D-42A85CF82CD6}"/>
                    </a:ext>
                  </a:extLst>
                </p:cNvPr>
                <p:cNvCxnSpPr/>
                <p:nvPr/>
              </p:nvCxnSpPr>
              <p:spPr>
                <a:xfrm flipH="1">
                  <a:off x="4560185" y="7220423"/>
                  <a:ext cx="9216" cy="316112"/>
                </a:xfrm>
                <a:prstGeom prst="straightConnector1">
                  <a:avLst/>
                </a:prstGeom>
                <a:ln w="349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5" name="Straight Arrow Connector 194">
                <a:extLst>
                  <a:ext uri="{FF2B5EF4-FFF2-40B4-BE49-F238E27FC236}">
                    <a16:creationId xmlns:a16="http://schemas.microsoft.com/office/drawing/2014/main" id="{EF111DAC-3B0E-44D9-8C8F-BCFB79FBB468}"/>
                  </a:ext>
                </a:extLst>
              </p:cNvPr>
              <p:cNvCxnSpPr/>
              <p:nvPr/>
            </p:nvCxnSpPr>
            <p:spPr>
              <a:xfrm>
                <a:off x="2534036" y="8084485"/>
                <a:ext cx="750283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35482A09-48E2-4F00-9C7D-819A0BBF134E}"/>
                  </a:ext>
                </a:extLst>
              </p:cNvPr>
              <p:cNvSpPr txBox="1"/>
              <p:nvPr/>
            </p:nvSpPr>
            <p:spPr>
              <a:xfrm>
                <a:off x="3222635" y="7984458"/>
                <a:ext cx="5657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act</a:t>
                </a:r>
              </a:p>
            </p:txBody>
          </p:sp>
        </p:grpSp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id="{B36F33C0-D8DA-4310-8E95-163F7AD5700C}"/>
                </a:ext>
              </a:extLst>
            </p:cNvPr>
            <p:cNvGrpSpPr/>
            <p:nvPr/>
          </p:nvGrpSpPr>
          <p:grpSpPr>
            <a:xfrm>
              <a:off x="976545" y="3930315"/>
              <a:ext cx="4029883" cy="2602417"/>
              <a:chOff x="964822" y="3977207"/>
              <a:chExt cx="4029883" cy="2602417"/>
            </a:xfrm>
          </p:grpSpPr>
          <p:cxnSp>
            <p:nvCxnSpPr>
              <p:cNvPr id="147" name="Straight Connector 146">
                <a:extLst>
                  <a:ext uri="{FF2B5EF4-FFF2-40B4-BE49-F238E27FC236}">
                    <a16:creationId xmlns:a16="http://schemas.microsoft.com/office/drawing/2014/main" id="{488BC9B9-4C98-4BC5-A4EF-519A28F8AF1A}"/>
                  </a:ext>
                </a:extLst>
              </p:cNvPr>
              <p:cNvCxnSpPr>
                <a:cxnSpLocks/>
                <a:endCxn id="154" idx="1"/>
              </p:cNvCxnSpPr>
              <p:nvPr/>
            </p:nvCxnSpPr>
            <p:spPr>
              <a:xfrm flipV="1">
                <a:off x="3686349" y="4745711"/>
                <a:ext cx="0" cy="1061754"/>
              </a:xfrm>
              <a:prstGeom prst="line">
                <a:avLst/>
              </a:prstGeom>
              <a:ln w="57150">
                <a:solidFill>
                  <a:schemeClr val="accent4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90B8D4D1-EAF2-4ACA-8F40-850687F9F9BE}"/>
                  </a:ext>
                </a:extLst>
              </p:cNvPr>
              <p:cNvSpPr txBox="1"/>
              <p:nvPr/>
            </p:nvSpPr>
            <p:spPr>
              <a:xfrm>
                <a:off x="3920982" y="4257125"/>
                <a:ext cx="107372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cropipette</a:t>
                </a:r>
              </a:p>
            </p:txBody>
          </p:sp>
          <p:sp>
            <p:nvSpPr>
              <p:cNvPr id="149" name="Snip Same Side Corner Rectangle 182">
                <a:extLst>
                  <a:ext uri="{FF2B5EF4-FFF2-40B4-BE49-F238E27FC236}">
                    <a16:creationId xmlns:a16="http://schemas.microsoft.com/office/drawing/2014/main" id="{BE8BA675-3884-4924-A58D-8A7351FB9013}"/>
                  </a:ext>
                </a:extLst>
              </p:cNvPr>
              <p:cNvSpPr/>
              <p:nvPr/>
            </p:nvSpPr>
            <p:spPr>
              <a:xfrm>
                <a:off x="3591842" y="4597916"/>
                <a:ext cx="192992" cy="247345"/>
              </a:xfrm>
              <a:prstGeom prst="snip2SameRect">
                <a:avLst>
                  <a:gd name="adj1" fmla="val 33990"/>
                  <a:gd name="adj2" fmla="val 0"/>
                </a:avLst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id="{23E892AC-D113-4FA6-9E29-1613C9F2A86B}"/>
                  </a:ext>
                </a:extLst>
              </p:cNvPr>
              <p:cNvSpPr/>
              <p:nvPr/>
            </p:nvSpPr>
            <p:spPr>
              <a:xfrm>
                <a:off x="4271858" y="4887782"/>
                <a:ext cx="643367" cy="404832"/>
              </a:xfrm>
              <a:prstGeom prst="rect">
                <a:avLst/>
              </a:prstGeom>
              <a:noFill/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id="{12E6EC0D-0A0B-46AE-892E-EDF702B450BB}"/>
                  </a:ext>
                </a:extLst>
              </p:cNvPr>
              <p:cNvCxnSpPr/>
              <p:nvPr/>
            </p:nvCxnSpPr>
            <p:spPr>
              <a:xfrm>
                <a:off x="3256739" y="4573622"/>
                <a:ext cx="859220" cy="0"/>
              </a:xfrm>
              <a:prstGeom prst="line">
                <a:avLst/>
              </a:prstGeom>
              <a:ln w="349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id="{DC7121E0-10F9-49B2-B888-EA218E9CD8FB}"/>
                  </a:ext>
                </a:extLst>
              </p:cNvPr>
              <p:cNvCxnSpPr/>
              <p:nvPr/>
            </p:nvCxnSpPr>
            <p:spPr>
              <a:xfrm>
                <a:off x="4917200" y="4237485"/>
                <a:ext cx="0" cy="21462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id="{40293862-5593-4720-B48F-42959CA2273D}"/>
                  </a:ext>
                </a:extLst>
              </p:cNvPr>
              <p:cNvCxnSpPr>
                <a:cxnSpLocks/>
                <a:stCxn id="191" idx="3"/>
              </p:cNvCxnSpPr>
              <p:nvPr/>
            </p:nvCxnSpPr>
            <p:spPr>
              <a:xfrm>
                <a:off x="3737349" y="4251517"/>
                <a:ext cx="11778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DD637BC7-07B3-407A-B5A7-85B31A672058}"/>
                  </a:ext>
                </a:extLst>
              </p:cNvPr>
              <p:cNvSpPr txBox="1"/>
              <p:nvPr/>
            </p:nvSpPr>
            <p:spPr>
              <a:xfrm>
                <a:off x="3686349" y="4645683"/>
                <a:ext cx="67602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X Obj.</a:t>
                </a: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470E677E-2419-4B26-9C09-38327266ABE7}"/>
                  </a:ext>
                </a:extLst>
              </p:cNvPr>
              <p:cNvSpPr txBox="1"/>
              <p:nvPr/>
            </p:nvSpPr>
            <p:spPr>
              <a:xfrm>
                <a:off x="3673995" y="4056772"/>
                <a:ext cx="90612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nalog white LED</a:t>
                </a:r>
              </a:p>
            </p:txBody>
          </p:sp>
          <p:grpSp>
            <p:nvGrpSpPr>
              <p:cNvPr id="156" name="Group 155">
                <a:extLst>
                  <a:ext uri="{FF2B5EF4-FFF2-40B4-BE49-F238E27FC236}">
                    <a16:creationId xmlns:a16="http://schemas.microsoft.com/office/drawing/2014/main" id="{7019A7EA-5DC3-4F7F-AE01-60073C7AE72C}"/>
                  </a:ext>
                </a:extLst>
              </p:cNvPr>
              <p:cNvGrpSpPr/>
              <p:nvPr/>
            </p:nvGrpSpPr>
            <p:grpSpPr>
              <a:xfrm>
                <a:off x="3598790" y="4137035"/>
                <a:ext cx="138559" cy="260319"/>
                <a:chOff x="3332837" y="1156785"/>
                <a:chExt cx="138559" cy="260319"/>
              </a:xfrm>
            </p:grpSpPr>
            <p:sp>
              <p:nvSpPr>
                <p:cNvPr id="191" name="Rectangle 190">
                  <a:extLst>
                    <a:ext uri="{FF2B5EF4-FFF2-40B4-BE49-F238E27FC236}">
                      <a16:creationId xmlns:a16="http://schemas.microsoft.com/office/drawing/2014/main" id="{DBECEC23-5741-44CE-B8AD-E9F3635BE83E}"/>
                    </a:ext>
                  </a:extLst>
                </p:cNvPr>
                <p:cNvSpPr/>
                <p:nvPr/>
              </p:nvSpPr>
              <p:spPr>
                <a:xfrm>
                  <a:off x="3332837" y="1156785"/>
                  <a:ext cx="138559" cy="228963"/>
                </a:xfrm>
                <a:prstGeom prst="rect">
                  <a:avLst/>
                </a:prstGeom>
                <a:gradFill flip="none" rotWithShape="1">
                  <a:gsLst>
                    <a:gs pos="39000">
                      <a:schemeClr val="bg1"/>
                    </a:gs>
                    <a:gs pos="97000">
                      <a:schemeClr val="tx1">
                        <a:lumMod val="50000"/>
                        <a:lumOff val="50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Rectangle 191">
                  <a:extLst>
                    <a:ext uri="{FF2B5EF4-FFF2-40B4-BE49-F238E27FC236}">
                      <a16:creationId xmlns:a16="http://schemas.microsoft.com/office/drawing/2014/main" id="{928A3A48-9FBA-427B-8F99-88142E1A4D37}"/>
                    </a:ext>
                  </a:extLst>
                </p:cNvPr>
                <p:cNvSpPr/>
                <p:nvPr/>
              </p:nvSpPr>
              <p:spPr>
                <a:xfrm>
                  <a:off x="3377930" y="1386424"/>
                  <a:ext cx="48928" cy="3068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7" name="Group 156">
                <a:extLst>
                  <a:ext uri="{FF2B5EF4-FFF2-40B4-BE49-F238E27FC236}">
                    <a16:creationId xmlns:a16="http://schemas.microsoft.com/office/drawing/2014/main" id="{C6646E3E-0841-4AB9-9002-4719D21C3D6C}"/>
                  </a:ext>
                </a:extLst>
              </p:cNvPr>
              <p:cNvGrpSpPr/>
              <p:nvPr/>
            </p:nvGrpSpPr>
            <p:grpSpPr>
              <a:xfrm>
                <a:off x="3777198" y="4349327"/>
                <a:ext cx="414550" cy="150883"/>
                <a:chOff x="3534422" y="5541857"/>
                <a:chExt cx="414550" cy="150883"/>
              </a:xfrm>
            </p:grpSpPr>
            <p:cxnSp>
              <p:nvCxnSpPr>
                <p:cNvPr id="189" name="Straight Connector 188">
                  <a:extLst>
                    <a:ext uri="{FF2B5EF4-FFF2-40B4-BE49-F238E27FC236}">
                      <a16:creationId xmlns:a16="http://schemas.microsoft.com/office/drawing/2014/main" id="{F0915D59-5EB5-45F7-9B3A-36949636BCC7}"/>
                    </a:ext>
                  </a:extLst>
                </p:cNvPr>
                <p:cNvCxnSpPr/>
                <p:nvPr/>
              </p:nvCxnSpPr>
              <p:spPr>
                <a:xfrm flipV="1">
                  <a:off x="3539683" y="5541857"/>
                  <a:ext cx="398382" cy="13811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Straight Connector 189">
                  <a:extLst>
                    <a:ext uri="{FF2B5EF4-FFF2-40B4-BE49-F238E27FC236}">
                      <a16:creationId xmlns:a16="http://schemas.microsoft.com/office/drawing/2014/main" id="{968DDF55-8267-4411-8B85-A7200CEC1758}"/>
                    </a:ext>
                  </a:extLst>
                </p:cNvPr>
                <p:cNvCxnSpPr/>
                <p:nvPr/>
              </p:nvCxnSpPr>
              <p:spPr>
                <a:xfrm flipV="1">
                  <a:off x="3534422" y="5598912"/>
                  <a:ext cx="414550" cy="9382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8" name="Group 157">
                <a:extLst>
                  <a:ext uri="{FF2B5EF4-FFF2-40B4-BE49-F238E27FC236}">
                    <a16:creationId xmlns:a16="http://schemas.microsoft.com/office/drawing/2014/main" id="{BC4498BA-17BF-49EA-8109-7C853AF790F7}"/>
                  </a:ext>
                </a:extLst>
              </p:cNvPr>
              <p:cNvGrpSpPr/>
              <p:nvPr/>
            </p:nvGrpSpPr>
            <p:grpSpPr>
              <a:xfrm flipH="1">
                <a:off x="3244200" y="4344213"/>
                <a:ext cx="376798" cy="148502"/>
                <a:chOff x="3517456" y="5522807"/>
                <a:chExt cx="418815" cy="148502"/>
              </a:xfrm>
            </p:grpSpPr>
            <p:cxnSp>
              <p:nvCxnSpPr>
                <p:cNvPr id="187" name="Straight Connector 186">
                  <a:extLst>
                    <a:ext uri="{FF2B5EF4-FFF2-40B4-BE49-F238E27FC236}">
                      <a16:creationId xmlns:a16="http://schemas.microsoft.com/office/drawing/2014/main" id="{927EA401-EA0C-495C-916F-433C735B5740}"/>
                    </a:ext>
                  </a:extLst>
                </p:cNvPr>
                <p:cNvCxnSpPr/>
                <p:nvPr/>
              </p:nvCxnSpPr>
              <p:spPr>
                <a:xfrm flipV="1">
                  <a:off x="3517458" y="5522807"/>
                  <a:ext cx="398382" cy="13811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8" name="Straight Connector 187">
                  <a:extLst>
                    <a:ext uri="{FF2B5EF4-FFF2-40B4-BE49-F238E27FC236}">
                      <a16:creationId xmlns:a16="http://schemas.microsoft.com/office/drawing/2014/main" id="{53F990C0-625F-4250-A6C7-1642F9096271}"/>
                    </a:ext>
                  </a:extLst>
                </p:cNvPr>
                <p:cNvCxnSpPr/>
                <p:nvPr/>
              </p:nvCxnSpPr>
              <p:spPr>
                <a:xfrm flipV="1">
                  <a:off x="3521721" y="5577481"/>
                  <a:ext cx="414550" cy="9382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716B462D-7E5D-41FD-BB6B-6BB6D473DAAE}"/>
                  </a:ext>
                </a:extLst>
              </p:cNvPr>
              <p:cNvCxnSpPr/>
              <p:nvPr/>
            </p:nvCxnSpPr>
            <p:spPr>
              <a:xfrm>
                <a:off x="3684011" y="5070474"/>
                <a:ext cx="586909" cy="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47A1BA56-FEAB-4410-B0AC-DFA2DD47A3B2}"/>
                  </a:ext>
                </a:extLst>
              </p:cNvPr>
              <p:cNvSpPr txBox="1"/>
              <p:nvPr/>
            </p:nvSpPr>
            <p:spPr>
              <a:xfrm>
                <a:off x="4297079" y="4953770"/>
                <a:ext cx="607997" cy="307777"/>
              </a:xfrm>
              <a:prstGeom prst="rect">
                <a:avLst/>
              </a:prstGeom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70 nm 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D</a:t>
                </a:r>
              </a:p>
            </p:txBody>
          </p: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CEFE98B1-59A4-4351-82A6-B2A1E404DE3C}"/>
                  </a:ext>
                </a:extLst>
              </p:cNvPr>
              <p:cNvCxnSpPr/>
              <p:nvPr/>
            </p:nvCxnSpPr>
            <p:spPr>
              <a:xfrm flipV="1">
                <a:off x="3705397" y="4839089"/>
                <a:ext cx="0" cy="226124"/>
              </a:xfrm>
              <a:prstGeom prst="line">
                <a:avLst/>
              </a:prstGeom>
              <a:ln w="57150">
                <a:solidFill>
                  <a:srgbClr val="00B050">
                    <a:alpha val="42000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>
                <a:extLst>
                  <a:ext uri="{FF2B5EF4-FFF2-40B4-BE49-F238E27FC236}">
                    <a16:creationId xmlns:a16="http://schemas.microsoft.com/office/drawing/2014/main" id="{6A3FB18E-B018-4229-B4A3-A27BDA5932FD}"/>
                  </a:ext>
                </a:extLst>
              </p:cNvPr>
              <p:cNvCxnSpPr/>
              <p:nvPr/>
            </p:nvCxnSpPr>
            <p:spPr>
              <a:xfrm>
                <a:off x="3586529" y="4979224"/>
                <a:ext cx="206976" cy="20697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455A6DFE-FA1A-4E98-90C0-C15C6B3F0D28}"/>
                  </a:ext>
                </a:extLst>
              </p:cNvPr>
              <p:cNvCxnSpPr/>
              <p:nvPr/>
            </p:nvCxnSpPr>
            <p:spPr>
              <a:xfrm flipH="1" flipV="1">
                <a:off x="2951315" y="5807465"/>
                <a:ext cx="745463" cy="2"/>
              </a:xfrm>
              <a:prstGeom prst="line">
                <a:avLst/>
              </a:prstGeom>
              <a:ln w="57150">
                <a:solidFill>
                  <a:schemeClr val="accent4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5D523D99-4795-4D7D-8B3E-4D9479033812}"/>
                  </a:ext>
                </a:extLst>
              </p:cNvPr>
              <p:cNvCxnSpPr/>
              <p:nvPr/>
            </p:nvCxnSpPr>
            <p:spPr>
              <a:xfrm flipV="1">
                <a:off x="3625990" y="5720433"/>
                <a:ext cx="172681" cy="16180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96F1944F-6081-4196-812D-A25138E163C0}"/>
                  </a:ext>
                </a:extLst>
              </p:cNvPr>
              <p:cNvSpPr txBox="1"/>
              <p:nvPr/>
            </p:nvSpPr>
            <p:spPr>
              <a:xfrm>
                <a:off x="2009184" y="5631054"/>
                <a:ext cx="927123" cy="246221"/>
              </a:xfrm>
              <a:prstGeom prst="rect">
                <a:avLst/>
              </a:prstGeom>
              <a:noFill/>
              <a:ln w="158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MCCD</a:t>
                </a:r>
              </a:p>
            </p:txBody>
          </p:sp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FA965471-7158-47F2-B49D-7C9C7680CB0D}"/>
                  </a:ext>
                </a:extLst>
              </p:cNvPr>
              <p:cNvCxnSpPr/>
              <p:nvPr/>
            </p:nvCxnSpPr>
            <p:spPr>
              <a:xfrm flipH="1">
                <a:off x="2469850" y="6383772"/>
                <a:ext cx="24537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CC419C67-F18D-4F74-AE4D-2188D831ACE3}"/>
                  </a:ext>
                </a:extLst>
              </p:cNvPr>
              <p:cNvSpPr txBox="1"/>
              <p:nvPr/>
            </p:nvSpPr>
            <p:spPr>
              <a:xfrm>
                <a:off x="3271281" y="6164126"/>
                <a:ext cx="999669" cy="415498"/>
              </a:xfrm>
              <a:prstGeom prst="rect">
                <a:avLst/>
              </a:prstGeom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mputer</a:t>
                </a:r>
              </a:p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8" name="Straight Connector 167">
                <a:extLst>
                  <a:ext uri="{FF2B5EF4-FFF2-40B4-BE49-F238E27FC236}">
                    <a16:creationId xmlns:a16="http://schemas.microsoft.com/office/drawing/2014/main" id="{57834C83-D600-415D-85F6-9BBD9555B7CB}"/>
                  </a:ext>
                </a:extLst>
              </p:cNvPr>
              <p:cNvCxnSpPr>
                <a:cxnSpLocks/>
                <a:stCxn id="165" idx="2"/>
              </p:cNvCxnSpPr>
              <p:nvPr/>
            </p:nvCxnSpPr>
            <p:spPr>
              <a:xfrm flipH="1">
                <a:off x="2469849" y="5877275"/>
                <a:ext cx="2897" cy="51206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D897C774-4D94-44EA-9579-2D0BF97DE8FB}"/>
                  </a:ext>
                </a:extLst>
              </p:cNvPr>
              <p:cNvSpPr txBox="1"/>
              <p:nvPr/>
            </p:nvSpPr>
            <p:spPr>
              <a:xfrm>
                <a:off x="3337661" y="4907070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M</a:t>
                </a:r>
                <a:endPara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2B0F2F2-9D75-464F-A929-1DFA941B53D7}"/>
                  </a:ext>
                </a:extLst>
              </p:cNvPr>
              <p:cNvSpPr txBox="1"/>
              <p:nvPr/>
            </p:nvSpPr>
            <p:spPr>
              <a:xfrm>
                <a:off x="3695127" y="5760778"/>
                <a:ext cx="2600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9C08BD75-8C10-4549-B209-003FBF9E07E9}"/>
                  </a:ext>
                </a:extLst>
              </p:cNvPr>
              <p:cNvSpPr txBox="1"/>
              <p:nvPr/>
            </p:nvSpPr>
            <p:spPr>
              <a:xfrm>
                <a:off x="2953495" y="5434895"/>
                <a:ext cx="6559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oftware 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equencing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162A55A0-75E9-4818-BA52-D24F0C8AAE19}"/>
                  </a:ext>
                </a:extLst>
              </p:cNvPr>
              <p:cNvSpPr txBox="1"/>
              <p:nvPr/>
            </p:nvSpPr>
            <p:spPr>
              <a:xfrm>
                <a:off x="1624425" y="4429833"/>
                <a:ext cx="10737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ustom stage and sample holder</a:t>
                </a:r>
              </a:p>
            </p:txBody>
          </p:sp>
          <p:sp>
            <p:nvSpPr>
              <p:cNvPr id="173" name="Rectangle 172">
                <a:extLst>
                  <a:ext uri="{FF2B5EF4-FFF2-40B4-BE49-F238E27FC236}">
                    <a16:creationId xmlns:a16="http://schemas.microsoft.com/office/drawing/2014/main" id="{42F9DC1E-1C49-41F6-ADC8-249F69602275}"/>
                  </a:ext>
                </a:extLst>
              </p:cNvPr>
              <p:cNvSpPr/>
              <p:nvPr/>
            </p:nvSpPr>
            <p:spPr>
              <a:xfrm rot="907613">
                <a:off x="2855589" y="4258598"/>
                <a:ext cx="402998" cy="11681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D1820C41-D8EA-4736-A41B-7A74E520FF1A}"/>
                  </a:ext>
                </a:extLst>
              </p:cNvPr>
              <p:cNvSpPr txBox="1"/>
              <p:nvPr/>
            </p:nvSpPr>
            <p:spPr>
              <a:xfrm>
                <a:off x="1603989" y="4122056"/>
                <a:ext cx="107372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iezo actuator</a:t>
                </a:r>
              </a:p>
            </p:txBody>
          </p:sp>
          <p:cxnSp>
            <p:nvCxnSpPr>
              <p:cNvPr id="175" name="Straight Arrow Connector 174">
                <a:extLst>
                  <a:ext uri="{FF2B5EF4-FFF2-40B4-BE49-F238E27FC236}">
                    <a16:creationId xmlns:a16="http://schemas.microsoft.com/office/drawing/2014/main" id="{B7F5FE2C-3AAD-47A7-A263-3220041483D6}"/>
                  </a:ext>
                </a:extLst>
              </p:cNvPr>
              <p:cNvCxnSpPr/>
              <p:nvPr/>
            </p:nvCxnSpPr>
            <p:spPr>
              <a:xfrm>
                <a:off x="2434645" y="4231608"/>
                <a:ext cx="389826" cy="3281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Arrow Connector 175">
                <a:extLst>
                  <a:ext uri="{FF2B5EF4-FFF2-40B4-BE49-F238E27FC236}">
                    <a16:creationId xmlns:a16="http://schemas.microsoft.com/office/drawing/2014/main" id="{1C718D35-C8FB-4D41-BD6D-6AE0C5DE4DBB}"/>
                  </a:ext>
                </a:extLst>
              </p:cNvPr>
              <p:cNvCxnSpPr/>
              <p:nvPr/>
            </p:nvCxnSpPr>
            <p:spPr>
              <a:xfrm flipV="1">
                <a:off x="2523929" y="4564518"/>
                <a:ext cx="700341" cy="272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4F96D3ED-3431-46F7-9BC1-ACB219B7D77B}"/>
                  </a:ext>
                </a:extLst>
              </p:cNvPr>
              <p:cNvSpPr txBox="1"/>
              <p:nvPr/>
            </p:nvSpPr>
            <p:spPr>
              <a:xfrm>
                <a:off x="3746920" y="5246672"/>
                <a:ext cx="2984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F</a:t>
                </a:r>
                <a:endPara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8" name="Straight Arrow Connector 177">
                <a:extLst>
                  <a:ext uri="{FF2B5EF4-FFF2-40B4-BE49-F238E27FC236}">
                    <a16:creationId xmlns:a16="http://schemas.microsoft.com/office/drawing/2014/main" id="{B1B6B110-8AA2-412E-9263-EE0D7FFA7DB5}"/>
                  </a:ext>
                </a:extLst>
              </p:cNvPr>
              <p:cNvCxnSpPr/>
              <p:nvPr/>
            </p:nvCxnSpPr>
            <p:spPr>
              <a:xfrm flipH="1">
                <a:off x="3769685" y="4522675"/>
                <a:ext cx="542272" cy="26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6D7ABB53-4661-443C-9184-05CFA769C049}"/>
                  </a:ext>
                </a:extLst>
              </p:cNvPr>
              <p:cNvSpPr txBox="1"/>
              <p:nvPr/>
            </p:nvSpPr>
            <p:spPr>
              <a:xfrm>
                <a:off x="4239262" y="4423105"/>
                <a:ext cx="33614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10B51B0B-B745-49CC-9FFD-A1B2293A01C6}"/>
                  </a:ext>
                </a:extLst>
              </p:cNvPr>
              <p:cNvSpPr txBox="1"/>
              <p:nvPr/>
            </p:nvSpPr>
            <p:spPr>
              <a:xfrm>
                <a:off x="964822" y="3977207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81" name="Rounded Rectangle 233">
                <a:extLst>
                  <a:ext uri="{FF2B5EF4-FFF2-40B4-BE49-F238E27FC236}">
                    <a16:creationId xmlns:a16="http://schemas.microsoft.com/office/drawing/2014/main" id="{273F182C-7434-44B3-9664-66D30490C3BC}"/>
                  </a:ext>
                </a:extLst>
              </p:cNvPr>
              <p:cNvSpPr/>
              <p:nvPr/>
            </p:nvSpPr>
            <p:spPr>
              <a:xfrm>
                <a:off x="3659111" y="5228314"/>
                <a:ext cx="55452" cy="233504"/>
              </a:xfrm>
              <a:prstGeom prst="roundRect">
                <a:avLst/>
              </a:prstGeom>
              <a:solidFill>
                <a:schemeClr val="bg1">
                  <a:lumMod val="75000"/>
                  <a:alpha val="66000"/>
                </a:schemeClr>
              </a:solidFill>
              <a:ln w="12700">
                <a:solidFill>
                  <a:schemeClr val="tx1"/>
                </a:solidFill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Oval 181">
                <a:extLst>
                  <a:ext uri="{FF2B5EF4-FFF2-40B4-BE49-F238E27FC236}">
                    <a16:creationId xmlns:a16="http://schemas.microsoft.com/office/drawing/2014/main" id="{9F3750B1-47C6-427D-82B5-2FB72CC36AC8}"/>
                  </a:ext>
                </a:extLst>
              </p:cNvPr>
              <p:cNvSpPr/>
              <p:nvPr/>
            </p:nvSpPr>
            <p:spPr>
              <a:xfrm>
                <a:off x="3615729" y="4456645"/>
                <a:ext cx="80143" cy="80143"/>
              </a:xfrm>
              <a:prstGeom prst="ellipse">
                <a:avLst/>
              </a:prstGeom>
              <a:solidFill>
                <a:srgbClr val="EA527A"/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38100" h="38100"/>
                <a:bevelB w="356870" h="35687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Oval 182">
                <a:extLst>
                  <a:ext uri="{FF2B5EF4-FFF2-40B4-BE49-F238E27FC236}">
                    <a16:creationId xmlns:a16="http://schemas.microsoft.com/office/drawing/2014/main" id="{666CA792-6800-40F2-9660-3E2575D8E34E}"/>
                  </a:ext>
                </a:extLst>
              </p:cNvPr>
              <p:cNvSpPr/>
              <p:nvPr/>
            </p:nvSpPr>
            <p:spPr>
              <a:xfrm>
                <a:off x="3704282" y="4458005"/>
                <a:ext cx="79587" cy="79587"/>
              </a:xfrm>
              <a:prstGeom prst="ellipse">
                <a:avLst/>
              </a:prstGeom>
              <a:solidFill>
                <a:schemeClr val="accent2">
                  <a:lumMod val="75000"/>
                  <a:alpha val="77000"/>
                </a:schemeClr>
              </a:solidFill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38100" h="38100"/>
                <a:bevelB w="356870" h="35687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5A415930-D47B-4F57-B5BA-DE4BEC3965A9}"/>
                  </a:ext>
                </a:extLst>
              </p:cNvPr>
              <p:cNvSpPr txBox="1"/>
              <p:nvPr/>
            </p:nvSpPr>
            <p:spPr>
              <a:xfrm>
                <a:off x="2364061" y="4656926"/>
                <a:ext cx="94447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bjective Heater</a:t>
                </a:r>
              </a:p>
            </p:txBody>
          </p:sp>
          <p:sp>
            <p:nvSpPr>
              <p:cNvPr id="185" name="Rectangle 184">
                <a:extLst>
                  <a:ext uri="{FF2B5EF4-FFF2-40B4-BE49-F238E27FC236}">
                    <a16:creationId xmlns:a16="http://schemas.microsoft.com/office/drawing/2014/main" id="{BE3631C6-5AE6-43D3-A54F-B3DD0E85F717}"/>
                  </a:ext>
                </a:extLst>
              </p:cNvPr>
              <p:cNvSpPr/>
              <p:nvPr/>
            </p:nvSpPr>
            <p:spPr>
              <a:xfrm>
                <a:off x="3513248" y="4704925"/>
                <a:ext cx="81272" cy="94749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6" name="Straight Arrow Connector 185">
                <a:extLst>
                  <a:ext uri="{FF2B5EF4-FFF2-40B4-BE49-F238E27FC236}">
                    <a16:creationId xmlns:a16="http://schemas.microsoft.com/office/drawing/2014/main" id="{D8EA15F8-176F-46D5-8EA6-E2A5C0085339}"/>
                  </a:ext>
                </a:extLst>
              </p:cNvPr>
              <p:cNvCxnSpPr>
                <a:cxnSpLocks/>
                <a:endCxn id="185" idx="1"/>
              </p:cNvCxnSpPr>
              <p:nvPr/>
            </p:nvCxnSpPr>
            <p:spPr>
              <a:xfrm flipV="1">
                <a:off x="3179820" y="4752300"/>
                <a:ext cx="333428" cy="529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w="sm" len="med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9CE82ABC-7E82-45C4-92D4-87F0E1C12105}"/>
                </a:ext>
              </a:extLst>
            </p:cNvPr>
            <p:cNvSpPr txBox="1"/>
            <p:nvPr/>
          </p:nvSpPr>
          <p:spPr>
            <a:xfrm>
              <a:off x="974213" y="6746642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497591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D2E2B4-81A5-4970-95ED-DAF4290F4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19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B05437C-3486-4355-AEF4-E5C9DFF2B814}"/>
              </a:ext>
            </a:extLst>
          </p:cNvPr>
          <p:cNvSpPr/>
          <p:nvPr/>
        </p:nvSpPr>
        <p:spPr>
          <a:xfrm>
            <a:off x="594360" y="417420"/>
            <a:ext cx="5491825" cy="3660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15. Micropipette assays.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(a</a:t>
            </a:r>
            <a:r>
              <a:rPr lang="en-US" sz="1200" dirty="0">
                <a:latin typeface="Times New Roman" charset="0"/>
                <a:ea typeface="MS Mincho" panose="02020609040205080304" pitchFamily="49" charset="-128"/>
                <a:cs typeface="Times New Roman" charset="0"/>
              </a:rPr>
              <a:t>)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Schematics of fluorescence micropipette for measuring 2D binding kinetics and real-time Ca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2+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signaling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b) Cartoon illustration of 2D kinetic measurements of TCR-pMHC interactions at the cell membrane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MS Mincho" panose="02020609040205080304" pitchFamily="49" charset="-128"/>
                <a:cs typeface="Times New Roman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-d) Real-time Ca</a:t>
            </a:r>
            <a:r>
              <a:rPr lang="en-US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+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signaling at the single-cell level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alcium imaging of a T cell contacting a CH27 cell loaded with MCC (c) or 102S (d)</a:t>
            </a:r>
            <a:r>
              <a:rPr lang="en-US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peptide</a:t>
            </a:r>
            <a:r>
              <a:rPr lang="en-US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measured by fluorescent micropipette at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37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  <a:sym typeface="Symbol" charset="2"/>
              </a:rPr>
              <a:t>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Intracellular high Ca</a:t>
            </a:r>
            <a:r>
              <a:rPr lang="en-US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2+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oncentration was indicated by pseudo (cold to hot) color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signal was recorded by time-lapse fluorescence microscopy and the fold-increase of C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 (F/F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shown by pseudo color. Shown were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representative experiments out of 3-5 independent experiments for each peptide (MCC and 102S). Also see Supplementary Movie 7. Scale bar 10 µm. </a:t>
            </a:r>
          </a:p>
        </p:txBody>
      </p:sp>
    </p:spTree>
    <p:extLst>
      <p:ext uri="{BB962C8B-B14F-4D97-AF65-F5344CB8AC3E}">
        <p14:creationId xmlns:p14="http://schemas.microsoft.com/office/powerpoint/2010/main" val="323513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85800" y="506745"/>
            <a:ext cx="5478780" cy="19981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FRET experimental system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T on glass surface. His-tagged pMHCs and accessory molecules ICAM-1 and B7.1 (not shown) were anchored on the PEG-Ni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ass surface to perform cell surface FRET (FRET1) and transmembrane FRET (FRET2) experiments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b) The diagram illustration of a dual-function TIRF and epi-fluorescence microscope. DM: Dichroic mirror; qDM: quad-band dichroic mirror; L: Lens; qBF: Quad band pass filter, and M: mirror. </a:t>
            </a:r>
            <a:endParaRPr lang="en-US" sz="1200" dirty="0">
              <a:solidFill>
                <a:srgbClr val="FF0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25945421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704849" y="2410221"/>
            <a:ext cx="5406723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16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orrelation between of the half-lives (t</a:t>
            </a:r>
            <a:r>
              <a:rPr lang="en-US" sz="1200" baseline="-25000" dirty="0">
                <a:latin typeface="Times New Roman" panose="02020603050405020304" pitchFamily="18" charset="0"/>
                <a:ea typeface="MS Mincho" panose="02020609040205080304" pitchFamily="49" charset="-128"/>
              </a:rPr>
              <a:t>1/2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 of tetramer staining at 25 </a:t>
            </a:r>
            <a:r>
              <a:rPr lang="en-US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o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 and intermolecular TCR-pMHC distance (a) or intramolecular TCR-CD3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ζ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distance (b). The tetramer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t</a:t>
            </a:r>
            <a:r>
              <a:rPr lang="en-US" sz="1200" baseline="-25000" dirty="0">
                <a:latin typeface="Times New Roman" panose="02020603050405020304" pitchFamily="18" charset="0"/>
                <a:ea typeface="MS Mincho" panose="02020609040205080304" pitchFamily="49" charset="-128"/>
              </a:rPr>
              <a:t>1/2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data was adopted from Corse et al. 2010. 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20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578053" y="956243"/>
            <a:ext cx="3298747" cy="1390848"/>
            <a:chOff x="1578053" y="956243"/>
            <a:chExt cx="3298747" cy="1390848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915"/>
            <a:stretch/>
          </p:blipFill>
          <p:spPr>
            <a:xfrm>
              <a:off x="1673806" y="1181497"/>
              <a:ext cx="3202994" cy="103040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1942058" y="2147036"/>
              <a:ext cx="11560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CR-pMHC distance (Å)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579708" y="1369642"/>
              <a:ext cx="292388" cy="71429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etramer t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/2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s)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578053" y="95624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095865" y="1333209"/>
              <a:ext cx="292388" cy="201337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5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340926" y="1427402"/>
              <a:ext cx="388248" cy="200055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CC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705088" y="1742454"/>
              <a:ext cx="393056" cy="200055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2S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289986" y="983136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RET1</a:t>
              </a:r>
            </a:p>
          </p:txBody>
        </p:sp>
        <p:sp>
          <p:nvSpPr>
            <p:cNvPr id="47" name="Text Box 207"/>
            <p:cNvSpPr txBox="1"/>
            <p:nvPr/>
          </p:nvSpPr>
          <p:spPr>
            <a:xfrm>
              <a:off x="3281698" y="965777"/>
              <a:ext cx="333003" cy="21729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998430" y="1880524"/>
              <a:ext cx="393056" cy="200055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2S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194958" y="1589089"/>
              <a:ext cx="388248" cy="200055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CC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517155" y="1403615"/>
              <a:ext cx="292388" cy="201337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5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903739" y="983136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RET2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269702" y="1370687"/>
              <a:ext cx="292388" cy="71429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etramer t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/2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s)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646686" y="2147036"/>
              <a:ext cx="1120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TCR-CD3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ζ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distance (Å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008039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21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500" y="1120960"/>
            <a:ext cx="2916550" cy="219456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9544" y="1194853"/>
            <a:ext cx="2620964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B2CBC3E-D2C4-4190-AFAC-2DAC03710563}"/>
              </a:ext>
            </a:extLst>
          </p:cNvPr>
          <p:cNvSpPr/>
          <p:nvPr/>
        </p:nvSpPr>
        <p:spPr>
          <a:xfrm>
            <a:off x="599103" y="3522603"/>
            <a:ext cx="5810938" cy="17205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7. </a:t>
            </a:r>
            <a:r>
              <a:rPr lang="en-US" sz="1200" b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cFV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oncentration determination and anisotropy measurement.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a) The concentration saturation curve of H57 scFV. Cy5-labeled H57 scFv was used to stain 5C.C7 T cells at different concentrations. The scFv concentrations were plotted against the fluorescence intensities measured by flow cytometry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b) Anisotropy measurement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nisotropy of scFv(J1)-Cy3, scFv(J3)-Alexa568, pMHC-Cy5, lipid Cy5 and CD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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FP measured in our home-built microscope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8" name="Text Box 207">
            <a:extLst>
              <a:ext uri="{FF2B5EF4-FFF2-40B4-BE49-F238E27FC236}">
                <a16:creationId xmlns:a16="http://schemas.microsoft.com/office/drawing/2014/main" id="{D4566B4F-2015-4351-AE1D-8DD54049C050}"/>
              </a:ext>
            </a:extLst>
          </p:cNvPr>
          <p:cNvSpPr txBox="1"/>
          <p:nvPr/>
        </p:nvSpPr>
        <p:spPr>
          <a:xfrm>
            <a:off x="1232257" y="1056325"/>
            <a:ext cx="333003" cy="21729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78226" tIns="39113" rIns="78226" bIns="39113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684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207">
            <a:extLst>
              <a:ext uri="{FF2B5EF4-FFF2-40B4-BE49-F238E27FC236}">
                <a16:creationId xmlns:a16="http://schemas.microsoft.com/office/drawing/2014/main" id="{9931A7B6-AD57-4F3D-A391-7AD9C30382A7}"/>
              </a:ext>
            </a:extLst>
          </p:cNvPr>
          <p:cNvSpPr txBox="1"/>
          <p:nvPr/>
        </p:nvSpPr>
        <p:spPr>
          <a:xfrm>
            <a:off x="3499785" y="1060942"/>
            <a:ext cx="333003" cy="21729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78226" tIns="39113" rIns="78226" bIns="39113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684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461942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613078" y="541992"/>
            <a:ext cx="5626100" cy="6601492"/>
            <a:chOff x="613078" y="541992"/>
            <a:chExt cx="5626100" cy="6601492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7" name="Rectangle 16"/>
                <p:cNvSpPr/>
                <p:nvPr/>
              </p:nvSpPr>
              <p:spPr>
                <a:xfrm>
                  <a:off x="613078" y="4732375"/>
                  <a:ext cx="5626100" cy="241110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igure S</a:t>
                  </a:r>
                  <a:r>
                    <a:rPr lang="en-US" sz="1200" b="1" dirty="0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18. </a:t>
                  </a:r>
                  <a:r>
                    <a:rPr lang="en-US" sz="1200" b="1" dirty="0" err="1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scFv</a:t>
                  </a:r>
                  <a:r>
                    <a:rPr lang="en-US" sz="1200" b="1" dirty="0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 disassociation calibration for transmembrane FRET </a:t>
                  </a: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sz="1200" dirty="0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(a) A representative time-lapse images of a J3 scFv labelled T cell on the lipid bilayer. Scale bar: 10 µm. Fluorescence intensity was decreasing with time because of the dissociation (and photobleaching) of scFv from TCR. </a:t>
                  </a:r>
                </a:p>
                <a:p>
                  <a:pPr algn="just">
                    <a:lnSpc>
                      <a:spcPct val="150000"/>
                    </a:lnSpc>
                  </a:pPr>
                  <a:r>
                    <a:rPr lang="en-US" sz="1200" dirty="0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(b) The intensity time trajectory was fitted with a first order disassociation model. The half-life was </a:t>
                  </a:r>
                  <a14:m>
                    <m:oMath xmlns:m="http://schemas.openxmlformats.org/officeDocument/2006/math">
                      <m:sSub>
                        <m:sSubPr>
                          <m:ctrlPr>
                            <a:rPr lang="en-US" sz="1200" i="1">
                              <a:latin typeface="Cambria Math" panose="02040503050406030204" pitchFamily="18" charset="0"/>
                              <a:ea typeface="MS Mincho" panose="02020609040205080304" pitchFamily="49" charset="-128"/>
                            </a:rPr>
                          </m:ctrlPr>
                        </m:sSubPr>
                        <m:e>
                          <m:r>
                            <a:rPr lang="en-US" sz="1200" i="1">
                              <a:latin typeface="Cambria Math" panose="02040503050406030204" pitchFamily="18" charset="0"/>
                              <a:ea typeface="MS Mincho" panose="02020609040205080304" pitchFamily="49" charset="-128"/>
                            </a:rPr>
                            <m:t>𝑡</m:t>
                          </m:r>
                        </m:e>
                        <m:sub>
                          <m:r>
                            <a:rPr lang="en-US" sz="1200" i="1">
                              <a:latin typeface="Cambria Math" panose="02040503050406030204" pitchFamily="18" charset="0"/>
                              <a:ea typeface="MS Mincho" panose="02020609040205080304" pitchFamily="49" charset="-128"/>
                            </a:rPr>
                            <m:t>1/2</m:t>
                          </m:r>
                        </m:sub>
                      </m:sSub>
                      <m:r>
                        <a:rPr lang="en-US" sz="1200" i="1">
                          <a:latin typeface="Cambria Math" panose="02040503050406030204" pitchFamily="18" charset="0"/>
                          <a:ea typeface="MS Mincho" panose="02020609040205080304" pitchFamily="49" charset="-128"/>
                        </a:rPr>
                        <m:t>=</m:t>
                      </m:r>
                      <m:f>
                        <m:fPr>
                          <m:ctrlPr>
                            <a:rPr lang="en-US" sz="1200" i="1">
                              <a:latin typeface="Cambria Math" panose="02040503050406030204" pitchFamily="18" charset="0"/>
                              <a:ea typeface="MS Mincho" panose="02020609040205080304" pitchFamily="49" charset="-128"/>
                            </a:rPr>
                          </m:ctrlPr>
                        </m:fPr>
                        <m:num>
                          <m:func>
                            <m:funcPr>
                              <m:ctrlPr>
                                <a:rPr lang="en-US" sz="1200" i="1">
                                  <a:latin typeface="Cambria Math" panose="02040503050406030204" pitchFamily="18" charset="0"/>
                                  <a:ea typeface="MS Mincho" panose="02020609040205080304" pitchFamily="49" charset="-128"/>
                                </a:rPr>
                              </m:ctrlPr>
                            </m:funcPr>
                            <m:fName>
                              <m:r>
                                <m:rPr>
                                  <m:sty m:val="p"/>
                                </m:rPr>
                                <a:rPr lang="en-US" sz="1200">
                                  <a:latin typeface="Cambria Math" panose="02040503050406030204" pitchFamily="18" charset="0"/>
                                  <a:ea typeface="MS Mincho" panose="02020609040205080304" pitchFamily="49" charset="-128"/>
                                </a:rPr>
                                <m:t>ln</m:t>
                              </m:r>
                            </m:fName>
                            <m:e>
                              <m:d>
                                <m:dPr>
                                  <m:ctrlPr>
                                    <a:rPr lang="en-US" sz="1200" i="1">
                                      <a:latin typeface="Cambria Math" panose="02040503050406030204" pitchFamily="18" charset="0"/>
                                      <a:ea typeface="MS Mincho" panose="02020609040205080304" pitchFamily="49" charset="-128"/>
                                    </a:rPr>
                                  </m:ctrlPr>
                                </m:dPr>
                                <m:e>
                                  <m:r>
                                    <a:rPr lang="en-US" sz="1200" i="1">
                                      <a:latin typeface="Cambria Math" panose="02040503050406030204" pitchFamily="18" charset="0"/>
                                      <a:ea typeface="MS Mincho" panose="02020609040205080304" pitchFamily="49" charset="-128"/>
                                    </a:rPr>
                                    <m:t>2</m:t>
                                  </m:r>
                                </m:e>
                              </m:d>
                            </m:e>
                          </m:func>
                        </m:num>
                        <m:den>
                          <m:r>
                            <a:rPr lang="en-US" sz="1200" i="1">
                              <a:latin typeface="Cambria Math" panose="02040503050406030204" pitchFamily="18" charset="0"/>
                              <a:ea typeface="MS Mincho" panose="02020609040205080304" pitchFamily="49" charset="-128"/>
                            </a:rPr>
                            <m:t>0.173</m:t>
                          </m:r>
                        </m:den>
                      </m:f>
                      <m:r>
                        <a:rPr lang="en-US" sz="1200" i="1">
                          <a:latin typeface="Cambria Math" panose="02040503050406030204" pitchFamily="18" charset="0"/>
                          <a:ea typeface="MS Mincho" panose="02020609040205080304" pitchFamily="49" charset="-128"/>
                        </a:rPr>
                        <m:t>=4</m:t>
                      </m:r>
                    </m:oMath>
                  </a14:m>
                  <a:r>
                    <a:rPr lang="en-US" sz="1200" dirty="0">
                      <a:latin typeface="Times New Roman" panose="02020603050405020304" pitchFamily="18" charset="0"/>
                      <a:ea typeface="MS Mincho" panose="02020609040205080304" pitchFamily="49" charset="-128"/>
                    </a:rPr>
                    <a:t> miniutes. Each data point was the average value of 50 independent measurements. The J3-Alexa568 intensities in transmembrane FRET experiments were corrected based on the dissociation kinetics of J3 scFv.</a:t>
                  </a:r>
                </a:p>
              </p:txBody>
            </p:sp>
          </mc:Choice>
          <mc:Fallback xmlns="">
            <p:sp>
              <p:nvSpPr>
                <p:cNvPr id="17" name="Rectangle 16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13078" y="4732375"/>
                  <a:ext cx="5626100" cy="2411109"/>
                </a:xfrm>
                <a:prstGeom prst="rect">
                  <a:avLst/>
                </a:prstGeom>
                <a:blipFill>
                  <a:blip r:embed="rId2"/>
                  <a:stretch>
                    <a:fillRect l="-108" r="-108" b="-101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grpSp>
          <p:nvGrpSpPr>
            <p:cNvPr id="12" name="Group 11"/>
            <p:cNvGrpSpPr/>
            <p:nvPr/>
          </p:nvGrpSpPr>
          <p:grpSpPr>
            <a:xfrm>
              <a:off x="732644" y="541992"/>
              <a:ext cx="5405322" cy="3832474"/>
              <a:chOff x="732644" y="541992"/>
              <a:chExt cx="5405322" cy="3832474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950715" y="2100328"/>
                <a:ext cx="3431764" cy="2274138"/>
                <a:chOff x="1532666" y="3140601"/>
                <a:chExt cx="3431764" cy="2274138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1532666" y="3150369"/>
                  <a:ext cx="2792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94301" y="3140601"/>
                  <a:ext cx="2728965" cy="2274138"/>
                </a:xfrm>
                <a:prstGeom prst="rect">
                  <a:avLst/>
                </a:prstGeom>
              </p:spPr>
            </p:pic>
            <p:sp>
              <p:nvSpPr>
                <p:cNvPr id="4" name="TextBox 3"/>
                <p:cNvSpPr txBox="1"/>
                <p:nvPr/>
              </p:nvSpPr>
              <p:spPr>
                <a:xfrm>
                  <a:off x="3051727" y="3302809"/>
                  <a:ext cx="191270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                                                 </a:t>
                  </a:r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732644" y="541992"/>
                <a:ext cx="5405322" cy="1179385"/>
                <a:chOff x="732644" y="541992"/>
                <a:chExt cx="5405322" cy="1179385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950715" y="54199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50715" y="982476"/>
                  <a:ext cx="4950827" cy="482067"/>
                </a:xfrm>
                <a:prstGeom prst="rect">
                  <a:avLst/>
                </a:prstGeom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732644" y="1444378"/>
                  <a:ext cx="8249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charset="0"/>
                      <a:ea typeface="Arial" charset="0"/>
                      <a:cs typeface="Arial" charset="0"/>
                    </a:rPr>
                    <a:t>Time = 0 </a:t>
                  </a: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007424" y="1413103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charset="0"/>
                      <a:ea typeface="Arial" charset="0"/>
                      <a:cs typeface="Arial" charset="0"/>
                    </a:rPr>
                    <a:t>10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5347365" y="1438823"/>
                  <a:ext cx="7906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charset="0"/>
                      <a:ea typeface="Arial" charset="0"/>
                      <a:cs typeface="Arial" charset="0"/>
                    </a:rPr>
                    <a:t>20 (Min.)</a:t>
                  </a:r>
                </a:p>
              </p:txBody>
            </p:sp>
          </p:grpSp>
        </p:grpSp>
        <p:cxnSp>
          <p:nvCxnSpPr>
            <p:cNvPr id="16" name="Straight Connector 15"/>
            <p:cNvCxnSpPr/>
            <p:nvPr/>
          </p:nvCxnSpPr>
          <p:spPr>
            <a:xfrm>
              <a:off x="997668" y="1417048"/>
              <a:ext cx="250614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" name="TextBox 2"/>
                <p:cNvSpPr txBox="1"/>
                <p:nvPr/>
              </p:nvSpPr>
              <p:spPr>
                <a:xfrm>
                  <a:off x="2614012" y="2357501"/>
                  <a:ext cx="1969578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dirty="0"/>
                    <a:t>I </a:t>
                  </a:r>
                  <a14:m>
                    <m:oMath xmlns:m="http://schemas.openxmlformats.org/officeDocument/2006/math">
                      <m:r>
                        <a:rPr lang="mr-IN" sz="1200" i="1" smtClean="0">
                          <a:latin typeface="Cambria Math" charset="0"/>
                        </a:rPr>
                        <m:t>=</m:t>
                      </m:r>
                    </m:oMath>
                  </a14:m>
                  <a:r>
                    <a:rPr lang="en-US" sz="1200" dirty="0"/>
                    <a:t> 0.2392 x </a:t>
                  </a:r>
                  <a14:m>
                    <m:oMath xmlns:m="http://schemas.openxmlformats.org/officeDocument/2006/math">
                      <m:sSup>
                        <m:sSupPr>
                          <m:ctrlPr>
                            <a:rPr lang="en-US" sz="1200" i="1" smtClean="0">
                              <a:latin typeface="Cambria Math" panose="02040503050406030204" pitchFamily="18" charset="0"/>
                            </a:rPr>
                          </m:ctrlPr>
                        </m:sSupPr>
                        <m:e>
                          <m:r>
                            <a:rPr lang="en-US" sz="1200" b="0" i="1" smtClean="0">
                              <a:latin typeface="Cambria Math" charset="0"/>
                            </a:rPr>
                            <m:t>𝑒</m:t>
                          </m:r>
                        </m:e>
                        <m:sup>
                          <m:r>
                            <a:rPr lang="en-US" sz="1200" b="0" i="1" smtClean="0">
                              <a:latin typeface="Cambria Math" charset="0"/>
                            </a:rPr>
                            <m:t>−0.173</m:t>
                          </m:r>
                          <m:r>
                            <a:rPr lang="en-US" sz="1200" b="0" i="1" smtClean="0">
                              <a:latin typeface="Cambria Math" charset="0"/>
                            </a:rPr>
                            <m:t>𝑡</m:t>
                          </m:r>
                          <m:r>
                            <a:rPr lang="en-US" sz="1200" b="0" i="1" smtClean="0">
                              <a:latin typeface="Cambria Math" charset="0"/>
                            </a:rPr>
                            <m:t> </m:t>
                          </m:r>
                        </m:sup>
                      </m:sSup>
                      <m:r>
                        <a:rPr lang="en-US" sz="1200" b="0" i="1" smtClean="0">
                          <a:latin typeface="Cambria Math" charset="0"/>
                        </a:rPr>
                        <m:t>+0.7364</m:t>
                      </m:r>
                    </m:oMath>
                  </a14:m>
                  <a:endParaRPr lang="en-US" sz="1200" dirty="0"/>
                </a:p>
              </p:txBody>
            </p:sp>
          </mc:Choice>
          <mc:Fallback xmlns="">
            <p:sp>
              <p:nvSpPr>
                <p:cNvPr id="3" name="TextBox 2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614012" y="2357501"/>
                  <a:ext cx="1969578" cy="184666"/>
                </a:xfrm>
                <a:prstGeom prst="rect">
                  <a:avLst/>
                </a:prstGeom>
                <a:blipFill rotWithShape="0">
                  <a:blip r:embed="rId5"/>
                  <a:stretch>
                    <a:fillRect l="-4954" t="-110000" r="-2167" b="-9333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14" name="Slide Number Placeholder 1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22</a:t>
            </a:r>
          </a:p>
        </p:txBody>
      </p:sp>
    </p:spTree>
    <p:extLst>
      <p:ext uri="{BB962C8B-B14F-4D97-AF65-F5344CB8AC3E}">
        <p14:creationId xmlns:p14="http://schemas.microsoft.com/office/powerpoint/2010/main" val="391986912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23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708915"/>
              </p:ext>
            </p:extLst>
          </p:nvPr>
        </p:nvGraphicFramePr>
        <p:xfrm>
          <a:off x="561975" y="1516836"/>
          <a:ext cx="5640704" cy="3108500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7791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81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35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026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026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845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5655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i="1" kern="1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200" kern="1600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i="1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200" kern="16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i="1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6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i="1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200" kern="16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×10</a:t>
                      </a:r>
                      <a:r>
                        <a:rPr lang="en-US" sz="1200" kern="16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i="1" kern="16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200" kern="1600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f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i="1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6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i="1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US" sz="1200" kern="16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</a:t>
                      </a: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×10</a:t>
                      </a:r>
                      <a:r>
                        <a:rPr lang="en-US" sz="1200" kern="16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5772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.6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6±7.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±0.3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5±12.4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43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8±10.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±0.9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5±22.6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9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8±14.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±0.49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2±20.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5772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C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6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9.46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7±1.7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±0.37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5±3.40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6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45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±4.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±0.38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±3.39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6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3±4.4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0±1.91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9±7.44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5772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S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3.01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±0.3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±0.76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±0.9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.68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±0.6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±0.81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4±1.03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57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34</a:t>
                      </a:r>
                      <a:endParaRPr lang="en-US" sz="1200" b="1" kern="16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.92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0±0.5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2±1.85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200" kern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6±1.67</a:t>
                      </a:r>
                      <a:endParaRPr lang="en-US" sz="1200" b="1" kern="16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787657" y="962838"/>
            <a:ext cx="350710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. 2D kinetic parameters</a:t>
            </a:r>
            <a:endParaRPr kumimoji="0" lang="en-US" altLang="en-US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8579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lide Number Placeholder 40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3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1163264" y="439594"/>
            <a:ext cx="4730943" cy="7158648"/>
            <a:chOff x="682975" y="402650"/>
            <a:chExt cx="4730943" cy="7158648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61" t="24040" r="34854" b="14823"/>
            <a:stretch/>
          </p:blipFill>
          <p:spPr>
            <a:xfrm>
              <a:off x="832381" y="3071593"/>
              <a:ext cx="1324437" cy="1083037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06"/>
            <a:stretch/>
          </p:blipFill>
          <p:spPr>
            <a:xfrm>
              <a:off x="933666" y="1878724"/>
              <a:ext cx="1108043" cy="1151844"/>
            </a:xfrm>
            <a:prstGeom prst="rect">
              <a:avLst/>
            </a:prstGeom>
          </p:spPr>
        </p:pic>
        <p:sp>
          <p:nvSpPr>
            <p:cNvPr id="8" name="Text Box 217"/>
            <p:cNvSpPr txBox="1"/>
            <p:nvPr/>
          </p:nvSpPr>
          <p:spPr>
            <a:xfrm>
              <a:off x="695467" y="2967443"/>
              <a:ext cx="254694" cy="26101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0" name="Text Box 215"/>
            <p:cNvSpPr txBox="1"/>
            <p:nvPr/>
          </p:nvSpPr>
          <p:spPr>
            <a:xfrm>
              <a:off x="682975" y="1872779"/>
              <a:ext cx="494331" cy="32256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" name="Text Box 211"/>
            <p:cNvSpPr txBox="1"/>
            <p:nvPr/>
          </p:nvSpPr>
          <p:spPr>
            <a:xfrm>
              <a:off x="3465038" y="402650"/>
              <a:ext cx="213355" cy="1392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9" name="Text Box 207"/>
            <p:cNvSpPr txBox="1"/>
            <p:nvPr/>
          </p:nvSpPr>
          <p:spPr>
            <a:xfrm>
              <a:off x="1978101" y="402650"/>
              <a:ext cx="322842" cy="25410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8" name="Text Box 207"/>
            <p:cNvSpPr txBox="1"/>
            <p:nvPr/>
          </p:nvSpPr>
          <p:spPr>
            <a:xfrm>
              <a:off x="692495" y="402650"/>
              <a:ext cx="322842" cy="25410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3543729" y="652112"/>
              <a:ext cx="1431054" cy="966940"/>
              <a:chOff x="177934" y="3570236"/>
              <a:chExt cx="2862370" cy="1725326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177934" y="3570236"/>
                <a:ext cx="2793996" cy="1725326"/>
                <a:chOff x="399008" y="3657073"/>
                <a:chExt cx="3935399" cy="2034445"/>
              </a:xfrm>
            </p:grpSpPr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231" t="20727" r="9692" b="15152"/>
                <a:stretch/>
              </p:blipFill>
              <p:spPr>
                <a:xfrm>
                  <a:off x="399010" y="3657073"/>
                  <a:ext cx="3935397" cy="1957099"/>
                </a:xfrm>
                <a:prstGeom prst="rect">
                  <a:avLst/>
                </a:prstGeom>
              </p:spPr>
            </p:pic>
            <p:cxnSp>
              <p:nvCxnSpPr>
                <p:cNvPr id="15" name="Straight Connector 14"/>
                <p:cNvCxnSpPr/>
                <p:nvPr/>
              </p:nvCxnSpPr>
              <p:spPr>
                <a:xfrm flipV="1">
                  <a:off x="2681218" y="4776153"/>
                  <a:ext cx="1616145" cy="91536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399008" y="4853964"/>
                  <a:ext cx="2263956" cy="83755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 flipV="1">
                  <a:off x="399008" y="3923607"/>
                  <a:ext cx="1" cy="93035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" name="TextBox 11"/>
              <p:cNvSpPr txBox="1"/>
              <p:nvPr/>
            </p:nvSpPr>
            <p:spPr>
              <a:xfrm rot="19272724">
                <a:off x="2167548" y="4772320"/>
                <a:ext cx="872756" cy="35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7 µm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127054">
                <a:off x="345451" y="4833499"/>
                <a:ext cx="872756" cy="35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0 µm</a:t>
                </a:r>
              </a:p>
            </p:txBody>
          </p:sp>
        </p:grp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88129" y="604108"/>
              <a:ext cx="1147695" cy="1030074"/>
            </a:xfrm>
            <a:prstGeom prst="rect">
              <a:avLst/>
            </a:prstGeom>
          </p:spPr>
        </p:pic>
        <p:grpSp>
          <p:nvGrpSpPr>
            <p:cNvPr id="47" name="Group 46"/>
            <p:cNvGrpSpPr/>
            <p:nvPr/>
          </p:nvGrpSpPr>
          <p:grpSpPr>
            <a:xfrm>
              <a:off x="743268" y="603419"/>
              <a:ext cx="1209995" cy="1015633"/>
              <a:chOff x="-789701" y="633894"/>
              <a:chExt cx="1209995" cy="1015633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-176045" y="1013502"/>
                <a:ext cx="29367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5</a:t>
                </a:r>
              </a:p>
            </p:txBody>
          </p:sp>
          <p:grpSp>
            <p:nvGrpSpPr>
              <p:cNvPr id="40" name="Group 39"/>
              <p:cNvGrpSpPr/>
              <p:nvPr/>
            </p:nvGrpSpPr>
            <p:grpSpPr>
              <a:xfrm>
                <a:off x="-789701" y="633894"/>
                <a:ext cx="1209995" cy="1015633"/>
                <a:chOff x="6258868" y="616881"/>
                <a:chExt cx="1209995" cy="1015633"/>
              </a:xfrm>
            </p:grpSpPr>
            <p:pic>
              <p:nvPicPr>
                <p:cNvPr id="43" name="Picture 42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435370" y="760573"/>
                  <a:ext cx="1033493" cy="762000"/>
                </a:xfrm>
                <a:prstGeom prst="rect">
                  <a:avLst/>
                </a:prstGeom>
              </p:spPr>
            </p:pic>
            <p:grpSp>
              <p:nvGrpSpPr>
                <p:cNvPr id="18" name="Group 17"/>
                <p:cNvGrpSpPr/>
                <p:nvPr/>
              </p:nvGrpSpPr>
              <p:grpSpPr>
                <a:xfrm>
                  <a:off x="6258868" y="616881"/>
                  <a:ext cx="1039890" cy="1015633"/>
                  <a:chOff x="6258868" y="616881"/>
                  <a:chExt cx="1039890" cy="1015633"/>
                </a:xfrm>
              </p:grpSpPr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6725371" y="1432459"/>
                    <a:ext cx="573387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ime (m)</a:t>
                    </a: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6258868" y="616881"/>
                    <a:ext cx="292388" cy="905056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ized Intensity</a:t>
                    </a:r>
                  </a:p>
                </p:txBody>
              </p:sp>
            </p:grpSp>
          </p:grpSp>
        </p:grpSp>
        <p:sp>
          <p:nvSpPr>
            <p:cNvPr id="49" name="TextBox 48"/>
            <p:cNvSpPr txBox="1"/>
            <p:nvPr/>
          </p:nvSpPr>
          <p:spPr>
            <a:xfrm>
              <a:off x="1285596" y="1096181"/>
              <a:ext cx="4635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RAP</a:t>
              </a:r>
            </a:p>
          </p:txBody>
        </p:sp>
        <p:grpSp>
          <p:nvGrpSpPr>
            <p:cNvPr id="53" name="Group 52"/>
            <p:cNvGrpSpPr/>
            <p:nvPr/>
          </p:nvGrpSpPr>
          <p:grpSpPr>
            <a:xfrm>
              <a:off x="2064126" y="1842109"/>
              <a:ext cx="3349792" cy="2424060"/>
              <a:chOff x="434557" y="1723739"/>
              <a:chExt cx="3349792" cy="2424060"/>
            </a:xfrm>
          </p:grpSpPr>
          <p:sp>
            <p:nvSpPr>
              <p:cNvPr id="20" name="Text Box 217"/>
              <p:cNvSpPr txBox="1"/>
              <p:nvPr/>
            </p:nvSpPr>
            <p:spPr>
              <a:xfrm>
                <a:off x="434557" y="1749522"/>
                <a:ext cx="331704" cy="21689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78226" tIns="39113" rIns="78226" bIns="39113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684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sp>
            <p:nvSpPr>
              <p:cNvPr id="25" name="Text Box 212"/>
              <p:cNvSpPr txBox="1"/>
              <p:nvPr/>
            </p:nvSpPr>
            <p:spPr>
              <a:xfrm>
                <a:off x="2085379" y="1723739"/>
                <a:ext cx="332625" cy="217047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78226" tIns="39113" rIns="78226" bIns="39113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684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87895" y="1898869"/>
                <a:ext cx="1496454" cy="2248930"/>
              </a:xfrm>
              <a:prstGeom prst="rect">
                <a:avLst/>
              </a:prstGeom>
            </p:spPr>
          </p:pic>
          <p:pic>
            <p:nvPicPr>
              <p:cNvPr id="51" name="Picture 50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45" t="7453" r="22743" b="23645"/>
              <a:stretch/>
            </p:blipFill>
            <p:spPr>
              <a:xfrm>
                <a:off x="531515" y="1796160"/>
                <a:ext cx="1558553" cy="2312691"/>
              </a:xfrm>
              <a:prstGeom prst="rect">
                <a:avLst/>
              </a:prstGeom>
            </p:spPr>
          </p:pic>
        </p:grpSp>
        <p:sp>
          <p:nvSpPr>
            <p:cNvPr id="23" name="Text Box 212"/>
            <p:cNvSpPr txBox="1"/>
            <p:nvPr/>
          </p:nvSpPr>
          <p:spPr>
            <a:xfrm>
              <a:off x="684913" y="4254403"/>
              <a:ext cx="302137" cy="19715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1812666" y="5280217"/>
              <a:ext cx="143425" cy="745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2" r="15079"/>
            <a:stretch/>
          </p:blipFill>
          <p:spPr>
            <a:xfrm>
              <a:off x="959794" y="4344908"/>
              <a:ext cx="1654473" cy="1467318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4049103" y="5060025"/>
              <a:ext cx="819025" cy="313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SD</a:t>
              </a:r>
            </a:p>
          </p:txBody>
        </p:sp>
        <p:sp>
          <p:nvSpPr>
            <p:cNvPr id="24" name="Text Box 212"/>
            <p:cNvSpPr txBox="1"/>
            <p:nvPr/>
          </p:nvSpPr>
          <p:spPr>
            <a:xfrm>
              <a:off x="2674580" y="4254403"/>
              <a:ext cx="345462" cy="2254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 err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</a:t>
              </a:r>
              <a:endPara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386906" y="4462177"/>
              <a:ext cx="662198" cy="2075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xperiment</a:t>
              </a:r>
            </a:p>
          </p:txBody>
        </p:sp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32284" y="6024599"/>
              <a:ext cx="1762123" cy="1373552"/>
            </a:xfrm>
            <a:prstGeom prst="rect">
              <a:avLst/>
            </a:prstGeom>
          </p:spPr>
        </p:pic>
        <p:grpSp>
          <p:nvGrpSpPr>
            <p:cNvPr id="33" name="Group 32"/>
            <p:cNvGrpSpPr/>
            <p:nvPr/>
          </p:nvGrpSpPr>
          <p:grpSpPr>
            <a:xfrm>
              <a:off x="855564" y="6019630"/>
              <a:ext cx="1697930" cy="1541668"/>
              <a:chOff x="180761" y="1595802"/>
              <a:chExt cx="4067898" cy="3693525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1291751" y="4727192"/>
                <a:ext cx="2549655" cy="562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 coordinate (µm)</a:t>
                </a:r>
              </a:p>
            </p:txBody>
          </p:sp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17" t="13559" r="7545" b="12802"/>
              <a:stretch/>
            </p:blipFill>
            <p:spPr>
              <a:xfrm>
                <a:off x="798092" y="1595802"/>
                <a:ext cx="3450567" cy="3131389"/>
              </a:xfrm>
              <a:prstGeom prst="rect">
                <a:avLst/>
              </a:prstGeom>
            </p:spPr>
          </p:pic>
          <p:sp>
            <p:nvSpPr>
              <p:cNvPr id="36" name="TextBox 35"/>
              <p:cNvSpPr txBox="1"/>
              <p:nvPr/>
            </p:nvSpPr>
            <p:spPr>
              <a:xfrm>
                <a:off x="180761" y="2102326"/>
                <a:ext cx="800951" cy="221560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 coordinate (µm)</a:t>
                </a:r>
              </a:p>
            </p:txBody>
          </p:sp>
        </p:grpSp>
        <p:sp>
          <p:nvSpPr>
            <p:cNvPr id="28" name="Text Box 214"/>
            <p:cNvSpPr txBox="1"/>
            <p:nvPr/>
          </p:nvSpPr>
          <p:spPr>
            <a:xfrm>
              <a:off x="743721" y="5853251"/>
              <a:ext cx="262785" cy="1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29" name="Text Box 214"/>
            <p:cNvSpPr txBox="1"/>
            <p:nvPr/>
          </p:nvSpPr>
          <p:spPr>
            <a:xfrm>
              <a:off x="2639588" y="5882435"/>
              <a:ext cx="262785" cy="1714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78226" tIns="39113" rIns="78226" bIns="391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684"/>
                </a:spcAft>
              </a:pPr>
              <a:r>
                <a:rPr lang="en-US" sz="12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523833" y="6043283"/>
              <a:ext cx="474626" cy="1578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imulation</a:t>
              </a: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94" t="6204" r="52192" b="45266"/>
            <a:stretch/>
          </p:blipFill>
          <p:spPr>
            <a:xfrm>
              <a:off x="2780189" y="4435108"/>
              <a:ext cx="1655233" cy="13758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432416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76275" y="657344"/>
            <a:ext cx="5495926" cy="58760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Single-molecule quantification of IE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K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pMHCs on lipid bilayer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a) Fluorescence recovery after photo-bleaching (FRAP) of fluorescent pMHCs bound to lipid bilayer to test the fluidity of a bilayer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b) A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representative TIRF image of single Cy3-labelled His</a:t>
            </a:r>
            <a:r>
              <a:rPr lang="en-US" sz="1200" baseline="-25000" dirty="0">
                <a:latin typeface="Times New Roman" charset="0"/>
                <a:ea typeface="Times New Roman" charset="0"/>
                <a:cs typeface="Times New Roman" charset="0"/>
              </a:rPr>
              <a:t>12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-K5-IE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k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pMHCs on mobile lipid bilayer. Each white spot represents a single fluorescent pMHC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c) 3D fluorescence intensity profiles of single pMHCs shown in B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d) A representative 2D intensity profile of a single pMHC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e) The same molecule in d was fitted with a 3D Gaussian function to determine the full width at half maximum (FWHM), a value of 263 nm. This was comparable to the diffraction limit spot size (187 nm) for the 532-nm excitation laser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f) Single-step photobleaching confirmed the detection of single pMHCs on lipid bilayer. Representative single-step bleaching of three single Cy3-labelled His</a:t>
            </a:r>
            <a:r>
              <a:rPr lang="en-US" sz="1200" baseline="-25000" dirty="0">
                <a:latin typeface="Times New Roman" charset="0"/>
                <a:ea typeface="Times New Roman" charset="0"/>
                <a:cs typeface="Times New Roman" charset="0"/>
              </a:rPr>
              <a:t>12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-K5-IE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k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pMHC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molecules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g) The stability test of the 532-nm laser by examining the intensity profile of a standard fluorescence bead under continuous illumination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h-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i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) The diffusion of single pMHCs on lipid bilayer was tracked by a Fiji plugin TrackMate software (H) and the diffusion was quantified by a mean-square distance (MSD) plot (I). Also see Supplementary Movie 1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j-k) </a:t>
            </a:r>
            <a:r>
              <a:rPr lang="en-US" sz="1200" i="1" dirty="0">
                <a:latin typeface="Times New Roman" charset="0"/>
                <a:ea typeface="Times New Roman" charset="0"/>
                <a:cs typeface="Times New Roman" charset="0"/>
              </a:rPr>
              <a:t>In silico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imulated pMHC diffusion on lipid bilayer using a TrackArt program and the resulted MSD plot. The diffusion coefficients obtained from experiments and simulation were 0.57 ± 0.06 and 0.59 ± 0.09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  <a:sym typeface="Symbol" charset="2"/>
              </a:rPr>
              <a:t>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m/s, respectively.    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5301663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52509" y="6475734"/>
            <a:ext cx="5464082" cy="23443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charset="0"/>
                <a:cs typeface="Times New Roman" charset="0"/>
              </a:rPr>
              <a:t>3.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Transmembrane FRET is specific to GFP/Alexa568 FRET pair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a)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Microclusters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are signaling hotspot. CD3</a:t>
            </a:r>
            <a:r>
              <a:rPr lang="el-GR" sz="1200" dirty="0">
                <a:latin typeface="Times New Roman" charset="0"/>
                <a:ea typeface="Times New Roman" charset="0"/>
                <a:cs typeface="Times New Roman" charset="0"/>
              </a:rPr>
              <a:t>ζ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-GFP signals inside and outside of the microclusters. 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b) No FRET is detected when Alexa568 is replaced by Cy5. A 470-nm LED light was used to excite GFP and measure Cy5 emission. CD3</a:t>
            </a:r>
            <a:r>
              <a:rPr lang="el-GR" sz="1200" dirty="0">
                <a:latin typeface="Times New Roman" charset="0"/>
                <a:ea typeface="Times New Roman" charset="0"/>
                <a:cs typeface="Times New Roman" charset="0"/>
              </a:rPr>
              <a:t>ζ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is tagged with GFP and TCR is labeled by Cy5 through J3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scFV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. Top row: DIC; Middle row: GFP emission; Bottom row: Cy5 emission. </a:t>
            </a:r>
          </a:p>
          <a:p>
            <a:pPr algn="just">
              <a:lnSpc>
                <a:spcPct val="200000"/>
              </a:lnSpc>
            </a:pP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853734" y="2571588"/>
            <a:ext cx="3853904" cy="3630430"/>
            <a:chOff x="853734" y="2571588"/>
            <a:chExt cx="3853904" cy="363043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9634" y="3006395"/>
              <a:ext cx="1033272" cy="103327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5906" y="3006395"/>
              <a:ext cx="1033272" cy="103327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4366" y="3006395"/>
              <a:ext cx="1033272" cy="103327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9634" y="4073399"/>
              <a:ext cx="1033272" cy="103327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5906" y="4073399"/>
              <a:ext cx="1033272" cy="103327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4366" y="4073399"/>
              <a:ext cx="1033272" cy="103327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9">
              <a:duotone>
                <a:prstClr val="black"/>
                <a:srgbClr val="D9C3A5">
                  <a:tint val="50000"/>
                  <a:satMod val="18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9634" y="5168746"/>
              <a:ext cx="1033272" cy="103327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0">
              <a:duotone>
                <a:prstClr val="black"/>
                <a:srgbClr val="D9C3A5">
                  <a:tint val="50000"/>
                  <a:satMod val="18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5906" y="5168746"/>
              <a:ext cx="1033272" cy="103327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1">
              <a:duotone>
                <a:prstClr val="black"/>
                <a:srgbClr val="D9C3A5">
                  <a:tint val="50000"/>
                  <a:satMod val="18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4366" y="5168746"/>
              <a:ext cx="1033272" cy="1033272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936444" y="3395007"/>
              <a:ext cx="3978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T cell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853734" y="4534933"/>
              <a:ext cx="6715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CD3</a:t>
              </a:r>
              <a:r>
                <a:rPr lang="en-US" sz="700" dirty="0">
                  <a:latin typeface="Arial" charset="0"/>
                  <a:ea typeface="Arial" charset="0"/>
                  <a:cs typeface="Arial" charset="0"/>
                  <a:sym typeface="Symbol" charset="2"/>
                </a:rPr>
                <a:t></a:t>
              </a:r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-GFP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66285" y="5564153"/>
              <a:ext cx="5565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TCR-Cy5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30429" y="2792342"/>
              <a:ext cx="3048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1 s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50461" y="2792342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3 min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866459" y="2792342"/>
              <a:ext cx="4796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charset="0"/>
                  <a:ea typeface="Arial" charset="0"/>
                  <a:cs typeface="Arial" charset="0"/>
                </a:rPr>
                <a:t>9.5 min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906748" y="2571588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918198" y="494051"/>
            <a:ext cx="3355214" cy="1821814"/>
            <a:chOff x="918198" y="494051"/>
            <a:chExt cx="3355214" cy="1821814"/>
          </a:xfrm>
        </p:grpSpPr>
        <p:sp>
          <p:nvSpPr>
            <p:cNvPr id="26" name="TextBox 25"/>
            <p:cNvSpPr txBox="1"/>
            <p:nvPr/>
          </p:nvSpPr>
          <p:spPr>
            <a:xfrm>
              <a:off x="918198" y="68194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1651418" y="675249"/>
              <a:ext cx="2120288" cy="1640616"/>
              <a:chOff x="1607272" y="635845"/>
              <a:chExt cx="2120288" cy="1640616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2336728" y="1963893"/>
                <a:ext cx="668773" cy="30777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nside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crocluster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896827" y="1968684"/>
                <a:ext cx="668773" cy="30777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utside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icrocluster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607272" y="1197750"/>
                <a:ext cx="292388" cy="33919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</a:p>
            </p:txBody>
          </p:sp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9660" y="635845"/>
                <a:ext cx="1827900" cy="1409700"/>
              </a:xfrm>
              <a:prstGeom prst="rect">
                <a:avLst/>
              </a:prstGeom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2594641" y="698497"/>
                <a:ext cx="437940" cy="200055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 = 22</a:t>
                </a:r>
              </a:p>
            </p:txBody>
          </p:sp>
        </p:grpSp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3343" y="494051"/>
              <a:ext cx="790069" cy="887809"/>
            </a:xfrm>
            <a:prstGeom prst="rect">
              <a:avLst/>
            </a:prstGeom>
          </p:spPr>
        </p:pic>
        <p:sp>
          <p:nvSpPr>
            <p:cNvPr id="35" name="Oval 34"/>
            <p:cNvSpPr/>
            <p:nvPr/>
          </p:nvSpPr>
          <p:spPr>
            <a:xfrm>
              <a:off x="3609746" y="842433"/>
              <a:ext cx="117814" cy="116507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 flipV="1">
              <a:off x="2800350" y="908050"/>
              <a:ext cx="831850" cy="59690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Oval 37"/>
            <p:cNvSpPr/>
            <p:nvPr/>
          </p:nvSpPr>
          <p:spPr>
            <a:xfrm>
              <a:off x="3606571" y="1140884"/>
              <a:ext cx="83670" cy="82742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 flipV="1">
              <a:off x="3384550" y="1200150"/>
              <a:ext cx="247650" cy="6731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Slide Number Placeholder 1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6447814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77334" y="5318693"/>
            <a:ext cx="5506350" cy="14441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Co-localization between TCRs and pMHCs on lipid bilayer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Representative co-localization between TCR(s) and pMHC(s) in single-molecule (a) and ensemble (b) FRET experiments. Line scan was used to indicate the fluorescence profile and co-localization for both single-molecule (a) and ensemble (b) FRET. Scale bar is 5 µm.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6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1835858" y="852687"/>
            <a:ext cx="3585046" cy="4115102"/>
            <a:chOff x="1360729" y="852687"/>
            <a:chExt cx="3585046" cy="4115102"/>
          </a:xfrm>
        </p:grpSpPr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8125A511-8FC8-BA4F-A0EC-2F828D70A775}"/>
                </a:ext>
              </a:extLst>
            </p:cNvPr>
            <p:cNvGrpSpPr/>
            <p:nvPr/>
          </p:nvGrpSpPr>
          <p:grpSpPr>
            <a:xfrm>
              <a:off x="1361698" y="852687"/>
              <a:ext cx="3347704" cy="1980936"/>
              <a:chOff x="1041893" y="674227"/>
              <a:chExt cx="3347704" cy="1980936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822145C3-BAA3-934F-837F-CC16DEE1A965}"/>
                  </a:ext>
                </a:extLst>
              </p:cNvPr>
              <p:cNvSpPr txBox="1"/>
              <p:nvPr/>
            </p:nvSpPr>
            <p:spPr>
              <a:xfrm>
                <a:off x="1041893" y="674227"/>
                <a:ext cx="312906" cy="276999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 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ED12240-91AB-A842-B77A-100886BE1983}"/>
                  </a:ext>
                </a:extLst>
              </p:cNvPr>
              <p:cNvSpPr txBox="1"/>
              <p:nvPr/>
            </p:nvSpPr>
            <p:spPr>
              <a:xfrm>
                <a:off x="2859716" y="2455108"/>
                <a:ext cx="86938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on (µm)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E81FA8F1-DD71-FC4A-A28A-D5881F8FC630}"/>
                  </a:ext>
                </a:extLst>
              </p:cNvPr>
              <p:cNvSpPr txBox="1"/>
              <p:nvPr/>
            </p:nvSpPr>
            <p:spPr>
              <a:xfrm>
                <a:off x="1088535" y="1690907"/>
                <a:ext cx="400110" cy="837294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</a:t>
                </a:r>
              </a:p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</a:p>
            </p:txBody>
          </p:sp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1E96D6DB-D491-1C49-A992-39A109C4BC69}"/>
                  </a:ext>
                </a:extLst>
              </p:cNvPr>
              <p:cNvGrpSpPr/>
              <p:nvPr/>
            </p:nvGrpSpPr>
            <p:grpSpPr>
              <a:xfrm>
                <a:off x="1550285" y="678120"/>
                <a:ext cx="818504" cy="910149"/>
                <a:chOff x="1550285" y="667268"/>
                <a:chExt cx="818504" cy="910149"/>
              </a:xfrm>
            </p:grpSpPr>
            <p:pic>
              <p:nvPicPr>
                <p:cNvPr id="117" name="Picture 116">
                  <a:extLst>
                    <a:ext uri="{FF2B5EF4-FFF2-40B4-BE49-F238E27FC236}">
                      <a16:creationId xmlns:a16="http://schemas.microsoft.com/office/drawing/2014/main" id="{404350EE-1E14-0E43-A853-8751B1B098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50285" y="848204"/>
                  <a:ext cx="818504" cy="729213"/>
                </a:xfrm>
                <a:prstGeom prst="rect">
                  <a:avLst/>
                </a:prstGeom>
              </p:spPr>
            </p:pic>
            <p:grpSp>
              <p:nvGrpSpPr>
                <p:cNvPr id="118" name="Group 117">
                  <a:extLst>
                    <a:ext uri="{FF2B5EF4-FFF2-40B4-BE49-F238E27FC236}">
                      <a16:creationId xmlns:a16="http://schemas.microsoft.com/office/drawing/2014/main" id="{A8A04879-C44D-2E4A-9B3E-4E891B23FC8F}"/>
                    </a:ext>
                  </a:extLst>
                </p:cNvPr>
                <p:cNvGrpSpPr/>
                <p:nvPr/>
              </p:nvGrpSpPr>
              <p:grpSpPr>
                <a:xfrm>
                  <a:off x="1758280" y="667268"/>
                  <a:ext cx="464742" cy="898529"/>
                  <a:chOff x="1758280" y="667268"/>
                  <a:chExt cx="464742" cy="898529"/>
                </a:xfrm>
              </p:grpSpPr>
              <p:sp>
                <p:nvSpPr>
                  <p:cNvPr id="119" name="TextBox 118">
                    <a:extLst>
                      <a:ext uri="{FF2B5EF4-FFF2-40B4-BE49-F238E27FC236}">
                        <a16:creationId xmlns:a16="http://schemas.microsoft.com/office/drawing/2014/main" id="{897C3B05-A892-874E-B206-D30507D6884D}"/>
                      </a:ext>
                    </a:extLst>
                  </p:cNvPr>
                  <p:cNvSpPr txBox="1"/>
                  <p:nvPr/>
                </p:nvSpPr>
                <p:spPr>
                  <a:xfrm>
                    <a:off x="1758280" y="667268"/>
                    <a:ext cx="46474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MHC</a:t>
                    </a:r>
                  </a:p>
                </p:txBody>
              </p:sp>
              <p:cxnSp>
                <p:nvCxnSpPr>
                  <p:cNvPr id="120" name="Straight Connector 119">
                    <a:extLst>
                      <a:ext uri="{FF2B5EF4-FFF2-40B4-BE49-F238E27FC236}">
                        <a16:creationId xmlns:a16="http://schemas.microsoft.com/office/drawing/2014/main" id="{A2C56002-C3C7-6C41-A720-2712EAAD19F6}"/>
                      </a:ext>
                    </a:extLst>
                  </p:cNvPr>
                  <p:cNvCxnSpPr/>
                  <p:nvPr/>
                </p:nvCxnSpPr>
                <p:spPr>
                  <a:xfrm>
                    <a:off x="1821340" y="864929"/>
                    <a:ext cx="105328" cy="700868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27696885-5CDC-6643-AE8F-ADBA4BF09D7E}"/>
                  </a:ext>
                </a:extLst>
              </p:cNvPr>
              <p:cNvGrpSpPr/>
              <p:nvPr/>
            </p:nvGrpSpPr>
            <p:grpSpPr>
              <a:xfrm>
                <a:off x="2782956" y="674227"/>
                <a:ext cx="818504" cy="917935"/>
                <a:chOff x="2452015" y="659482"/>
                <a:chExt cx="818504" cy="917935"/>
              </a:xfrm>
            </p:grpSpPr>
            <p:pic>
              <p:nvPicPr>
                <p:cNvPr id="114" name="Picture 113">
                  <a:extLst>
                    <a:ext uri="{FF2B5EF4-FFF2-40B4-BE49-F238E27FC236}">
                      <a16:creationId xmlns:a16="http://schemas.microsoft.com/office/drawing/2014/main" id="{A0DF6777-1B79-614E-8733-286F5C1AA4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52015" y="848204"/>
                  <a:ext cx="818504" cy="729213"/>
                </a:xfrm>
                <a:prstGeom prst="rect">
                  <a:avLst/>
                </a:prstGeom>
              </p:spPr>
            </p:pic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EE5C24E5-6E6D-FB4D-84DE-0B1F14D7B70C}"/>
                    </a:ext>
                  </a:extLst>
                </p:cNvPr>
                <p:cNvSpPr txBox="1"/>
                <p:nvPr/>
              </p:nvSpPr>
              <p:spPr>
                <a:xfrm>
                  <a:off x="2662272" y="659482"/>
                  <a:ext cx="4647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CR</a:t>
                  </a:r>
                </a:p>
              </p:txBody>
            </p:sp>
            <p:cxnSp>
              <p:nvCxnSpPr>
                <p:cNvPr id="116" name="Straight Connector 115">
                  <a:extLst>
                    <a:ext uri="{FF2B5EF4-FFF2-40B4-BE49-F238E27FC236}">
                      <a16:creationId xmlns:a16="http://schemas.microsoft.com/office/drawing/2014/main" id="{6E310EE1-3E58-6A45-847E-0CCAC781A36C}"/>
                    </a:ext>
                  </a:extLst>
                </p:cNvPr>
                <p:cNvCxnSpPr/>
                <p:nvPr/>
              </p:nvCxnSpPr>
              <p:spPr>
                <a:xfrm>
                  <a:off x="2716782" y="852229"/>
                  <a:ext cx="105328" cy="7008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5" name="Group 104">
                <a:extLst>
                  <a:ext uri="{FF2B5EF4-FFF2-40B4-BE49-F238E27FC236}">
                    <a16:creationId xmlns:a16="http://schemas.microsoft.com/office/drawing/2014/main" id="{FB2E5ECC-2751-4341-A553-22861D93858E}"/>
                  </a:ext>
                </a:extLst>
              </p:cNvPr>
              <p:cNvGrpSpPr/>
              <p:nvPr/>
            </p:nvGrpSpPr>
            <p:grpSpPr>
              <a:xfrm>
                <a:off x="3412394" y="874795"/>
                <a:ext cx="977203" cy="700868"/>
                <a:chOff x="2741105" y="862376"/>
                <a:chExt cx="977203" cy="700868"/>
              </a:xfrm>
            </p:grpSpPr>
            <p:cxnSp>
              <p:nvCxnSpPr>
                <p:cNvPr id="110" name="Straight Connector 109">
                  <a:extLst>
                    <a:ext uri="{FF2B5EF4-FFF2-40B4-BE49-F238E27FC236}">
                      <a16:creationId xmlns:a16="http://schemas.microsoft.com/office/drawing/2014/main" id="{D01598EE-7265-744A-BD36-774E739AE0CB}"/>
                    </a:ext>
                  </a:extLst>
                </p:cNvPr>
                <p:cNvCxnSpPr/>
                <p:nvPr/>
              </p:nvCxnSpPr>
              <p:spPr>
                <a:xfrm>
                  <a:off x="2741105" y="1504649"/>
                  <a:ext cx="156452" cy="0"/>
                </a:xfrm>
                <a:prstGeom prst="line">
                  <a:avLst/>
                </a:prstGeom>
                <a:ln w="381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Straight Connector 110">
                  <a:extLst>
                    <a:ext uri="{FF2B5EF4-FFF2-40B4-BE49-F238E27FC236}">
                      <a16:creationId xmlns:a16="http://schemas.microsoft.com/office/drawing/2014/main" id="{38C3A692-DAD7-914F-A2A7-CF4F5F72260A}"/>
                    </a:ext>
                  </a:extLst>
                </p:cNvPr>
                <p:cNvCxnSpPr/>
                <p:nvPr/>
              </p:nvCxnSpPr>
              <p:spPr>
                <a:xfrm>
                  <a:off x="3612980" y="862376"/>
                  <a:ext cx="105328" cy="7008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BB56F81B-043C-ED41-97DE-0226C59FC5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 flipH="1" flipV="1">
                <a:off x="1550285" y="1866434"/>
                <a:ext cx="723900" cy="558800"/>
              </a:xfrm>
              <a:prstGeom prst="rect">
                <a:avLst/>
              </a:prstGeom>
            </p:spPr>
          </p:pic>
          <p:pic>
            <p:nvPicPr>
              <p:cNvPr id="108" name="Picture 107">
                <a:extLst>
                  <a:ext uri="{FF2B5EF4-FFF2-40B4-BE49-F238E27FC236}">
                    <a16:creationId xmlns:a16="http://schemas.microsoft.com/office/drawing/2014/main" id="{60442641-F49B-C14D-BF1B-C2EF38CE82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 flipH="1" flipV="1">
                <a:off x="2796859" y="1866433"/>
                <a:ext cx="723900" cy="558800"/>
              </a:xfrm>
              <a:prstGeom prst="rect">
                <a:avLst/>
              </a:prstGeom>
            </p:spPr>
          </p:pic>
        </p:grp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E66D1E4-ED87-1140-B3A5-9CB2EA93AF0F}"/>
                </a:ext>
              </a:extLst>
            </p:cNvPr>
            <p:cNvSpPr txBox="1"/>
            <p:nvPr/>
          </p:nvSpPr>
          <p:spPr>
            <a:xfrm>
              <a:off x="1360729" y="2914682"/>
              <a:ext cx="246337" cy="28020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620D54A-A230-7946-B0A2-3C594B794913}"/>
                </a:ext>
              </a:extLst>
            </p:cNvPr>
            <p:cNvSpPr txBox="1"/>
            <p:nvPr/>
          </p:nvSpPr>
          <p:spPr>
            <a:xfrm>
              <a:off x="3229564" y="4767734"/>
              <a:ext cx="8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osition (µm)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EBC95068-7E1F-6645-9FFC-95EE436F3AC0}"/>
                </a:ext>
              </a:extLst>
            </p:cNvPr>
            <p:cNvSpPr txBox="1"/>
            <p:nvPr/>
          </p:nvSpPr>
          <p:spPr>
            <a:xfrm>
              <a:off x="1400537" y="3872032"/>
              <a:ext cx="400110" cy="837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ormalized 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ignal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1872712" y="2917959"/>
              <a:ext cx="3073063" cy="1029278"/>
              <a:chOff x="1872712" y="2917959"/>
              <a:chExt cx="3073063" cy="1029278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A2A17320-8111-1140-83F8-B7261496F2D4}"/>
                  </a:ext>
                </a:extLst>
              </p:cNvPr>
              <p:cNvGrpSpPr/>
              <p:nvPr/>
            </p:nvGrpSpPr>
            <p:grpSpPr>
              <a:xfrm>
                <a:off x="2632400" y="3071571"/>
                <a:ext cx="385049" cy="875666"/>
                <a:chOff x="2312595" y="3288532"/>
                <a:chExt cx="385049" cy="875666"/>
              </a:xfrm>
            </p:grpSpPr>
            <p:pic>
              <p:nvPicPr>
                <p:cNvPr id="94" name="Picture 93">
                  <a:extLst>
                    <a:ext uri="{FF2B5EF4-FFF2-40B4-BE49-F238E27FC236}">
                      <a16:creationId xmlns:a16="http://schemas.microsoft.com/office/drawing/2014/main" id="{3CFA10BE-F4C7-C343-837C-2B1DAE6239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273" t="2915" r="63328" b="2258"/>
                <a:stretch/>
              </p:blipFill>
              <p:spPr>
                <a:xfrm>
                  <a:off x="2312595" y="3339570"/>
                  <a:ext cx="108927" cy="777750"/>
                </a:xfrm>
                <a:prstGeom prst="rect">
                  <a:avLst/>
                </a:prstGeom>
              </p:spPr>
            </p:pic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2D584529-9B61-5C49-8063-2E0532B984D3}"/>
                    </a:ext>
                  </a:extLst>
                </p:cNvPr>
                <p:cNvSpPr txBox="1"/>
                <p:nvPr/>
              </p:nvSpPr>
              <p:spPr>
                <a:xfrm>
                  <a:off x="2330236" y="3964143"/>
                  <a:ext cx="34817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w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9A0224C2-A330-9546-8795-32ED73B77205}"/>
                    </a:ext>
                  </a:extLst>
                </p:cNvPr>
                <p:cNvSpPr txBox="1"/>
                <p:nvPr/>
              </p:nvSpPr>
              <p:spPr>
                <a:xfrm>
                  <a:off x="2330236" y="3288532"/>
                  <a:ext cx="36740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gh</a:t>
                  </a:r>
                </a:p>
              </p:txBody>
            </p:sp>
          </p:grp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A6810E69-0128-C947-AF68-0F7F95476D76}"/>
                  </a:ext>
                </a:extLst>
              </p:cNvPr>
              <p:cNvGrpSpPr/>
              <p:nvPr/>
            </p:nvGrpSpPr>
            <p:grpSpPr>
              <a:xfrm>
                <a:off x="3959125" y="3062535"/>
                <a:ext cx="367408" cy="875666"/>
                <a:chOff x="2330236" y="3288532"/>
                <a:chExt cx="367408" cy="875666"/>
              </a:xfrm>
            </p:grpSpPr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A11F360C-7F11-7444-A252-8915CE44A503}"/>
                    </a:ext>
                  </a:extLst>
                </p:cNvPr>
                <p:cNvSpPr txBox="1"/>
                <p:nvPr/>
              </p:nvSpPr>
              <p:spPr>
                <a:xfrm>
                  <a:off x="2330236" y="3964143"/>
                  <a:ext cx="34817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w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4D35A5AF-76C5-B341-A8D6-6642DA1875DA}"/>
                    </a:ext>
                  </a:extLst>
                </p:cNvPr>
                <p:cNvSpPr txBox="1"/>
                <p:nvPr/>
              </p:nvSpPr>
              <p:spPr>
                <a:xfrm>
                  <a:off x="2330236" y="3288532"/>
                  <a:ext cx="36740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gh</a:t>
                  </a: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1872712" y="2917959"/>
                <a:ext cx="3073063" cy="975952"/>
                <a:chOff x="1872712" y="2917959"/>
                <a:chExt cx="3073063" cy="975952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83189" y="3142199"/>
                  <a:ext cx="727910" cy="727910"/>
                </a:xfrm>
                <a:prstGeom prst="rect">
                  <a:avLst/>
                </a:prstGeom>
              </p:spPr>
            </p:pic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72712" y="3156376"/>
                  <a:ext cx="727910" cy="727910"/>
                </a:xfrm>
                <a:prstGeom prst="rect">
                  <a:avLst/>
                </a:prstGeom>
              </p:spPr>
            </p:pic>
            <p:cxnSp>
              <p:nvCxnSpPr>
                <p:cNvPr id="66" name="Straight Connector 65">
                  <a:extLst>
                    <a:ext uri="{FF2B5EF4-FFF2-40B4-BE49-F238E27FC236}">
                      <a16:creationId xmlns:a16="http://schemas.microsoft.com/office/drawing/2014/main" id="{B2041949-8B33-B84C-B442-9DB277C808F9}"/>
                    </a:ext>
                  </a:extLst>
                </p:cNvPr>
                <p:cNvCxnSpPr/>
                <p:nvPr/>
              </p:nvCxnSpPr>
              <p:spPr>
                <a:xfrm>
                  <a:off x="2109231" y="3183061"/>
                  <a:ext cx="267496" cy="693312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8B04A7E5-EC7F-F84E-BAE7-B4320C98824B}"/>
                    </a:ext>
                  </a:extLst>
                </p:cNvPr>
                <p:cNvSpPr txBox="1"/>
                <p:nvPr/>
              </p:nvSpPr>
              <p:spPr>
                <a:xfrm>
                  <a:off x="1993948" y="2924549"/>
                  <a:ext cx="4647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MHC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D7436439-9E90-9546-968D-7182407A5032}"/>
                    </a:ext>
                  </a:extLst>
                </p:cNvPr>
                <p:cNvSpPr txBox="1"/>
                <p:nvPr/>
              </p:nvSpPr>
              <p:spPr>
                <a:xfrm>
                  <a:off x="3313018" y="2917959"/>
                  <a:ext cx="4647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CR</a:t>
                  </a:r>
                </a:p>
              </p:txBody>
            </p:sp>
            <p:cxnSp>
              <p:nvCxnSpPr>
                <p:cNvPr id="98" name="Straight Connector 97">
                  <a:extLst>
                    <a:ext uri="{FF2B5EF4-FFF2-40B4-BE49-F238E27FC236}">
                      <a16:creationId xmlns:a16="http://schemas.microsoft.com/office/drawing/2014/main" id="{E322B6F5-BF75-914F-BAB4-246830AB1E21}"/>
                    </a:ext>
                  </a:extLst>
                </p:cNvPr>
                <p:cNvCxnSpPr/>
                <p:nvPr/>
              </p:nvCxnSpPr>
              <p:spPr>
                <a:xfrm>
                  <a:off x="4678279" y="3153712"/>
                  <a:ext cx="267496" cy="693312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Straight Connector 98">
                  <a:extLst>
                    <a:ext uri="{FF2B5EF4-FFF2-40B4-BE49-F238E27FC236}">
                      <a16:creationId xmlns:a16="http://schemas.microsoft.com/office/drawing/2014/main" id="{9179937B-E547-6249-9218-5D582BB2BEE7}"/>
                    </a:ext>
                  </a:extLst>
                </p:cNvPr>
                <p:cNvCxnSpPr/>
                <p:nvPr/>
              </p:nvCxnSpPr>
              <p:spPr>
                <a:xfrm>
                  <a:off x="3731268" y="3807980"/>
                  <a:ext cx="156452" cy="0"/>
                </a:xfrm>
                <a:prstGeom prst="line">
                  <a:avLst/>
                </a:prstGeom>
                <a:ln w="381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78" name="Picture 77">
                  <a:extLst>
                    <a:ext uri="{FF2B5EF4-FFF2-40B4-BE49-F238E27FC236}">
                      <a16:creationId xmlns:a16="http://schemas.microsoft.com/office/drawing/2014/main" id="{0B26DB6D-645D-1A44-8B87-47BC37D69F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23" t="4051" r="61834" b="3291"/>
                <a:stretch/>
              </p:blipFill>
              <p:spPr>
                <a:xfrm>
                  <a:off x="3930335" y="3106825"/>
                  <a:ext cx="118573" cy="787086"/>
                </a:xfrm>
                <a:prstGeom prst="rect">
                  <a:avLst/>
                </a:prstGeom>
              </p:spPr>
            </p:pic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3F1B3627-A7EB-E340-B133-F4E063047BC0}"/>
                    </a:ext>
                  </a:extLst>
                </p:cNvPr>
                <p:cNvCxnSpPr/>
                <p:nvPr/>
              </p:nvCxnSpPr>
              <p:spPr>
                <a:xfrm>
                  <a:off x="3414343" y="3157424"/>
                  <a:ext cx="267496" cy="693312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7253" y="4049566"/>
              <a:ext cx="884306" cy="7448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74819" y="4049566"/>
              <a:ext cx="884306" cy="744800"/>
            </a:xfrm>
            <a:prstGeom prst="rect">
              <a:avLst/>
            </a:prstGeom>
          </p:spPr>
        </p:pic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5A1B8506-4EB2-463D-BC9B-B31B84997A80}"/>
              </a:ext>
            </a:extLst>
          </p:cNvPr>
          <p:cNvSpPr txBox="1"/>
          <p:nvPr/>
        </p:nvSpPr>
        <p:spPr>
          <a:xfrm>
            <a:off x="2426483" y="2633568"/>
            <a:ext cx="8693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osition (µm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8E36493-FBCC-49BE-873E-E3A2513B8582}"/>
              </a:ext>
            </a:extLst>
          </p:cNvPr>
          <p:cNvSpPr txBox="1"/>
          <p:nvPr/>
        </p:nvSpPr>
        <p:spPr>
          <a:xfrm>
            <a:off x="2503419" y="4767731"/>
            <a:ext cx="8693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osition (µm)</a:t>
            </a:r>
          </a:p>
        </p:txBody>
      </p:sp>
    </p:spTree>
    <p:extLst>
      <p:ext uri="{BB962C8B-B14F-4D97-AF65-F5344CB8AC3E}">
        <p14:creationId xmlns:p14="http://schemas.microsoft.com/office/powerpoint/2010/main" val="13331790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31226" y="5010452"/>
            <a:ext cx="5357446" cy="1167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Representative trajectories of bond conformational dynamics for K5, MCC and 102S pMHCs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For each peptide,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three trajectories with long (blue), medium (green) and short (red) bond lifetimes were randomly chosen as demonstration. Note: the x- and y-axes are different for each peptide.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71743" y="4734768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Time (s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765378" y="1981200"/>
            <a:ext cx="292388" cy="12184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CR-pMHC  distance(Å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24147" y="691604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44273" y="2109881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C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344273" y="3553562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2S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7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6966" y="734823"/>
            <a:ext cx="2949554" cy="4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9220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8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0B5D482-B3B6-4895-9440-AE02E17C0409}"/>
              </a:ext>
            </a:extLst>
          </p:cNvPr>
          <p:cNvSpPr/>
          <p:nvPr/>
        </p:nvSpPr>
        <p:spPr>
          <a:xfrm>
            <a:off x="575575" y="3321607"/>
            <a:ext cx="5810938" cy="14441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6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intramolecular distance of each pMHC varian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C-terminus of K5, MCC or 102S peptide was labeled by a Cy3 and loaded to a I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HC molecule, respectively. The lipid bilayer was labeled by Cy5. Highly diluted Cy3-labeled pMHC was added onto the Cy-5 labeled bilayer to measure the Cy3/Cy5 smFRET for all three pMHC variants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4191" y="1020007"/>
            <a:ext cx="3190219" cy="230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03896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08660" y="2518677"/>
            <a:ext cx="5486400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7.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TCR-</a:t>
            </a:r>
            <a:r>
              <a:rPr lang="en-US" sz="1200" b="1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pMHC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distance measurements by ensemble FRET</a:t>
            </a:r>
          </a:p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The average TCR-pMHC distances for K5, MCC and 102S pMHCs after ligation with 5C.C7 TCRs on a lipid bilayer and a glass surface. 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2164893" y="968034"/>
            <a:ext cx="2573934" cy="1473625"/>
            <a:chOff x="1958418" y="4137954"/>
            <a:chExt cx="2573934" cy="147362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6290" y="4263645"/>
              <a:ext cx="1954547" cy="1297440"/>
            </a:xfrm>
            <a:prstGeom prst="rect">
              <a:avLst/>
            </a:prstGeom>
          </p:spPr>
        </p:pic>
        <p:grpSp>
          <p:nvGrpSpPr>
            <p:cNvPr id="27" name="Group 26"/>
            <p:cNvGrpSpPr/>
            <p:nvPr/>
          </p:nvGrpSpPr>
          <p:grpSpPr>
            <a:xfrm>
              <a:off x="2499299" y="5407067"/>
              <a:ext cx="1354103" cy="204512"/>
              <a:chOff x="5070149" y="1119191"/>
              <a:chExt cx="1354102" cy="204512"/>
            </a:xfrm>
          </p:grpSpPr>
          <p:sp>
            <p:nvSpPr>
              <p:cNvPr id="45" name="TextBox 44"/>
              <p:cNvSpPr txBox="1"/>
              <p:nvPr/>
            </p:nvSpPr>
            <p:spPr>
              <a:xfrm>
                <a:off x="5070149" y="1119191"/>
                <a:ext cx="292388" cy="201337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5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5533167" y="1119832"/>
                <a:ext cx="388248" cy="200055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CC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027449" y="1119832"/>
                <a:ext cx="393056" cy="200055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2S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239520" y="1123648"/>
                <a:ext cx="184731" cy="200055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445042" y="4137954"/>
              <a:ext cx="2087310" cy="410973"/>
              <a:chOff x="2445042" y="4137954"/>
              <a:chExt cx="2087310" cy="410973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2473896" y="4190656"/>
                <a:ext cx="5100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RET1</a:t>
                </a:r>
                <a:endPara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2445042" y="4137954"/>
                <a:ext cx="2087310" cy="410973"/>
                <a:chOff x="2787942" y="4471128"/>
                <a:chExt cx="2087310" cy="410973"/>
              </a:xfrm>
            </p:grpSpPr>
            <p:sp>
              <p:nvSpPr>
                <p:cNvPr id="49" name="Rectangle 48"/>
                <p:cNvSpPr/>
                <p:nvPr/>
              </p:nvSpPr>
              <p:spPr>
                <a:xfrm>
                  <a:off x="4329859" y="4539343"/>
                  <a:ext cx="185646" cy="70556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4461356" y="4471128"/>
                  <a:ext cx="37221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pid</a:t>
                  </a:r>
                </a:p>
              </p:txBody>
            </p:sp>
            <p:sp>
              <p:nvSpPr>
                <p:cNvPr id="51" name="Rectangle 50"/>
                <p:cNvSpPr/>
                <p:nvPr/>
              </p:nvSpPr>
              <p:spPr>
                <a:xfrm>
                  <a:off x="4329859" y="4638446"/>
                  <a:ext cx="185646" cy="70556"/>
                </a:xfrm>
                <a:prstGeom prst="rect">
                  <a:avLst/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4461356" y="4570231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ass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2787942" y="4682046"/>
                  <a:ext cx="56778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 = 15-20</a:t>
                  </a:r>
                </a:p>
              </p:txBody>
            </p:sp>
          </p:grpSp>
        </p:grpSp>
        <p:sp>
          <p:nvSpPr>
            <p:cNvPr id="32" name="TextBox 31"/>
            <p:cNvSpPr txBox="1"/>
            <p:nvPr/>
          </p:nvSpPr>
          <p:spPr>
            <a:xfrm>
              <a:off x="1958418" y="4539343"/>
              <a:ext cx="292388" cy="61328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istance (Å)</a:t>
              </a:r>
            </a:p>
          </p:txBody>
        </p:sp>
      </p:grpSp>
      <p:cxnSp>
        <p:nvCxnSpPr>
          <p:cNvPr id="77" name="Straight Connector 76"/>
          <p:cNvCxnSpPr/>
          <p:nvPr/>
        </p:nvCxnSpPr>
        <p:spPr>
          <a:xfrm>
            <a:off x="3174415" y="1599872"/>
            <a:ext cx="15645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dirty="0"/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3099592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05</TotalTime>
  <Words>2344</Words>
  <Application>Microsoft Office PowerPoint</Application>
  <PresentationFormat>Letter Paper (8.5x11 in)</PresentationFormat>
  <Paragraphs>466</Paragraphs>
  <Slides>23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9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Lab</dc:creator>
  <cp:lastModifiedBy>Jun Huang</cp:lastModifiedBy>
  <cp:revision>1013</cp:revision>
  <cp:lastPrinted>2018-09-06T20:41:00Z</cp:lastPrinted>
  <dcterms:created xsi:type="dcterms:W3CDTF">2017-04-17T16:59:43Z</dcterms:created>
  <dcterms:modified xsi:type="dcterms:W3CDTF">2019-08-04T03:36:04Z</dcterms:modified>
</cp:coreProperties>
</file>